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>
        <p:scale>
          <a:sx n="100" d="100"/>
          <a:sy n="100" d="100"/>
        </p:scale>
        <p:origin x="1128" y="-10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8758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8962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285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9090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3298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9155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2661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4198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0024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2432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4578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7B191-BE96-44D0-80D0-E4C5F8FB7CD3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5E321-BBFC-4C79-AF71-7CB20689C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5889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4"/>
          <p:cNvSpPr txBox="1">
            <a:spLocks noChangeArrowheads="1"/>
          </p:cNvSpPr>
          <p:nvPr/>
        </p:nvSpPr>
        <p:spPr bwMode="auto">
          <a:xfrm>
            <a:off x="4260044" y="113641"/>
            <a:ext cx="253047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50"/>
              </a:spcBef>
              <a:buFont typeface="Arial" panose="020B0604020202020204" pitchFamily="34" charset="0"/>
              <a:buChar char="•"/>
              <a:defRPr sz="29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457200" indent="-239713">
              <a:lnSpc>
                <a:spcPct val="90000"/>
              </a:lnSpc>
              <a:spcBef>
                <a:spcPts val="525"/>
              </a:spcBef>
              <a:buFont typeface="Arial" panose="020B0604020202020204" pitchFamily="34" charset="0"/>
              <a:buChar char="•"/>
              <a:defRPr sz="25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914400" indent="-239713">
              <a:lnSpc>
                <a:spcPct val="90000"/>
              </a:lnSpc>
              <a:spcBef>
                <a:spcPts val="52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371600" indent="-239713">
              <a:lnSpc>
                <a:spcPct val="90000"/>
              </a:lnSpc>
              <a:spcBef>
                <a:spcPts val="52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1828800" indent="-239713">
              <a:lnSpc>
                <a:spcPct val="90000"/>
              </a:lnSpc>
              <a:spcBef>
                <a:spcPts val="52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indent="-239713" eaLnBrk="0" fontAlgn="base" hangingPunct="0">
              <a:lnSpc>
                <a:spcPct val="90000"/>
              </a:lnSpc>
              <a:spcBef>
                <a:spcPts val="52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indent="-239713" eaLnBrk="0" fontAlgn="base" hangingPunct="0">
              <a:lnSpc>
                <a:spcPct val="90000"/>
              </a:lnSpc>
              <a:spcBef>
                <a:spcPts val="52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indent="-239713" eaLnBrk="0" fontAlgn="base" hangingPunct="0">
              <a:lnSpc>
                <a:spcPct val="90000"/>
              </a:lnSpc>
              <a:spcBef>
                <a:spcPts val="52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indent="-239713" eaLnBrk="0" fontAlgn="base" hangingPunct="0">
              <a:lnSpc>
                <a:spcPct val="90000"/>
              </a:lnSpc>
              <a:spcBef>
                <a:spcPts val="52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defTabSz="914400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nb-NO" alt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nb-NO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Fig.S2.</a:t>
            </a:r>
          </a:p>
        </p:txBody>
      </p:sp>
      <p:grpSp>
        <p:nvGrpSpPr>
          <p:cNvPr id="212" name="Group 211"/>
          <p:cNvGrpSpPr/>
          <p:nvPr/>
        </p:nvGrpSpPr>
        <p:grpSpPr>
          <a:xfrm>
            <a:off x="1603296" y="741363"/>
            <a:ext cx="3625707" cy="5408650"/>
            <a:chOff x="1603474" y="741363"/>
            <a:chExt cx="4232659" cy="6240505"/>
          </a:xfrm>
        </p:grpSpPr>
        <p:sp>
          <p:nvSpPr>
            <p:cNvPr id="6" name="TextBox 357"/>
            <p:cNvSpPr txBox="1">
              <a:spLocks noChangeArrowheads="1"/>
            </p:cNvSpPr>
            <p:nvPr/>
          </p:nvSpPr>
          <p:spPr bwMode="auto">
            <a:xfrm>
              <a:off x="1904269" y="6677678"/>
              <a:ext cx="1497454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eaLnBrk="1" hangingPunct="1"/>
              <a:r>
                <a:rPr lang="nb-NO" altLang="en-US" sz="1100">
                  <a:latin typeface="Arial" panose="020B0604020202020204" pitchFamily="34" charset="0"/>
                  <a:cs typeface="Arial" panose="020B0604020202020204" pitchFamily="34" charset="0"/>
                </a:rPr>
                <a:t>Long photoperiod</a:t>
              </a:r>
              <a:endParaRPr lang="en-US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66"/>
            <p:cNvSpPr txBox="1">
              <a:spLocks noChangeArrowheads="1"/>
            </p:cNvSpPr>
            <p:nvPr/>
          </p:nvSpPr>
          <p:spPr bwMode="auto">
            <a:xfrm>
              <a:off x="3663122" y="6680022"/>
              <a:ext cx="2173011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eaLnBrk="1" hangingPunct="1"/>
              <a:r>
                <a:rPr lang="nb-NO" altLang="en-US" sz="1100">
                  <a:latin typeface="Arial" panose="020B0604020202020204" pitchFamily="34" charset="0"/>
                  <a:cs typeface="Arial" panose="020B0604020202020204" pitchFamily="34" charset="0"/>
                </a:rPr>
                <a:t>Short photoperiod 7 weeks</a:t>
              </a:r>
              <a:endParaRPr lang="en-US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Connector 8"/>
            <p:cNvCxnSpPr/>
            <p:nvPr/>
          </p:nvCxnSpPr>
          <p:spPr bwMode="auto">
            <a:xfrm flipV="1">
              <a:off x="2159375" y="3999333"/>
              <a:ext cx="885264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Rectangle 9"/>
            <p:cNvSpPr/>
            <p:nvPr/>
          </p:nvSpPr>
          <p:spPr bwMode="auto">
            <a:xfrm>
              <a:off x="3600104" y="4885946"/>
              <a:ext cx="352526" cy="2374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sp>
          <p:nvSpPr>
            <p:cNvPr id="11" name="TextBox 349"/>
            <p:cNvSpPr txBox="1">
              <a:spLocks noChangeArrowheads="1"/>
            </p:cNvSpPr>
            <p:nvPr/>
          </p:nvSpPr>
          <p:spPr bwMode="auto">
            <a:xfrm>
              <a:off x="1622974" y="3333535"/>
              <a:ext cx="340961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nb-NO" altLang="en-US" sz="1100" dirty="0"/>
                <a:t>2.</a:t>
              </a:r>
              <a:endParaRPr lang="en-US" altLang="en-US" sz="1100" dirty="0"/>
            </a:p>
          </p:txBody>
        </p:sp>
        <p:sp>
          <p:nvSpPr>
            <p:cNvPr id="12" name="TextBox 350"/>
            <p:cNvSpPr txBox="1">
              <a:spLocks noChangeArrowheads="1"/>
            </p:cNvSpPr>
            <p:nvPr/>
          </p:nvSpPr>
          <p:spPr bwMode="auto">
            <a:xfrm>
              <a:off x="1622974" y="4330419"/>
              <a:ext cx="340961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nb-NO" altLang="en-US" sz="1100" dirty="0"/>
                <a:t>3.</a:t>
              </a:r>
              <a:endParaRPr lang="en-US" altLang="en-US" sz="1100" dirty="0"/>
            </a:p>
          </p:txBody>
        </p:sp>
        <p:sp>
          <p:nvSpPr>
            <p:cNvPr id="13" name="TextBox 351"/>
            <p:cNvSpPr txBox="1">
              <a:spLocks noChangeArrowheads="1"/>
            </p:cNvSpPr>
            <p:nvPr/>
          </p:nvSpPr>
          <p:spPr bwMode="auto">
            <a:xfrm>
              <a:off x="1622974" y="5285766"/>
              <a:ext cx="340961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nb-NO" altLang="en-US" sz="1100" dirty="0"/>
                <a:t>4.</a:t>
              </a:r>
              <a:endParaRPr lang="en-US" altLang="en-US" sz="1100" dirty="0"/>
            </a:p>
          </p:txBody>
        </p:sp>
        <p:cxnSp>
          <p:nvCxnSpPr>
            <p:cNvPr id="14" name="Straight Connector 13"/>
            <p:cNvCxnSpPr/>
            <p:nvPr/>
          </p:nvCxnSpPr>
          <p:spPr bwMode="auto">
            <a:xfrm flipV="1">
              <a:off x="2957986" y="2653653"/>
              <a:ext cx="1198864" cy="131597"/>
            </a:xfrm>
            <a:prstGeom prst="line">
              <a:avLst/>
            </a:prstGeom>
            <a:ln>
              <a:solidFill>
                <a:schemeClr val="accent1">
                  <a:lumMod val="40000"/>
                  <a:lumOff val="60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 bwMode="auto">
            <a:xfrm flipV="1">
              <a:off x="3012562" y="3480299"/>
              <a:ext cx="1162430" cy="12952"/>
            </a:xfrm>
            <a:prstGeom prst="line">
              <a:avLst/>
            </a:prstGeom>
            <a:ln>
              <a:solidFill>
                <a:srgbClr val="FFC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 bwMode="auto">
            <a:xfrm>
              <a:off x="3058467" y="4449153"/>
              <a:ext cx="1070633" cy="5827"/>
            </a:xfrm>
            <a:prstGeom prst="line">
              <a:avLst/>
            </a:prstGeom>
            <a:ln>
              <a:solidFill>
                <a:schemeClr val="accent1">
                  <a:lumMod val="7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Left Brace 16"/>
            <p:cNvSpPr/>
            <p:nvPr/>
          </p:nvSpPr>
          <p:spPr bwMode="auto">
            <a:xfrm>
              <a:off x="4300803" y="2276826"/>
              <a:ext cx="279989" cy="779386"/>
            </a:xfrm>
            <a:prstGeom prst="leftBrace">
              <a:avLst>
                <a:gd name="adj1" fmla="val 8333"/>
                <a:gd name="adj2" fmla="val 44223"/>
              </a:avLst>
            </a:prstGeom>
            <a:ln>
              <a:solidFill>
                <a:schemeClr val="accent1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sp>
          <p:nvSpPr>
            <p:cNvPr id="18" name="Left Brace 17"/>
            <p:cNvSpPr/>
            <p:nvPr/>
          </p:nvSpPr>
          <p:spPr bwMode="auto">
            <a:xfrm>
              <a:off x="4313859" y="3095544"/>
              <a:ext cx="227764" cy="888645"/>
            </a:xfrm>
            <a:prstGeom prst="leftBrace">
              <a:avLst>
                <a:gd name="adj1" fmla="val 8333"/>
                <a:gd name="adj2" fmla="val 42633"/>
              </a:avLst>
            </a:prstGeom>
            <a:ln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sp>
          <p:nvSpPr>
            <p:cNvPr id="19" name="Left Brace 18"/>
            <p:cNvSpPr/>
            <p:nvPr/>
          </p:nvSpPr>
          <p:spPr bwMode="auto">
            <a:xfrm>
              <a:off x="4244224" y="4032264"/>
              <a:ext cx="336568" cy="827459"/>
            </a:xfrm>
            <a:prstGeom prst="leftBrace">
              <a:avLst/>
            </a:prstGeom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sp>
          <p:nvSpPr>
            <p:cNvPr id="20" name="Left Brace 19"/>
            <p:cNvSpPr/>
            <p:nvPr/>
          </p:nvSpPr>
          <p:spPr bwMode="auto">
            <a:xfrm>
              <a:off x="2043239" y="4963156"/>
              <a:ext cx="294185" cy="930893"/>
            </a:xfrm>
            <a:prstGeom prst="leftBrace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sp>
          <p:nvSpPr>
            <p:cNvPr id="21" name="Left Brace 20"/>
            <p:cNvSpPr/>
            <p:nvPr/>
          </p:nvSpPr>
          <p:spPr bwMode="auto">
            <a:xfrm>
              <a:off x="4306606" y="938031"/>
              <a:ext cx="285792" cy="1298005"/>
            </a:xfrm>
            <a:prstGeom prst="leftBrace">
              <a:avLst>
                <a:gd name="adj1" fmla="val 8333"/>
                <a:gd name="adj2" fmla="val 39946"/>
              </a:avLst>
            </a:prstGeom>
            <a:ln>
              <a:solidFill>
                <a:srgbClr val="D2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cxnSp>
          <p:nvCxnSpPr>
            <p:cNvPr id="22" name="Straight Connector 21"/>
            <p:cNvCxnSpPr/>
            <p:nvPr/>
          </p:nvCxnSpPr>
          <p:spPr bwMode="auto">
            <a:xfrm flipV="1">
              <a:off x="2827627" y="1486202"/>
              <a:ext cx="1340467" cy="994991"/>
            </a:xfrm>
            <a:prstGeom prst="line">
              <a:avLst/>
            </a:prstGeom>
            <a:ln>
              <a:solidFill>
                <a:srgbClr val="D2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300"/>
            <p:cNvSpPr txBox="1">
              <a:spLocks noChangeArrowheads="1"/>
            </p:cNvSpPr>
            <p:nvPr/>
          </p:nvSpPr>
          <p:spPr bwMode="auto">
            <a:xfrm>
              <a:off x="1622974" y="2668945"/>
              <a:ext cx="340961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nb-NO" altLang="en-US" sz="1100" dirty="0"/>
                <a:t>1.</a:t>
              </a:r>
              <a:endParaRPr lang="en-US" altLang="en-US" sz="1100" dirty="0"/>
            </a:p>
          </p:txBody>
        </p:sp>
        <p:sp>
          <p:nvSpPr>
            <p:cNvPr id="24" name="TextBox 117"/>
            <p:cNvSpPr txBox="1">
              <a:spLocks noChangeArrowheads="1"/>
            </p:cNvSpPr>
            <p:nvPr/>
          </p:nvSpPr>
          <p:spPr bwMode="auto">
            <a:xfrm>
              <a:off x="1611821" y="3847702"/>
              <a:ext cx="735192" cy="3018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1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+mn-lt"/>
                </a:rPr>
                <a:t>BMP</a:t>
              </a:r>
            </a:p>
          </p:txBody>
        </p:sp>
        <p:sp>
          <p:nvSpPr>
            <p:cNvPr id="25" name="Freeform 24"/>
            <p:cNvSpPr/>
            <p:nvPr/>
          </p:nvSpPr>
          <p:spPr bwMode="auto">
            <a:xfrm>
              <a:off x="2616514" y="2649765"/>
              <a:ext cx="114607" cy="3794952"/>
            </a:xfrm>
            <a:custGeom>
              <a:avLst/>
              <a:gdLst>
                <a:gd name="connsiteX0" fmla="*/ 226094 w 537484"/>
                <a:gd name="connsiteY0" fmla="*/ 386839 h 8967583"/>
                <a:gd name="connsiteX1" fmla="*/ 400265 w 537484"/>
                <a:gd name="connsiteY1" fmla="*/ 5815182 h 8967583"/>
                <a:gd name="connsiteX2" fmla="*/ 443808 w 537484"/>
                <a:gd name="connsiteY2" fmla="*/ 8166496 h 8967583"/>
                <a:gd name="connsiteX3" fmla="*/ 458322 w 537484"/>
                <a:gd name="connsiteY3" fmla="*/ 8587411 h 8967583"/>
                <a:gd name="connsiteX4" fmla="*/ 458322 w 537484"/>
                <a:gd name="connsiteY4" fmla="*/ 8921239 h 8967583"/>
                <a:gd name="connsiteX5" fmla="*/ 516379 w 537484"/>
                <a:gd name="connsiteY5" fmla="*/ 8935753 h 8967583"/>
                <a:gd name="connsiteX6" fmla="*/ 51922 w 537484"/>
                <a:gd name="connsiteY6" fmla="*/ 8935753 h 8967583"/>
                <a:gd name="connsiteX7" fmla="*/ 8379 w 537484"/>
                <a:gd name="connsiteY7" fmla="*/ 8921239 h 8967583"/>
                <a:gd name="connsiteX8" fmla="*/ 8379 w 537484"/>
                <a:gd name="connsiteY8" fmla="*/ 8601925 h 8967583"/>
                <a:gd name="connsiteX9" fmla="*/ 95465 w 537484"/>
                <a:gd name="connsiteY9" fmla="*/ 5292668 h 8967583"/>
                <a:gd name="connsiteX10" fmla="*/ 197065 w 537484"/>
                <a:gd name="connsiteY10" fmla="*/ 1039982 h 8967583"/>
                <a:gd name="connsiteX11" fmla="*/ 168036 w 537484"/>
                <a:gd name="connsiteY11" fmla="*/ 459411 h 8967583"/>
                <a:gd name="connsiteX12" fmla="*/ 255122 w 537484"/>
                <a:gd name="connsiteY12" fmla="*/ 444896 h 8967583"/>
                <a:gd name="connsiteX13" fmla="*/ 226094 w 537484"/>
                <a:gd name="connsiteY13" fmla="*/ 386839 h 8967583"/>
                <a:gd name="connsiteX0" fmla="*/ 568994 w 571319"/>
                <a:gd name="connsiteY0" fmla="*/ 405698 h 8895955"/>
                <a:gd name="connsiteX1" fmla="*/ 400265 w 571319"/>
                <a:gd name="connsiteY1" fmla="*/ 5743554 h 8895955"/>
                <a:gd name="connsiteX2" fmla="*/ 443808 w 571319"/>
                <a:gd name="connsiteY2" fmla="*/ 8094868 h 8895955"/>
                <a:gd name="connsiteX3" fmla="*/ 458322 w 571319"/>
                <a:gd name="connsiteY3" fmla="*/ 8515783 h 8895955"/>
                <a:gd name="connsiteX4" fmla="*/ 458322 w 571319"/>
                <a:gd name="connsiteY4" fmla="*/ 8849611 h 8895955"/>
                <a:gd name="connsiteX5" fmla="*/ 516379 w 571319"/>
                <a:gd name="connsiteY5" fmla="*/ 8864125 h 8895955"/>
                <a:gd name="connsiteX6" fmla="*/ 51922 w 571319"/>
                <a:gd name="connsiteY6" fmla="*/ 8864125 h 8895955"/>
                <a:gd name="connsiteX7" fmla="*/ 8379 w 571319"/>
                <a:gd name="connsiteY7" fmla="*/ 8849611 h 8895955"/>
                <a:gd name="connsiteX8" fmla="*/ 8379 w 571319"/>
                <a:gd name="connsiteY8" fmla="*/ 8530297 h 8895955"/>
                <a:gd name="connsiteX9" fmla="*/ 95465 w 571319"/>
                <a:gd name="connsiteY9" fmla="*/ 5221040 h 8895955"/>
                <a:gd name="connsiteX10" fmla="*/ 197065 w 571319"/>
                <a:gd name="connsiteY10" fmla="*/ 968354 h 8895955"/>
                <a:gd name="connsiteX11" fmla="*/ 168036 w 571319"/>
                <a:gd name="connsiteY11" fmla="*/ 387783 h 8895955"/>
                <a:gd name="connsiteX12" fmla="*/ 255122 w 571319"/>
                <a:gd name="connsiteY12" fmla="*/ 373268 h 8895955"/>
                <a:gd name="connsiteX13" fmla="*/ 568994 w 571319"/>
                <a:gd name="connsiteY13" fmla="*/ 405698 h 8895955"/>
                <a:gd name="connsiteX0" fmla="*/ 568994 w 571887"/>
                <a:gd name="connsiteY0" fmla="*/ 472076 h 8962333"/>
                <a:gd name="connsiteX1" fmla="*/ 400265 w 571887"/>
                <a:gd name="connsiteY1" fmla="*/ 5809932 h 8962333"/>
                <a:gd name="connsiteX2" fmla="*/ 443808 w 571887"/>
                <a:gd name="connsiteY2" fmla="*/ 8161246 h 8962333"/>
                <a:gd name="connsiteX3" fmla="*/ 458322 w 571887"/>
                <a:gd name="connsiteY3" fmla="*/ 8582161 h 8962333"/>
                <a:gd name="connsiteX4" fmla="*/ 458322 w 571887"/>
                <a:gd name="connsiteY4" fmla="*/ 8915989 h 8962333"/>
                <a:gd name="connsiteX5" fmla="*/ 516379 w 571887"/>
                <a:gd name="connsiteY5" fmla="*/ 8930503 h 8962333"/>
                <a:gd name="connsiteX6" fmla="*/ 51922 w 571887"/>
                <a:gd name="connsiteY6" fmla="*/ 8930503 h 8962333"/>
                <a:gd name="connsiteX7" fmla="*/ 8379 w 571887"/>
                <a:gd name="connsiteY7" fmla="*/ 8915989 h 8962333"/>
                <a:gd name="connsiteX8" fmla="*/ 8379 w 571887"/>
                <a:gd name="connsiteY8" fmla="*/ 8596675 h 8962333"/>
                <a:gd name="connsiteX9" fmla="*/ 95465 w 571887"/>
                <a:gd name="connsiteY9" fmla="*/ 5287418 h 8962333"/>
                <a:gd name="connsiteX10" fmla="*/ 197065 w 571887"/>
                <a:gd name="connsiteY10" fmla="*/ 1034732 h 8962333"/>
                <a:gd name="connsiteX11" fmla="*/ 168036 w 571887"/>
                <a:gd name="connsiteY11" fmla="*/ 454161 h 8962333"/>
                <a:gd name="connsiteX12" fmla="*/ 236072 w 571887"/>
                <a:gd name="connsiteY12" fmla="*/ 263433 h 8962333"/>
                <a:gd name="connsiteX13" fmla="*/ 568994 w 571887"/>
                <a:gd name="connsiteY13" fmla="*/ 472076 h 8962333"/>
                <a:gd name="connsiteX0" fmla="*/ 568994 w 571887"/>
                <a:gd name="connsiteY0" fmla="*/ 472076 h 8962333"/>
                <a:gd name="connsiteX1" fmla="*/ 400265 w 571887"/>
                <a:gd name="connsiteY1" fmla="*/ 5809932 h 8962333"/>
                <a:gd name="connsiteX2" fmla="*/ 443808 w 571887"/>
                <a:gd name="connsiteY2" fmla="*/ 8161246 h 8962333"/>
                <a:gd name="connsiteX3" fmla="*/ 458322 w 571887"/>
                <a:gd name="connsiteY3" fmla="*/ 8582161 h 8962333"/>
                <a:gd name="connsiteX4" fmla="*/ 458322 w 571887"/>
                <a:gd name="connsiteY4" fmla="*/ 8915989 h 8962333"/>
                <a:gd name="connsiteX5" fmla="*/ 516379 w 571887"/>
                <a:gd name="connsiteY5" fmla="*/ 8930503 h 8962333"/>
                <a:gd name="connsiteX6" fmla="*/ 51922 w 571887"/>
                <a:gd name="connsiteY6" fmla="*/ 8930503 h 8962333"/>
                <a:gd name="connsiteX7" fmla="*/ 8379 w 571887"/>
                <a:gd name="connsiteY7" fmla="*/ 8915989 h 8962333"/>
                <a:gd name="connsiteX8" fmla="*/ 8379 w 571887"/>
                <a:gd name="connsiteY8" fmla="*/ 8596675 h 8962333"/>
                <a:gd name="connsiteX9" fmla="*/ 95465 w 571887"/>
                <a:gd name="connsiteY9" fmla="*/ 5287418 h 8962333"/>
                <a:gd name="connsiteX10" fmla="*/ 197065 w 571887"/>
                <a:gd name="connsiteY10" fmla="*/ 1034732 h 8962333"/>
                <a:gd name="connsiteX11" fmla="*/ 206136 w 571887"/>
                <a:gd name="connsiteY11" fmla="*/ 454161 h 8962333"/>
                <a:gd name="connsiteX12" fmla="*/ 236072 w 571887"/>
                <a:gd name="connsiteY12" fmla="*/ 263433 h 8962333"/>
                <a:gd name="connsiteX13" fmla="*/ 568994 w 571887"/>
                <a:gd name="connsiteY13" fmla="*/ 472076 h 8962333"/>
                <a:gd name="connsiteX0" fmla="*/ 568994 w 572188"/>
                <a:gd name="connsiteY0" fmla="*/ 436477 h 8926734"/>
                <a:gd name="connsiteX1" fmla="*/ 400265 w 572188"/>
                <a:gd name="connsiteY1" fmla="*/ 5774333 h 8926734"/>
                <a:gd name="connsiteX2" fmla="*/ 443808 w 572188"/>
                <a:gd name="connsiteY2" fmla="*/ 8125647 h 8926734"/>
                <a:gd name="connsiteX3" fmla="*/ 458322 w 572188"/>
                <a:gd name="connsiteY3" fmla="*/ 8546562 h 8926734"/>
                <a:gd name="connsiteX4" fmla="*/ 458322 w 572188"/>
                <a:gd name="connsiteY4" fmla="*/ 8880390 h 8926734"/>
                <a:gd name="connsiteX5" fmla="*/ 516379 w 572188"/>
                <a:gd name="connsiteY5" fmla="*/ 8894904 h 8926734"/>
                <a:gd name="connsiteX6" fmla="*/ 51922 w 572188"/>
                <a:gd name="connsiteY6" fmla="*/ 8894904 h 8926734"/>
                <a:gd name="connsiteX7" fmla="*/ 8379 w 572188"/>
                <a:gd name="connsiteY7" fmla="*/ 8880390 h 8926734"/>
                <a:gd name="connsiteX8" fmla="*/ 8379 w 572188"/>
                <a:gd name="connsiteY8" fmla="*/ 8561076 h 8926734"/>
                <a:gd name="connsiteX9" fmla="*/ 95465 w 572188"/>
                <a:gd name="connsiteY9" fmla="*/ 5251819 h 8926734"/>
                <a:gd name="connsiteX10" fmla="*/ 197065 w 572188"/>
                <a:gd name="connsiteY10" fmla="*/ 999133 h 8926734"/>
                <a:gd name="connsiteX11" fmla="*/ 206136 w 572188"/>
                <a:gd name="connsiteY11" fmla="*/ 418562 h 8926734"/>
                <a:gd name="connsiteX12" fmla="*/ 226547 w 572188"/>
                <a:gd name="connsiteY12" fmla="*/ 318321 h 8926734"/>
                <a:gd name="connsiteX13" fmla="*/ 568994 w 572188"/>
                <a:gd name="connsiteY13" fmla="*/ 436477 h 8926734"/>
                <a:gd name="connsiteX0" fmla="*/ 568994 w 570582"/>
                <a:gd name="connsiteY0" fmla="*/ 363376 h 8853633"/>
                <a:gd name="connsiteX1" fmla="*/ 400265 w 570582"/>
                <a:gd name="connsiteY1" fmla="*/ 5701232 h 8853633"/>
                <a:gd name="connsiteX2" fmla="*/ 443808 w 570582"/>
                <a:gd name="connsiteY2" fmla="*/ 8052546 h 8853633"/>
                <a:gd name="connsiteX3" fmla="*/ 458322 w 570582"/>
                <a:gd name="connsiteY3" fmla="*/ 8473461 h 8853633"/>
                <a:gd name="connsiteX4" fmla="*/ 458322 w 570582"/>
                <a:gd name="connsiteY4" fmla="*/ 8807289 h 8853633"/>
                <a:gd name="connsiteX5" fmla="*/ 516379 w 570582"/>
                <a:gd name="connsiteY5" fmla="*/ 8821803 h 8853633"/>
                <a:gd name="connsiteX6" fmla="*/ 51922 w 570582"/>
                <a:gd name="connsiteY6" fmla="*/ 8821803 h 8853633"/>
                <a:gd name="connsiteX7" fmla="*/ 8379 w 570582"/>
                <a:gd name="connsiteY7" fmla="*/ 8807289 h 8853633"/>
                <a:gd name="connsiteX8" fmla="*/ 8379 w 570582"/>
                <a:gd name="connsiteY8" fmla="*/ 8487975 h 8853633"/>
                <a:gd name="connsiteX9" fmla="*/ 95465 w 570582"/>
                <a:gd name="connsiteY9" fmla="*/ 5178718 h 8853633"/>
                <a:gd name="connsiteX10" fmla="*/ 197065 w 570582"/>
                <a:gd name="connsiteY10" fmla="*/ 926032 h 8853633"/>
                <a:gd name="connsiteX11" fmla="*/ 206136 w 570582"/>
                <a:gd name="connsiteY11" fmla="*/ 345461 h 8853633"/>
                <a:gd name="connsiteX12" fmla="*/ 226547 w 570582"/>
                <a:gd name="connsiteY12" fmla="*/ 245220 h 8853633"/>
                <a:gd name="connsiteX13" fmla="*/ 282789 w 570582"/>
                <a:gd name="connsiteY13" fmla="*/ 451369 h 8853633"/>
                <a:gd name="connsiteX14" fmla="*/ 568994 w 570582"/>
                <a:gd name="connsiteY14" fmla="*/ 363376 h 8853633"/>
                <a:gd name="connsiteX0" fmla="*/ 288007 w 537484"/>
                <a:gd name="connsiteY0" fmla="*/ 1071799 h 8614318"/>
                <a:gd name="connsiteX1" fmla="*/ 400265 w 537484"/>
                <a:gd name="connsiteY1" fmla="*/ 5461917 h 8614318"/>
                <a:gd name="connsiteX2" fmla="*/ 443808 w 537484"/>
                <a:gd name="connsiteY2" fmla="*/ 7813231 h 8614318"/>
                <a:gd name="connsiteX3" fmla="*/ 458322 w 537484"/>
                <a:gd name="connsiteY3" fmla="*/ 8234146 h 8614318"/>
                <a:gd name="connsiteX4" fmla="*/ 458322 w 537484"/>
                <a:gd name="connsiteY4" fmla="*/ 8567974 h 8614318"/>
                <a:gd name="connsiteX5" fmla="*/ 516379 w 537484"/>
                <a:gd name="connsiteY5" fmla="*/ 8582488 h 8614318"/>
                <a:gd name="connsiteX6" fmla="*/ 51922 w 537484"/>
                <a:gd name="connsiteY6" fmla="*/ 8582488 h 8614318"/>
                <a:gd name="connsiteX7" fmla="*/ 8379 w 537484"/>
                <a:gd name="connsiteY7" fmla="*/ 8567974 h 8614318"/>
                <a:gd name="connsiteX8" fmla="*/ 8379 w 537484"/>
                <a:gd name="connsiteY8" fmla="*/ 8248660 h 8614318"/>
                <a:gd name="connsiteX9" fmla="*/ 95465 w 537484"/>
                <a:gd name="connsiteY9" fmla="*/ 4939403 h 8614318"/>
                <a:gd name="connsiteX10" fmla="*/ 197065 w 537484"/>
                <a:gd name="connsiteY10" fmla="*/ 686717 h 8614318"/>
                <a:gd name="connsiteX11" fmla="*/ 206136 w 537484"/>
                <a:gd name="connsiteY11" fmla="*/ 106146 h 8614318"/>
                <a:gd name="connsiteX12" fmla="*/ 226547 w 537484"/>
                <a:gd name="connsiteY12" fmla="*/ 5905 h 8614318"/>
                <a:gd name="connsiteX13" fmla="*/ 282789 w 537484"/>
                <a:gd name="connsiteY13" fmla="*/ 212054 h 8614318"/>
                <a:gd name="connsiteX14" fmla="*/ 288007 w 537484"/>
                <a:gd name="connsiteY14" fmla="*/ 1071799 h 8614318"/>
                <a:gd name="connsiteX0" fmla="*/ 288007 w 537484"/>
                <a:gd name="connsiteY0" fmla="*/ 1098859 h 8641378"/>
                <a:gd name="connsiteX1" fmla="*/ 400265 w 537484"/>
                <a:gd name="connsiteY1" fmla="*/ 5488977 h 8641378"/>
                <a:gd name="connsiteX2" fmla="*/ 443808 w 537484"/>
                <a:gd name="connsiteY2" fmla="*/ 7840291 h 8641378"/>
                <a:gd name="connsiteX3" fmla="*/ 458322 w 537484"/>
                <a:gd name="connsiteY3" fmla="*/ 8261206 h 8641378"/>
                <a:gd name="connsiteX4" fmla="*/ 458322 w 537484"/>
                <a:gd name="connsiteY4" fmla="*/ 8595034 h 8641378"/>
                <a:gd name="connsiteX5" fmla="*/ 516379 w 537484"/>
                <a:gd name="connsiteY5" fmla="*/ 8609548 h 8641378"/>
                <a:gd name="connsiteX6" fmla="*/ 51922 w 537484"/>
                <a:gd name="connsiteY6" fmla="*/ 8609548 h 8641378"/>
                <a:gd name="connsiteX7" fmla="*/ 8379 w 537484"/>
                <a:gd name="connsiteY7" fmla="*/ 8595034 h 8641378"/>
                <a:gd name="connsiteX8" fmla="*/ 8379 w 537484"/>
                <a:gd name="connsiteY8" fmla="*/ 8275720 h 8641378"/>
                <a:gd name="connsiteX9" fmla="*/ 95465 w 537484"/>
                <a:gd name="connsiteY9" fmla="*/ 4966463 h 8641378"/>
                <a:gd name="connsiteX10" fmla="*/ 197065 w 537484"/>
                <a:gd name="connsiteY10" fmla="*/ 713777 h 8641378"/>
                <a:gd name="connsiteX11" fmla="*/ 206136 w 537484"/>
                <a:gd name="connsiteY11" fmla="*/ 133206 h 8641378"/>
                <a:gd name="connsiteX12" fmla="*/ 226547 w 537484"/>
                <a:gd name="connsiteY12" fmla="*/ 32965 h 8641378"/>
                <a:gd name="connsiteX13" fmla="*/ 297077 w 537484"/>
                <a:gd name="connsiteY13" fmla="*/ 620114 h 8641378"/>
                <a:gd name="connsiteX14" fmla="*/ 288007 w 537484"/>
                <a:gd name="connsiteY14" fmla="*/ 1098859 h 8641378"/>
                <a:gd name="connsiteX0" fmla="*/ 288007 w 537484"/>
                <a:gd name="connsiteY0" fmla="*/ 1098859 h 8641378"/>
                <a:gd name="connsiteX1" fmla="*/ 400265 w 537484"/>
                <a:gd name="connsiteY1" fmla="*/ 5488977 h 8641378"/>
                <a:gd name="connsiteX2" fmla="*/ 443808 w 537484"/>
                <a:gd name="connsiteY2" fmla="*/ 7840291 h 8641378"/>
                <a:gd name="connsiteX3" fmla="*/ 458322 w 537484"/>
                <a:gd name="connsiteY3" fmla="*/ 8261206 h 8641378"/>
                <a:gd name="connsiteX4" fmla="*/ 458322 w 537484"/>
                <a:gd name="connsiteY4" fmla="*/ 8595034 h 8641378"/>
                <a:gd name="connsiteX5" fmla="*/ 516379 w 537484"/>
                <a:gd name="connsiteY5" fmla="*/ 8609548 h 8641378"/>
                <a:gd name="connsiteX6" fmla="*/ 51922 w 537484"/>
                <a:gd name="connsiteY6" fmla="*/ 8609548 h 8641378"/>
                <a:gd name="connsiteX7" fmla="*/ 8379 w 537484"/>
                <a:gd name="connsiteY7" fmla="*/ 8595034 h 8641378"/>
                <a:gd name="connsiteX8" fmla="*/ 8379 w 537484"/>
                <a:gd name="connsiteY8" fmla="*/ 8275720 h 8641378"/>
                <a:gd name="connsiteX9" fmla="*/ 95465 w 537484"/>
                <a:gd name="connsiteY9" fmla="*/ 4966463 h 8641378"/>
                <a:gd name="connsiteX10" fmla="*/ 197065 w 537484"/>
                <a:gd name="connsiteY10" fmla="*/ 713777 h 8641378"/>
                <a:gd name="connsiteX11" fmla="*/ 206136 w 537484"/>
                <a:gd name="connsiteY11" fmla="*/ 133206 h 8641378"/>
                <a:gd name="connsiteX12" fmla="*/ 226547 w 537484"/>
                <a:gd name="connsiteY12" fmla="*/ 32965 h 8641378"/>
                <a:gd name="connsiteX13" fmla="*/ 297077 w 537484"/>
                <a:gd name="connsiteY13" fmla="*/ 620114 h 8641378"/>
                <a:gd name="connsiteX14" fmla="*/ 288007 w 537484"/>
                <a:gd name="connsiteY14" fmla="*/ 1098859 h 8641378"/>
                <a:gd name="connsiteX0" fmla="*/ 288007 w 537484"/>
                <a:gd name="connsiteY0" fmla="*/ 1099206 h 8641725"/>
                <a:gd name="connsiteX1" fmla="*/ 400265 w 537484"/>
                <a:gd name="connsiteY1" fmla="*/ 5489324 h 8641725"/>
                <a:gd name="connsiteX2" fmla="*/ 443808 w 537484"/>
                <a:gd name="connsiteY2" fmla="*/ 7840638 h 8641725"/>
                <a:gd name="connsiteX3" fmla="*/ 458322 w 537484"/>
                <a:gd name="connsiteY3" fmla="*/ 8261553 h 8641725"/>
                <a:gd name="connsiteX4" fmla="*/ 458322 w 537484"/>
                <a:gd name="connsiteY4" fmla="*/ 8595381 h 8641725"/>
                <a:gd name="connsiteX5" fmla="*/ 516379 w 537484"/>
                <a:gd name="connsiteY5" fmla="*/ 8609895 h 8641725"/>
                <a:gd name="connsiteX6" fmla="*/ 51922 w 537484"/>
                <a:gd name="connsiteY6" fmla="*/ 8609895 h 8641725"/>
                <a:gd name="connsiteX7" fmla="*/ 8379 w 537484"/>
                <a:gd name="connsiteY7" fmla="*/ 8595381 h 8641725"/>
                <a:gd name="connsiteX8" fmla="*/ 8379 w 537484"/>
                <a:gd name="connsiteY8" fmla="*/ 8276067 h 8641725"/>
                <a:gd name="connsiteX9" fmla="*/ 95465 w 537484"/>
                <a:gd name="connsiteY9" fmla="*/ 4966810 h 8641725"/>
                <a:gd name="connsiteX10" fmla="*/ 197065 w 537484"/>
                <a:gd name="connsiteY10" fmla="*/ 714124 h 8641725"/>
                <a:gd name="connsiteX11" fmla="*/ 206136 w 537484"/>
                <a:gd name="connsiteY11" fmla="*/ 133553 h 8641725"/>
                <a:gd name="connsiteX12" fmla="*/ 226547 w 537484"/>
                <a:gd name="connsiteY12" fmla="*/ 33312 h 8641725"/>
                <a:gd name="connsiteX13" fmla="*/ 282789 w 537484"/>
                <a:gd name="connsiteY13" fmla="*/ 625224 h 8641725"/>
                <a:gd name="connsiteX14" fmla="*/ 288007 w 537484"/>
                <a:gd name="connsiteY14" fmla="*/ 1099206 h 8641725"/>
                <a:gd name="connsiteX0" fmla="*/ 288007 w 537484"/>
                <a:gd name="connsiteY0" fmla="*/ 1099206 h 8641725"/>
                <a:gd name="connsiteX1" fmla="*/ 400265 w 537484"/>
                <a:gd name="connsiteY1" fmla="*/ 5489324 h 8641725"/>
                <a:gd name="connsiteX2" fmla="*/ 443808 w 537484"/>
                <a:gd name="connsiteY2" fmla="*/ 7840638 h 8641725"/>
                <a:gd name="connsiteX3" fmla="*/ 458322 w 537484"/>
                <a:gd name="connsiteY3" fmla="*/ 8261553 h 8641725"/>
                <a:gd name="connsiteX4" fmla="*/ 458322 w 537484"/>
                <a:gd name="connsiteY4" fmla="*/ 8595381 h 8641725"/>
                <a:gd name="connsiteX5" fmla="*/ 516379 w 537484"/>
                <a:gd name="connsiteY5" fmla="*/ 8609895 h 8641725"/>
                <a:gd name="connsiteX6" fmla="*/ 51922 w 537484"/>
                <a:gd name="connsiteY6" fmla="*/ 8609895 h 8641725"/>
                <a:gd name="connsiteX7" fmla="*/ 8379 w 537484"/>
                <a:gd name="connsiteY7" fmla="*/ 8595381 h 8641725"/>
                <a:gd name="connsiteX8" fmla="*/ 8379 w 537484"/>
                <a:gd name="connsiteY8" fmla="*/ 8276067 h 8641725"/>
                <a:gd name="connsiteX9" fmla="*/ 95465 w 537484"/>
                <a:gd name="connsiteY9" fmla="*/ 4966810 h 8641725"/>
                <a:gd name="connsiteX10" fmla="*/ 197065 w 537484"/>
                <a:gd name="connsiteY10" fmla="*/ 714124 h 8641725"/>
                <a:gd name="connsiteX11" fmla="*/ 206136 w 537484"/>
                <a:gd name="connsiteY11" fmla="*/ 133553 h 8641725"/>
                <a:gd name="connsiteX12" fmla="*/ 226547 w 537484"/>
                <a:gd name="connsiteY12" fmla="*/ 33312 h 8641725"/>
                <a:gd name="connsiteX13" fmla="*/ 282789 w 537484"/>
                <a:gd name="connsiteY13" fmla="*/ 625224 h 8641725"/>
                <a:gd name="connsiteX14" fmla="*/ 288007 w 537484"/>
                <a:gd name="connsiteY14" fmla="*/ 1099206 h 8641725"/>
                <a:gd name="connsiteX0" fmla="*/ 288007 w 537484"/>
                <a:gd name="connsiteY0" fmla="*/ 1097820 h 8640339"/>
                <a:gd name="connsiteX1" fmla="*/ 400265 w 537484"/>
                <a:gd name="connsiteY1" fmla="*/ 5487938 h 8640339"/>
                <a:gd name="connsiteX2" fmla="*/ 443808 w 537484"/>
                <a:gd name="connsiteY2" fmla="*/ 7839252 h 8640339"/>
                <a:gd name="connsiteX3" fmla="*/ 458322 w 537484"/>
                <a:gd name="connsiteY3" fmla="*/ 8260167 h 8640339"/>
                <a:gd name="connsiteX4" fmla="*/ 458322 w 537484"/>
                <a:gd name="connsiteY4" fmla="*/ 8593995 h 8640339"/>
                <a:gd name="connsiteX5" fmla="*/ 516379 w 537484"/>
                <a:gd name="connsiteY5" fmla="*/ 8608509 h 8640339"/>
                <a:gd name="connsiteX6" fmla="*/ 51922 w 537484"/>
                <a:gd name="connsiteY6" fmla="*/ 8608509 h 8640339"/>
                <a:gd name="connsiteX7" fmla="*/ 8379 w 537484"/>
                <a:gd name="connsiteY7" fmla="*/ 8593995 h 8640339"/>
                <a:gd name="connsiteX8" fmla="*/ 8379 w 537484"/>
                <a:gd name="connsiteY8" fmla="*/ 8274681 h 8640339"/>
                <a:gd name="connsiteX9" fmla="*/ 95465 w 537484"/>
                <a:gd name="connsiteY9" fmla="*/ 4965424 h 8640339"/>
                <a:gd name="connsiteX10" fmla="*/ 197065 w 537484"/>
                <a:gd name="connsiteY10" fmla="*/ 712738 h 8640339"/>
                <a:gd name="connsiteX11" fmla="*/ 206136 w 537484"/>
                <a:gd name="connsiteY11" fmla="*/ 132167 h 8640339"/>
                <a:gd name="connsiteX12" fmla="*/ 226547 w 537484"/>
                <a:gd name="connsiteY12" fmla="*/ 31926 h 8640339"/>
                <a:gd name="connsiteX13" fmla="*/ 263739 w 537484"/>
                <a:gd name="connsiteY13" fmla="*/ 604788 h 8640339"/>
                <a:gd name="connsiteX14" fmla="*/ 288007 w 537484"/>
                <a:gd name="connsiteY14" fmla="*/ 1097820 h 8640339"/>
                <a:gd name="connsiteX0" fmla="*/ 288007 w 537484"/>
                <a:gd name="connsiteY0" fmla="*/ 1097820 h 8640339"/>
                <a:gd name="connsiteX1" fmla="*/ 400265 w 537484"/>
                <a:gd name="connsiteY1" fmla="*/ 5487938 h 8640339"/>
                <a:gd name="connsiteX2" fmla="*/ 443808 w 537484"/>
                <a:gd name="connsiteY2" fmla="*/ 7839252 h 8640339"/>
                <a:gd name="connsiteX3" fmla="*/ 458322 w 537484"/>
                <a:gd name="connsiteY3" fmla="*/ 8260167 h 8640339"/>
                <a:gd name="connsiteX4" fmla="*/ 458322 w 537484"/>
                <a:gd name="connsiteY4" fmla="*/ 8593995 h 8640339"/>
                <a:gd name="connsiteX5" fmla="*/ 516379 w 537484"/>
                <a:gd name="connsiteY5" fmla="*/ 8608509 h 8640339"/>
                <a:gd name="connsiteX6" fmla="*/ 51922 w 537484"/>
                <a:gd name="connsiteY6" fmla="*/ 8608509 h 8640339"/>
                <a:gd name="connsiteX7" fmla="*/ 8379 w 537484"/>
                <a:gd name="connsiteY7" fmla="*/ 8593995 h 8640339"/>
                <a:gd name="connsiteX8" fmla="*/ 8379 w 537484"/>
                <a:gd name="connsiteY8" fmla="*/ 8274681 h 8640339"/>
                <a:gd name="connsiteX9" fmla="*/ 95465 w 537484"/>
                <a:gd name="connsiteY9" fmla="*/ 4965424 h 8640339"/>
                <a:gd name="connsiteX10" fmla="*/ 197065 w 537484"/>
                <a:gd name="connsiteY10" fmla="*/ 712738 h 8640339"/>
                <a:gd name="connsiteX11" fmla="*/ 206136 w 537484"/>
                <a:gd name="connsiteY11" fmla="*/ 132167 h 8640339"/>
                <a:gd name="connsiteX12" fmla="*/ 226547 w 537484"/>
                <a:gd name="connsiteY12" fmla="*/ 31926 h 8640339"/>
                <a:gd name="connsiteX13" fmla="*/ 263739 w 537484"/>
                <a:gd name="connsiteY13" fmla="*/ 604788 h 8640339"/>
                <a:gd name="connsiteX14" fmla="*/ 288007 w 537484"/>
                <a:gd name="connsiteY14" fmla="*/ 1097820 h 8640339"/>
                <a:gd name="connsiteX0" fmla="*/ 288007 w 537484"/>
                <a:gd name="connsiteY0" fmla="*/ 1097820 h 8640339"/>
                <a:gd name="connsiteX1" fmla="*/ 400265 w 537484"/>
                <a:gd name="connsiteY1" fmla="*/ 5487938 h 8640339"/>
                <a:gd name="connsiteX2" fmla="*/ 443808 w 537484"/>
                <a:gd name="connsiteY2" fmla="*/ 7839252 h 8640339"/>
                <a:gd name="connsiteX3" fmla="*/ 458322 w 537484"/>
                <a:gd name="connsiteY3" fmla="*/ 8260167 h 8640339"/>
                <a:gd name="connsiteX4" fmla="*/ 458322 w 537484"/>
                <a:gd name="connsiteY4" fmla="*/ 8593995 h 8640339"/>
                <a:gd name="connsiteX5" fmla="*/ 516379 w 537484"/>
                <a:gd name="connsiteY5" fmla="*/ 8608509 h 8640339"/>
                <a:gd name="connsiteX6" fmla="*/ 51922 w 537484"/>
                <a:gd name="connsiteY6" fmla="*/ 8608509 h 8640339"/>
                <a:gd name="connsiteX7" fmla="*/ 8379 w 537484"/>
                <a:gd name="connsiteY7" fmla="*/ 8593995 h 8640339"/>
                <a:gd name="connsiteX8" fmla="*/ 8379 w 537484"/>
                <a:gd name="connsiteY8" fmla="*/ 8274681 h 8640339"/>
                <a:gd name="connsiteX9" fmla="*/ 95465 w 537484"/>
                <a:gd name="connsiteY9" fmla="*/ 4965424 h 8640339"/>
                <a:gd name="connsiteX10" fmla="*/ 197065 w 537484"/>
                <a:gd name="connsiteY10" fmla="*/ 712738 h 8640339"/>
                <a:gd name="connsiteX11" fmla="*/ 206136 w 537484"/>
                <a:gd name="connsiteY11" fmla="*/ 132167 h 8640339"/>
                <a:gd name="connsiteX12" fmla="*/ 226547 w 537484"/>
                <a:gd name="connsiteY12" fmla="*/ 31926 h 8640339"/>
                <a:gd name="connsiteX13" fmla="*/ 263739 w 537484"/>
                <a:gd name="connsiteY13" fmla="*/ 604788 h 8640339"/>
                <a:gd name="connsiteX14" fmla="*/ 288007 w 537484"/>
                <a:gd name="connsiteY14" fmla="*/ 1097820 h 8640339"/>
                <a:gd name="connsiteX0" fmla="*/ 288007 w 537484"/>
                <a:gd name="connsiteY0" fmla="*/ 1097820 h 8640339"/>
                <a:gd name="connsiteX1" fmla="*/ 400265 w 537484"/>
                <a:gd name="connsiteY1" fmla="*/ 5487938 h 8640339"/>
                <a:gd name="connsiteX2" fmla="*/ 443808 w 537484"/>
                <a:gd name="connsiteY2" fmla="*/ 7839252 h 8640339"/>
                <a:gd name="connsiteX3" fmla="*/ 458322 w 537484"/>
                <a:gd name="connsiteY3" fmla="*/ 8260167 h 8640339"/>
                <a:gd name="connsiteX4" fmla="*/ 458322 w 537484"/>
                <a:gd name="connsiteY4" fmla="*/ 8593995 h 8640339"/>
                <a:gd name="connsiteX5" fmla="*/ 516379 w 537484"/>
                <a:gd name="connsiteY5" fmla="*/ 8608509 h 8640339"/>
                <a:gd name="connsiteX6" fmla="*/ 51922 w 537484"/>
                <a:gd name="connsiteY6" fmla="*/ 8608509 h 8640339"/>
                <a:gd name="connsiteX7" fmla="*/ 8379 w 537484"/>
                <a:gd name="connsiteY7" fmla="*/ 8593995 h 8640339"/>
                <a:gd name="connsiteX8" fmla="*/ 8379 w 537484"/>
                <a:gd name="connsiteY8" fmla="*/ 8274681 h 8640339"/>
                <a:gd name="connsiteX9" fmla="*/ 95465 w 537484"/>
                <a:gd name="connsiteY9" fmla="*/ 4965424 h 8640339"/>
                <a:gd name="connsiteX10" fmla="*/ 197065 w 537484"/>
                <a:gd name="connsiteY10" fmla="*/ 712738 h 8640339"/>
                <a:gd name="connsiteX11" fmla="*/ 206136 w 537484"/>
                <a:gd name="connsiteY11" fmla="*/ 132167 h 8640339"/>
                <a:gd name="connsiteX12" fmla="*/ 226547 w 537484"/>
                <a:gd name="connsiteY12" fmla="*/ 31926 h 8640339"/>
                <a:gd name="connsiteX13" fmla="*/ 244689 w 537484"/>
                <a:gd name="connsiteY13" fmla="*/ 604788 h 8640339"/>
                <a:gd name="connsiteX14" fmla="*/ 288007 w 537484"/>
                <a:gd name="connsiteY14" fmla="*/ 1097820 h 8640339"/>
                <a:gd name="connsiteX0" fmla="*/ 268957 w 537484"/>
                <a:gd name="connsiteY0" fmla="*/ 1121632 h 8640339"/>
                <a:gd name="connsiteX1" fmla="*/ 400265 w 537484"/>
                <a:gd name="connsiteY1" fmla="*/ 5487938 h 8640339"/>
                <a:gd name="connsiteX2" fmla="*/ 443808 w 537484"/>
                <a:gd name="connsiteY2" fmla="*/ 7839252 h 8640339"/>
                <a:gd name="connsiteX3" fmla="*/ 458322 w 537484"/>
                <a:gd name="connsiteY3" fmla="*/ 8260167 h 8640339"/>
                <a:gd name="connsiteX4" fmla="*/ 458322 w 537484"/>
                <a:gd name="connsiteY4" fmla="*/ 8593995 h 8640339"/>
                <a:gd name="connsiteX5" fmla="*/ 516379 w 537484"/>
                <a:gd name="connsiteY5" fmla="*/ 8608509 h 8640339"/>
                <a:gd name="connsiteX6" fmla="*/ 51922 w 537484"/>
                <a:gd name="connsiteY6" fmla="*/ 8608509 h 8640339"/>
                <a:gd name="connsiteX7" fmla="*/ 8379 w 537484"/>
                <a:gd name="connsiteY7" fmla="*/ 8593995 h 8640339"/>
                <a:gd name="connsiteX8" fmla="*/ 8379 w 537484"/>
                <a:gd name="connsiteY8" fmla="*/ 8274681 h 8640339"/>
                <a:gd name="connsiteX9" fmla="*/ 95465 w 537484"/>
                <a:gd name="connsiteY9" fmla="*/ 4965424 h 8640339"/>
                <a:gd name="connsiteX10" fmla="*/ 197065 w 537484"/>
                <a:gd name="connsiteY10" fmla="*/ 712738 h 8640339"/>
                <a:gd name="connsiteX11" fmla="*/ 206136 w 537484"/>
                <a:gd name="connsiteY11" fmla="*/ 132167 h 8640339"/>
                <a:gd name="connsiteX12" fmla="*/ 226547 w 537484"/>
                <a:gd name="connsiteY12" fmla="*/ 31926 h 8640339"/>
                <a:gd name="connsiteX13" fmla="*/ 244689 w 537484"/>
                <a:gd name="connsiteY13" fmla="*/ 604788 h 8640339"/>
                <a:gd name="connsiteX14" fmla="*/ 268957 w 537484"/>
                <a:gd name="connsiteY14" fmla="*/ 1121632 h 8640339"/>
                <a:gd name="connsiteX0" fmla="*/ 268957 w 467285"/>
                <a:gd name="connsiteY0" fmla="*/ 1121632 h 8640339"/>
                <a:gd name="connsiteX1" fmla="*/ 400265 w 467285"/>
                <a:gd name="connsiteY1" fmla="*/ 5487938 h 8640339"/>
                <a:gd name="connsiteX2" fmla="*/ 443808 w 467285"/>
                <a:gd name="connsiteY2" fmla="*/ 7839252 h 8640339"/>
                <a:gd name="connsiteX3" fmla="*/ 458322 w 467285"/>
                <a:gd name="connsiteY3" fmla="*/ 8260167 h 8640339"/>
                <a:gd name="connsiteX4" fmla="*/ 458322 w 467285"/>
                <a:gd name="connsiteY4" fmla="*/ 8593995 h 8640339"/>
                <a:gd name="connsiteX5" fmla="*/ 344929 w 467285"/>
                <a:gd name="connsiteY5" fmla="*/ 8618034 h 8640339"/>
                <a:gd name="connsiteX6" fmla="*/ 51922 w 467285"/>
                <a:gd name="connsiteY6" fmla="*/ 8608509 h 8640339"/>
                <a:gd name="connsiteX7" fmla="*/ 8379 w 467285"/>
                <a:gd name="connsiteY7" fmla="*/ 8593995 h 8640339"/>
                <a:gd name="connsiteX8" fmla="*/ 8379 w 467285"/>
                <a:gd name="connsiteY8" fmla="*/ 8274681 h 8640339"/>
                <a:gd name="connsiteX9" fmla="*/ 95465 w 467285"/>
                <a:gd name="connsiteY9" fmla="*/ 4965424 h 8640339"/>
                <a:gd name="connsiteX10" fmla="*/ 197065 w 467285"/>
                <a:gd name="connsiteY10" fmla="*/ 712738 h 8640339"/>
                <a:gd name="connsiteX11" fmla="*/ 206136 w 467285"/>
                <a:gd name="connsiteY11" fmla="*/ 132167 h 8640339"/>
                <a:gd name="connsiteX12" fmla="*/ 226547 w 467285"/>
                <a:gd name="connsiteY12" fmla="*/ 31926 h 8640339"/>
                <a:gd name="connsiteX13" fmla="*/ 244689 w 467285"/>
                <a:gd name="connsiteY13" fmla="*/ 604788 h 8640339"/>
                <a:gd name="connsiteX14" fmla="*/ 268957 w 467285"/>
                <a:gd name="connsiteY14" fmla="*/ 1121632 h 8640339"/>
                <a:gd name="connsiteX0" fmla="*/ 270835 w 469163"/>
                <a:gd name="connsiteY0" fmla="*/ 1121632 h 8639464"/>
                <a:gd name="connsiteX1" fmla="*/ 402143 w 469163"/>
                <a:gd name="connsiteY1" fmla="*/ 5487938 h 8639464"/>
                <a:gd name="connsiteX2" fmla="*/ 445686 w 469163"/>
                <a:gd name="connsiteY2" fmla="*/ 7839252 h 8639464"/>
                <a:gd name="connsiteX3" fmla="*/ 460200 w 469163"/>
                <a:gd name="connsiteY3" fmla="*/ 8260167 h 8639464"/>
                <a:gd name="connsiteX4" fmla="*/ 460200 w 469163"/>
                <a:gd name="connsiteY4" fmla="*/ 8593995 h 8639464"/>
                <a:gd name="connsiteX5" fmla="*/ 346807 w 469163"/>
                <a:gd name="connsiteY5" fmla="*/ 8618034 h 8639464"/>
                <a:gd name="connsiteX6" fmla="*/ 87137 w 469163"/>
                <a:gd name="connsiteY6" fmla="*/ 8622796 h 8639464"/>
                <a:gd name="connsiteX7" fmla="*/ 10257 w 469163"/>
                <a:gd name="connsiteY7" fmla="*/ 8593995 h 8639464"/>
                <a:gd name="connsiteX8" fmla="*/ 10257 w 469163"/>
                <a:gd name="connsiteY8" fmla="*/ 8274681 h 8639464"/>
                <a:gd name="connsiteX9" fmla="*/ 97343 w 469163"/>
                <a:gd name="connsiteY9" fmla="*/ 4965424 h 8639464"/>
                <a:gd name="connsiteX10" fmla="*/ 198943 w 469163"/>
                <a:gd name="connsiteY10" fmla="*/ 712738 h 8639464"/>
                <a:gd name="connsiteX11" fmla="*/ 208014 w 469163"/>
                <a:gd name="connsiteY11" fmla="*/ 132167 h 8639464"/>
                <a:gd name="connsiteX12" fmla="*/ 228425 w 469163"/>
                <a:gd name="connsiteY12" fmla="*/ 31926 h 8639464"/>
                <a:gd name="connsiteX13" fmla="*/ 246567 w 469163"/>
                <a:gd name="connsiteY13" fmla="*/ 604788 h 8639464"/>
                <a:gd name="connsiteX14" fmla="*/ 270835 w 469163"/>
                <a:gd name="connsiteY14" fmla="*/ 1121632 h 8639464"/>
                <a:gd name="connsiteX0" fmla="*/ 280632 w 478960"/>
                <a:gd name="connsiteY0" fmla="*/ 1121632 h 8629359"/>
                <a:gd name="connsiteX1" fmla="*/ 411940 w 478960"/>
                <a:gd name="connsiteY1" fmla="*/ 5487938 h 8629359"/>
                <a:gd name="connsiteX2" fmla="*/ 455483 w 478960"/>
                <a:gd name="connsiteY2" fmla="*/ 7839252 h 8629359"/>
                <a:gd name="connsiteX3" fmla="*/ 469997 w 478960"/>
                <a:gd name="connsiteY3" fmla="*/ 8260167 h 8629359"/>
                <a:gd name="connsiteX4" fmla="*/ 469997 w 478960"/>
                <a:gd name="connsiteY4" fmla="*/ 8593995 h 8629359"/>
                <a:gd name="connsiteX5" fmla="*/ 356604 w 478960"/>
                <a:gd name="connsiteY5" fmla="*/ 8618034 h 8629359"/>
                <a:gd name="connsiteX6" fmla="*/ 96934 w 478960"/>
                <a:gd name="connsiteY6" fmla="*/ 8622796 h 8629359"/>
                <a:gd name="connsiteX7" fmla="*/ 5767 w 478960"/>
                <a:gd name="connsiteY7" fmla="*/ 8527320 h 8629359"/>
                <a:gd name="connsiteX8" fmla="*/ 20054 w 478960"/>
                <a:gd name="connsiteY8" fmla="*/ 8274681 h 8629359"/>
                <a:gd name="connsiteX9" fmla="*/ 107140 w 478960"/>
                <a:gd name="connsiteY9" fmla="*/ 4965424 h 8629359"/>
                <a:gd name="connsiteX10" fmla="*/ 208740 w 478960"/>
                <a:gd name="connsiteY10" fmla="*/ 712738 h 8629359"/>
                <a:gd name="connsiteX11" fmla="*/ 217811 w 478960"/>
                <a:gd name="connsiteY11" fmla="*/ 132167 h 8629359"/>
                <a:gd name="connsiteX12" fmla="*/ 238222 w 478960"/>
                <a:gd name="connsiteY12" fmla="*/ 31926 h 8629359"/>
                <a:gd name="connsiteX13" fmla="*/ 256364 w 478960"/>
                <a:gd name="connsiteY13" fmla="*/ 604788 h 8629359"/>
                <a:gd name="connsiteX14" fmla="*/ 280632 w 478960"/>
                <a:gd name="connsiteY14" fmla="*/ 1121632 h 8629359"/>
                <a:gd name="connsiteX0" fmla="*/ 274911 w 473239"/>
                <a:gd name="connsiteY0" fmla="*/ 1121632 h 8629359"/>
                <a:gd name="connsiteX1" fmla="*/ 406219 w 473239"/>
                <a:gd name="connsiteY1" fmla="*/ 5487938 h 8629359"/>
                <a:gd name="connsiteX2" fmla="*/ 449762 w 473239"/>
                <a:gd name="connsiteY2" fmla="*/ 7839252 h 8629359"/>
                <a:gd name="connsiteX3" fmla="*/ 464276 w 473239"/>
                <a:gd name="connsiteY3" fmla="*/ 8260167 h 8629359"/>
                <a:gd name="connsiteX4" fmla="*/ 464276 w 473239"/>
                <a:gd name="connsiteY4" fmla="*/ 8593995 h 8629359"/>
                <a:gd name="connsiteX5" fmla="*/ 350883 w 473239"/>
                <a:gd name="connsiteY5" fmla="*/ 8618034 h 8629359"/>
                <a:gd name="connsiteX6" fmla="*/ 91213 w 473239"/>
                <a:gd name="connsiteY6" fmla="*/ 8622796 h 8629359"/>
                <a:gd name="connsiteX7" fmla="*/ 46 w 473239"/>
                <a:gd name="connsiteY7" fmla="*/ 8527320 h 8629359"/>
                <a:gd name="connsiteX8" fmla="*/ 14333 w 473239"/>
                <a:gd name="connsiteY8" fmla="*/ 8274681 h 8629359"/>
                <a:gd name="connsiteX9" fmla="*/ 101419 w 473239"/>
                <a:gd name="connsiteY9" fmla="*/ 4965424 h 8629359"/>
                <a:gd name="connsiteX10" fmla="*/ 203019 w 473239"/>
                <a:gd name="connsiteY10" fmla="*/ 712738 h 8629359"/>
                <a:gd name="connsiteX11" fmla="*/ 212090 w 473239"/>
                <a:gd name="connsiteY11" fmla="*/ 132167 h 8629359"/>
                <a:gd name="connsiteX12" fmla="*/ 232501 w 473239"/>
                <a:gd name="connsiteY12" fmla="*/ 31926 h 8629359"/>
                <a:gd name="connsiteX13" fmla="*/ 250643 w 473239"/>
                <a:gd name="connsiteY13" fmla="*/ 604788 h 8629359"/>
                <a:gd name="connsiteX14" fmla="*/ 274911 w 473239"/>
                <a:gd name="connsiteY14" fmla="*/ 1121632 h 8629359"/>
                <a:gd name="connsiteX0" fmla="*/ 274911 w 480890"/>
                <a:gd name="connsiteY0" fmla="*/ 1121632 h 8632030"/>
                <a:gd name="connsiteX1" fmla="*/ 406219 w 480890"/>
                <a:gd name="connsiteY1" fmla="*/ 5487938 h 8632030"/>
                <a:gd name="connsiteX2" fmla="*/ 449762 w 480890"/>
                <a:gd name="connsiteY2" fmla="*/ 7839252 h 8632030"/>
                <a:gd name="connsiteX3" fmla="*/ 464276 w 480890"/>
                <a:gd name="connsiteY3" fmla="*/ 8260167 h 8632030"/>
                <a:gd name="connsiteX4" fmla="*/ 473801 w 480890"/>
                <a:gd name="connsiteY4" fmla="*/ 8532082 h 8632030"/>
                <a:gd name="connsiteX5" fmla="*/ 350883 w 480890"/>
                <a:gd name="connsiteY5" fmla="*/ 8618034 h 8632030"/>
                <a:gd name="connsiteX6" fmla="*/ 91213 w 480890"/>
                <a:gd name="connsiteY6" fmla="*/ 8622796 h 8632030"/>
                <a:gd name="connsiteX7" fmla="*/ 46 w 480890"/>
                <a:gd name="connsiteY7" fmla="*/ 8527320 h 8632030"/>
                <a:gd name="connsiteX8" fmla="*/ 14333 w 480890"/>
                <a:gd name="connsiteY8" fmla="*/ 8274681 h 8632030"/>
                <a:gd name="connsiteX9" fmla="*/ 101419 w 480890"/>
                <a:gd name="connsiteY9" fmla="*/ 4965424 h 8632030"/>
                <a:gd name="connsiteX10" fmla="*/ 203019 w 480890"/>
                <a:gd name="connsiteY10" fmla="*/ 712738 h 8632030"/>
                <a:gd name="connsiteX11" fmla="*/ 212090 w 480890"/>
                <a:gd name="connsiteY11" fmla="*/ 132167 h 8632030"/>
                <a:gd name="connsiteX12" fmla="*/ 232501 w 480890"/>
                <a:gd name="connsiteY12" fmla="*/ 31926 h 8632030"/>
                <a:gd name="connsiteX13" fmla="*/ 250643 w 480890"/>
                <a:gd name="connsiteY13" fmla="*/ 604788 h 8632030"/>
                <a:gd name="connsiteX14" fmla="*/ 274911 w 480890"/>
                <a:gd name="connsiteY14" fmla="*/ 1121632 h 8632030"/>
                <a:gd name="connsiteX0" fmla="*/ 274911 w 474066"/>
                <a:gd name="connsiteY0" fmla="*/ 1121632 h 8632030"/>
                <a:gd name="connsiteX1" fmla="*/ 406219 w 474066"/>
                <a:gd name="connsiteY1" fmla="*/ 5487938 h 8632030"/>
                <a:gd name="connsiteX2" fmla="*/ 449762 w 474066"/>
                <a:gd name="connsiteY2" fmla="*/ 7839252 h 8632030"/>
                <a:gd name="connsiteX3" fmla="*/ 464276 w 474066"/>
                <a:gd name="connsiteY3" fmla="*/ 8260167 h 8632030"/>
                <a:gd name="connsiteX4" fmla="*/ 473801 w 474066"/>
                <a:gd name="connsiteY4" fmla="*/ 8532082 h 8632030"/>
                <a:gd name="connsiteX5" fmla="*/ 350883 w 474066"/>
                <a:gd name="connsiteY5" fmla="*/ 8618034 h 8632030"/>
                <a:gd name="connsiteX6" fmla="*/ 91213 w 474066"/>
                <a:gd name="connsiteY6" fmla="*/ 8622796 h 8632030"/>
                <a:gd name="connsiteX7" fmla="*/ 46 w 474066"/>
                <a:gd name="connsiteY7" fmla="*/ 8527320 h 8632030"/>
                <a:gd name="connsiteX8" fmla="*/ 14333 w 474066"/>
                <a:gd name="connsiteY8" fmla="*/ 8274681 h 8632030"/>
                <a:gd name="connsiteX9" fmla="*/ 101419 w 474066"/>
                <a:gd name="connsiteY9" fmla="*/ 4965424 h 8632030"/>
                <a:gd name="connsiteX10" fmla="*/ 203019 w 474066"/>
                <a:gd name="connsiteY10" fmla="*/ 712738 h 8632030"/>
                <a:gd name="connsiteX11" fmla="*/ 212090 w 474066"/>
                <a:gd name="connsiteY11" fmla="*/ 132167 h 8632030"/>
                <a:gd name="connsiteX12" fmla="*/ 232501 w 474066"/>
                <a:gd name="connsiteY12" fmla="*/ 31926 h 8632030"/>
                <a:gd name="connsiteX13" fmla="*/ 250643 w 474066"/>
                <a:gd name="connsiteY13" fmla="*/ 604788 h 8632030"/>
                <a:gd name="connsiteX14" fmla="*/ 274911 w 474066"/>
                <a:gd name="connsiteY14" fmla="*/ 1121632 h 8632030"/>
                <a:gd name="connsiteX0" fmla="*/ 274911 w 478814"/>
                <a:gd name="connsiteY0" fmla="*/ 1121632 h 8631000"/>
                <a:gd name="connsiteX1" fmla="*/ 406219 w 478814"/>
                <a:gd name="connsiteY1" fmla="*/ 5487938 h 8631000"/>
                <a:gd name="connsiteX2" fmla="*/ 449762 w 478814"/>
                <a:gd name="connsiteY2" fmla="*/ 7839252 h 8631000"/>
                <a:gd name="connsiteX3" fmla="*/ 464276 w 478814"/>
                <a:gd name="connsiteY3" fmla="*/ 8260167 h 8631000"/>
                <a:gd name="connsiteX4" fmla="*/ 478563 w 478814"/>
                <a:gd name="connsiteY4" fmla="*/ 8593995 h 8631000"/>
                <a:gd name="connsiteX5" fmla="*/ 350883 w 478814"/>
                <a:gd name="connsiteY5" fmla="*/ 8618034 h 8631000"/>
                <a:gd name="connsiteX6" fmla="*/ 91213 w 478814"/>
                <a:gd name="connsiteY6" fmla="*/ 8622796 h 8631000"/>
                <a:gd name="connsiteX7" fmla="*/ 46 w 478814"/>
                <a:gd name="connsiteY7" fmla="*/ 8527320 h 8631000"/>
                <a:gd name="connsiteX8" fmla="*/ 14333 w 478814"/>
                <a:gd name="connsiteY8" fmla="*/ 8274681 h 8631000"/>
                <a:gd name="connsiteX9" fmla="*/ 101419 w 478814"/>
                <a:gd name="connsiteY9" fmla="*/ 4965424 h 8631000"/>
                <a:gd name="connsiteX10" fmla="*/ 203019 w 478814"/>
                <a:gd name="connsiteY10" fmla="*/ 712738 h 8631000"/>
                <a:gd name="connsiteX11" fmla="*/ 212090 w 478814"/>
                <a:gd name="connsiteY11" fmla="*/ 132167 h 8631000"/>
                <a:gd name="connsiteX12" fmla="*/ 232501 w 478814"/>
                <a:gd name="connsiteY12" fmla="*/ 31926 h 8631000"/>
                <a:gd name="connsiteX13" fmla="*/ 250643 w 478814"/>
                <a:gd name="connsiteY13" fmla="*/ 604788 h 8631000"/>
                <a:gd name="connsiteX14" fmla="*/ 274911 w 478814"/>
                <a:gd name="connsiteY14" fmla="*/ 1121632 h 8631000"/>
                <a:gd name="connsiteX0" fmla="*/ 274908 w 486316"/>
                <a:gd name="connsiteY0" fmla="*/ 1121632 h 8631060"/>
                <a:gd name="connsiteX1" fmla="*/ 406216 w 486316"/>
                <a:gd name="connsiteY1" fmla="*/ 5487938 h 8631060"/>
                <a:gd name="connsiteX2" fmla="*/ 449759 w 486316"/>
                <a:gd name="connsiteY2" fmla="*/ 7839252 h 8631060"/>
                <a:gd name="connsiteX3" fmla="*/ 464273 w 486316"/>
                <a:gd name="connsiteY3" fmla="*/ 8260167 h 8631060"/>
                <a:gd name="connsiteX4" fmla="*/ 478560 w 486316"/>
                <a:gd name="connsiteY4" fmla="*/ 8593995 h 8631060"/>
                <a:gd name="connsiteX5" fmla="*/ 331830 w 486316"/>
                <a:gd name="connsiteY5" fmla="*/ 8622797 h 8631060"/>
                <a:gd name="connsiteX6" fmla="*/ 91210 w 486316"/>
                <a:gd name="connsiteY6" fmla="*/ 8622796 h 8631060"/>
                <a:gd name="connsiteX7" fmla="*/ 43 w 486316"/>
                <a:gd name="connsiteY7" fmla="*/ 8527320 h 8631060"/>
                <a:gd name="connsiteX8" fmla="*/ 14330 w 486316"/>
                <a:gd name="connsiteY8" fmla="*/ 8274681 h 8631060"/>
                <a:gd name="connsiteX9" fmla="*/ 101416 w 486316"/>
                <a:gd name="connsiteY9" fmla="*/ 4965424 h 8631060"/>
                <a:gd name="connsiteX10" fmla="*/ 203016 w 486316"/>
                <a:gd name="connsiteY10" fmla="*/ 712738 h 8631060"/>
                <a:gd name="connsiteX11" fmla="*/ 212087 w 486316"/>
                <a:gd name="connsiteY11" fmla="*/ 132167 h 8631060"/>
                <a:gd name="connsiteX12" fmla="*/ 232498 w 486316"/>
                <a:gd name="connsiteY12" fmla="*/ 31926 h 8631060"/>
                <a:gd name="connsiteX13" fmla="*/ 250640 w 486316"/>
                <a:gd name="connsiteY13" fmla="*/ 604788 h 8631060"/>
                <a:gd name="connsiteX14" fmla="*/ 274908 w 486316"/>
                <a:gd name="connsiteY14" fmla="*/ 1121632 h 8631060"/>
                <a:gd name="connsiteX0" fmla="*/ 277822 w 489230"/>
                <a:gd name="connsiteY0" fmla="*/ 1121632 h 8634642"/>
                <a:gd name="connsiteX1" fmla="*/ 409130 w 489230"/>
                <a:gd name="connsiteY1" fmla="*/ 5487938 h 8634642"/>
                <a:gd name="connsiteX2" fmla="*/ 452673 w 489230"/>
                <a:gd name="connsiteY2" fmla="*/ 7839252 h 8634642"/>
                <a:gd name="connsiteX3" fmla="*/ 467187 w 489230"/>
                <a:gd name="connsiteY3" fmla="*/ 8260167 h 8634642"/>
                <a:gd name="connsiteX4" fmla="*/ 481474 w 489230"/>
                <a:gd name="connsiteY4" fmla="*/ 8593995 h 8634642"/>
                <a:gd name="connsiteX5" fmla="*/ 334744 w 489230"/>
                <a:gd name="connsiteY5" fmla="*/ 8622797 h 8634642"/>
                <a:gd name="connsiteX6" fmla="*/ 56024 w 489230"/>
                <a:gd name="connsiteY6" fmla="*/ 8627559 h 8634642"/>
                <a:gd name="connsiteX7" fmla="*/ 2957 w 489230"/>
                <a:gd name="connsiteY7" fmla="*/ 8527320 h 8634642"/>
                <a:gd name="connsiteX8" fmla="*/ 17244 w 489230"/>
                <a:gd name="connsiteY8" fmla="*/ 8274681 h 8634642"/>
                <a:gd name="connsiteX9" fmla="*/ 104330 w 489230"/>
                <a:gd name="connsiteY9" fmla="*/ 4965424 h 8634642"/>
                <a:gd name="connsiteX10" fmla="*/ 205930 w 489230"/>
                <a:gd name="connsiteY10" fmla="*/ 712738 h 8634642"/>
                <a:gd name="connsiteX11" fmla="*/ 215001 w 489230"/>
                <a:gd name="connsiteY11" fmla="*/ 132167 h 8634642"/>
                <a:gd name="connsiteX12" fmla="*/ 235412 w 489230"/>
                <a:gd name="connsiteY12" fmla="*/ 31926 h 8634642"/>
                <a:gd name="connsiteX13" fmla="*/ 253554 w 489230"/>
                <a:gd name="connsiteY13" fmla="*/ 604788 h 8634642"/>
                <a:gd name="connsiteX14" fmla="*/ 277822 w 489230"/>
                <a:gd name="connsiteY14" fmla="*/ 1121632 h 863464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</a:cxnLst>
              <a:rect l="l" t="t" r="r" b="b"/>
              <a:pathLst>
                <a:path w="489230" h="8634642">
                  <a:moveTo>
                    <a:pt x="277822" y="1121632"/>
                  </a:moveTo>
                  <a:cubicBezTo>
                    <a:pt x="303751" y="1935490"/>
                    <a:pt x="379988" y="4368335"/>
                    <a:pt x="409130" y="5487938"/>
                  </a:cubicBezTo>
                  <a:cubicBezTo>
                    <a:pt x="438272" y="6607541"/>
                    <a:pt x="442997" y="7377214"/>
                    <a:pt x="452673" y="7839252"/>
                  </a:cubicBezTo>
                  <a:cubicBezTo>
                    <a:pt x="462349" y="8301290"/>
                    <a:pt x="462387" y="8134377"/>
                    <a:pt x="467187" y="8260167"/>
                  </a:cubicBezTo>
                  <a:cubicBezTo>
                    <a:pt x="471987" y="8385957"/>
                    <a:pt x="503548" y="8533557"/>
                    <a:pt x="481474" y="8593995"/>
                  </a:cubicBezTo>
                  <a:cubicBezTo>
                    <a:pt x="459400" y="8654433"/>
                    <a:pt x="405652" y="8617203"/>
                    <a:pt x="334744" y="8622797"/>
                  </a:cubicBezTo>
                  <a:cubicBezTo>
                    <a:pt x="263836" y="8628391"/>
                    <a:pt x="111322" y="8643472"/>
                    <a:pt x="56024" y="8627559"/>
                  </a:cubicBezTo>
                  <a:cubicBezTo>
                    <a:pt x="726" y="8611646"/>
                    <a:pt x="9420" y="8586133"/>
                    <a:pt x="2957" y="8527320"/>
                  </a:cubicBezTo>
                  <a:cubicBezTo>
                    <a:pt x="-3506" y="8468507"/>
                    <a:pt x="348" y="8868330"/>
                    <a:pt x="17244" y="8274681"/>
                  </a:cubicBezTo>
                  <a:cubicBezTo>
                    <a:pt x="34140" y="7681032"/>
                    <a:pt x="72882" y="6225748"/>
                    <a:pt x="104330" y="4965424"/>
                  </a:cubicBezTo>
                  <a:cubicBezTo>
                    <a:pt x="135778" y="3705100"/>
                    <a:pt x="187485" y="1518281"/>
                    <a:pt x="205930" y="712738"/>
                  </a:cubicBezTo>
                  <a:cubicBezTo>
                    <a:pt x="224375" y="-92805"/>
                    <a:pt x="205325" y="231348"/>
                    <a:pt x="215001" y="132167"/>
                  </a:cubicBezTo>
                  <a:cubicBezTo>
                    <a:pt x="224677" y="32986"/>
                    <a:pt x="228987" y="-46844"/>
                    <a:pt x="235412" y="31926"/>
                  </a:cubicBezTo>
                  <a:cubicBezTo>
                    <a:pt x="241838" y="110696"/>
                    <a:pt x="258392" y="399357"/>
                    <a:pt x="253554" y="604788"/>
                  </a:cubicBezTo>
                  <a:cubicBezTo>
                    <a:pt x="263004" y="734019"/>
                    <a:pt x="251893" y="307774"/>
                    <a:pt x="277822" y="1121632"/>
                  </a:cubicBezTo>
                  <a:close/>
                </a:path>
              </a:pathLst>
            </a:custGeom>
            <a:solidFill>
              <a:srgbClr val="92D050"/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grpSp>
          <p:nvGrpSpPr>
            <p:cNvPr id="26" name="Group 2"/>
            <p:cNvGrpSpPr>
              <a:grpSpLocks/>
            </p:cNvGrpSpPr>
            <p:nvPr/>
          </p:nvGrpSpPr>
          <p:grpSpPr bwMode="auto">
            <a:xfrm>
              <a:off x="2420917" y="2511438"/>
              <a:ext cx="464354" cy="3532558"/>
              <a:chOff x="3539084" y="4246563"/>
              <a:chExt cx="507954" cy="3849354"/>
            </a:xfrm>
          </p:grpSpPr>
          <p:sp>
            <p:nvSpPr>
              <p:cNvPr id="137" name="Freeform 136"/>
              <p:cNvSpPr/>
              <p:nvPr/>
            </p:nvSpPr>
            <p:spPr bwMode="auto">
              <a:xfrm>
                <a:off x="3737177" y="4246489"/>
                <a:ext cx="112673" cy="168269"/>
              </a:xfrm>
              <a:custGeom>
                <a:avLst/>
                <a:gdLst>
                  <a:gd name="connsiteX0" fmla="*/ 130797 w 378463"/>
                  <a:gd name="connsiteY0" fmla="*/ 330774 h 590424"/>
                  <a:gd name="connsiteX1" fmla="*/ 67297 w 378463"/>
                  <a:gd name="connsiteY1" fmla="*/ 273624 h 590424"/>
                  <a:gd name="connsiteX2" fmla="*/ 105397 w 378463"/>
                  <a:gd name="connsiteY2" fmla="*/ 159324 h 590424"/>
                  <a:gd name="connsiteX3" fmla="*/ 118097 w 378463"/>
                  <a:gd name="connsiteY3" fmla="*/ 222824 h 590424"/>
                  <a:gd name="connsiteX4" fmla="*/ 156197 w 378463"/>
                  <a:gd name="connsiteY4" fmla="*/ 279974 h 590424"/>
                  <a:gd name="connsiteX5" fmla="*/ 137147 w 378463"/>
                  <a:gd name="connsiteY5" fmla="*/ 159324 h 590424"/>
                  <a:gd name="connsiteX6" fmla="*/ 168897 w 378463"/>
                  <a:gd name="connsiteY6" fmla="*/ 70424 h 590424"/>
                  <a:gd name="connsiteX7" fmla="*/ 175247 w 378463"/>
                  <a:gd name="connsiteY7" fmla="*/ 102174 h 590424"/>
                  <a:gd name="connsiteX8" fmla="*/ 194297 w 378463"/>
                  <a:gd name="connsiteY8" fmla="*/ 260924 h 590424"/>
                  <a:gd name="connsiteX9" fmla="*/ 213347 w 378463"/>
                  <a:gd name="connsiteY9" fmla="*/ 108524 h 590424"/>
                  <a:gd name="connsiteX10" fmla="*/ 181597 w 378463"/>
                  <a:gd name="connsiteY10" fmla="*/ 574 h 590424"/>
                  <a:gd name="connsiteX11" fmla="*/ 257797 w 378463"/>
                  <a:gd name="connsiteY11" fmla="*/ 76774 h 590424"/>
                  <a:gd name="connsiteX12" fmla="*/ 226047 w 378463"/>
                  <a:gd name="connsiteY12" fmla="*/ 299024 h 590424"/>
                  <a:gd name="connsiteX13" fmla="*/ 283197 w 378463"/>
                  <a:gd name="connsiteY13" fmla="*/ 191074 h 590424"/>
                  <a:gd name="connsiteX14" fmla="*/ 283197 w 378463"/>
                  <a:gd name="connsiteY14" fmla="*/ 114874 h 590424"/>
                  <a:gd name="connsiteX15" fmla="*/ 302247 w 378463"/>
                  <a:gd name="connsiteY15" fmla="*/ 279974 h 590424"/>
                  <a:gd name="connsiteX16" fmla="*/ 245097 w 378463"/>
                  <a:gd name="connsiteY16" fmla="*/ 368874 h 590424"/>
                  <a:gd name="connsiteX17" fmla="*/ 206997 w 378463"/>
                  <a:gd name="connsiteY17" fmla="*/ 457774 h 590424"/>
                  <a:gd name="connsiteX18" fmla="*/ 302247 w 378463"/>
                  <a:gd name="connsiteY18" fmla="*/ 368874 h 590424"/>
                  <a:gd name="connsiteX19" fmla="*/ 378447 w 378463"/>
                  <a:gd name="connsiteY19" fmla="*/ 305374 h 590424"/>
                  <a:gd name="connsiteX20" fmla="*/ 295897 w 378463"/>
                  <a:gd name="connsiteY20" fmla="*/ 438724 h 590424"/>
                  <a:gd name="connsiteX21" fmla="*/ 226047 w 378463"/>
                  <a:gd name="connsiteY21" fmla="*/ 572074 h 590424"/>
                  <a:gd name="connsiteX22" fmla="*/ 149847 w 378463"/>
                  <a:gd name="connsiteY22" fmla="*/ 578424 h 590424"/>
                  <a:gd name="connsiteX23" fmla="*/ 149847 w 378463"/>
                  <a:gd name="connsiteY23" fmla="*/ 470474 h 590424"/>
                  <a:gd name="connsiteX24" fmla="*/ 54597 w 378463"/>
                  <a:gd name="connsiteY24" fmla="*/ 349824 h 590424"/>
                  <a:gd name="connsiteX25" fmla="*/ 3797 w 378463"/>
                  <a:gd name="connsiteY25" fmla="*/ 229174 h 590424"/>
                  <a:gd name="connsiteX26" fmla="*/ 16497 w 378463"/>
                  <a:gd name="connsiteY26" fmla="*/ 203774 h 590424"/>
                  <a:gd name="connsiteX27" fmla="*/ 130797 w 378463"/>
                  <a:gd name="connsiteY27" fmla="*/ 330774 h 590424"/>
                  <a:gd name="connsiteX0" fmla="*/ 130797 w 378463"/>
                  <a:gd name="connsiteY0" fmla="*/ 330774 h 590863"/>
                  <a:gd name="connsiteX1" fmla="*/ 67297 w 378463"/>
                  <a:gd name="connsiteY1" fmla="*/ 273624 h 590863"/>
                  <a:gd name="connsiteX2" fmla="*/ 105397 w 378463"/>
                  <a:gd name="connsiteY2" fmla="*/ 159324 h 590863"/>
                  <a:gd name="connsiteX3" fmla="*/ 118097 w 378463"/>
                  <a:gd name="connsiteY3" fmla="*/ 222824 h 590863"/>
                  <a:gd name="connsiteX4" fmla="*/ 156197 w 378463"/>
                  <a:gd name="connsiteY4" fmla="*/ 279974 h 590863"/>
                  <a:gd name="connsiteX5" fmla="*/ 137147 w 378463"/>
                  <a:gd name="connsiteY5" fmla="*/ 159324 h 590863"/>
                  <a:gd name="connsiteX6" fmla="*/ 168897 w 378463"/>
                  <a:gd name="connsiteY6" fmla="*/ 70424 h 590863"/>
                  <a:gd name="connsiteX7" fmla="*/ 175247 w 378463"/>
                  <a:gd name="connsiteY7" fmla="*/ 102174 h 590863"/>
                  <a:gd name="connsiteX8" fmla="*/ 194297 w 378463"/>
                  <a:gd name="connsiteY8" fmla="*/ 260924 h 590863"/>
                  <a:gd name="connsiteX9" fmla="*/ 213347 w 378463"/>
                  <a:gd name="connsiteY9" fmla="*/ 108524 h 590863"/>
                  <a:gd name="connsiteX10" fmla="*/ 181597 w 378463"/>
                  <a:gd name="connsiteY10" fmla="*/ 574 h 590863"/>
                  <a:gd name="connsiteX11" fmla="*/ 257797 w 378463"/>
                  <a:gd name="connsiteY11" fmla="*/ 76774 h 590863"/>
                  <a:gd name="connsiteX12" fmla="*/ 226047 w 378463"/>
                  <a:gd name="connsiteY12" fmla="*/ 299024 h 590863"/>
                  <a:gd name="connsiteX13" fmla="*/ 283197 w 378463"/>
                  <a:gd name="connsiteY13" fmla="*/ 191074 h 590863"/>
                  <a:gd name="connsiteX14" fmla="*/ 283197 w 378463"/>
                  <a:gd name="connsiteY14" fmla="*/ 114874 h 590863"/>
                  <a:gd name="connsiteX15" fmla="*/ 302247 w 378463"/>
                  <a:gd name="connsiteY15" fmla="*/ 279974 h 590863"/>
                  <a:gd name="connsiteX16" fmla="*/ 245097 w 378463"/>
                  <a:gd name="connsiteY16" fmla="*/ 368874 h 590863"/>
                  <a:gd name="connsiteX17" fmla="*/ 206997 w 378463"/>
                  <a:gd name="connsiteY17" fmla="*/ 457774 h 590863"/>
                  <a:gd name="connsiteX18" fmla="*/ 302247 w 378463"/>
                  <a:gd name="connsiteY18" fmla="*/ 368874 h 590863"/>
                  <a:gd name="connsiteX19" fmla="*/ 378447 w 378463"/>
                  <a:gd name="connsiteY19" fmla="*/ 305374 h 590863"/>
                  <a:gd name="connsiteX20" fmla="*/ 295897 w 378463"/>
                  <a:gd name="connsiteY20" fmla="*/ 438724 h 590863"/>
                  <a:gd name="connsiteX21" fmla="*/ 226047 w 378463"/>
                  <a:gd name="connsiteY21" fmla="*/ 572074 h 590863"/>
                  <a:gd name="connsiteX22" fmla="*/ 149847 w 378463"/>
                  <a:gd name="connsiteY22" fmla="*/ 578424 h 590863"/>
                  <a:gd name="connsiteX23" fmla="*/ 142680 w 378463"/>
                  <a:gd name="connsiteY23" fmla="*/ 463942 h 590863"/>
                  <a:gd name="connsiteX24" fmla="*/ 54597 w 378463"/>
                  <a:gd name="connsiteY24" fmla="*/ 349824 h 590863"/>
                  <a:gd name="connsiteX25" fmla="*/ 3797 w 378463"/>
                  <a:gd name="connsiteY25" fmla="*/ 229174 h 590863"/>
                  <a:gd name="connsiteX26" fmla="*/ 16497 w 378463"/>
                  <a:gd name="connsiteY26" fmla="*/ 203774 h 590863"/>
                  <a:gd name="connsiteX27" fmla="*/ 130797 w 378463"/>
                  <a:gd name="connsiteY27" fmla="*/ 330774 h 590863"/>
                  <a:gd name="connsiteX0" fmla="*/ 130797 w 378463"/>
                  <a:gd name="connsiteY0" fmla="*/ 330774 h 590863"/>
                  <a:gd name="connsiteX1" fmla="*/ 67297 w 378463"/>
                  <a:gd name="connsiteY1" fmla="*/ 273624 h 590863"/>
                  <a:gd name="connsiteX2" fmla="*/ 105397 w 378463"/>
                  <a:gd name="connsiteY2" fmla="*/ 159324 h 590863"/>
                  <a:gd name="connsiteX3" fmla="*/ 118097 w 378463"/>
                  <a:gd name="connsiteY3" fmla="*/ 222824 h 590863"/>
                  <a:gd name="connsiteX4" fmla="*/ 156197 w 378463"/>
                  <a:gd name="connsiteY4" fmla="*/ 279974 h 590863"/>
                  <a:gd name="connsiteX5" fmla="*/ 137147 w 378463"/>
                  <a:gd name="connsiteY5" fmla="*/ 159324 h 590863"/>
                  <a:gd name="connsiteX6" fmla="*/ 168897 w 378463"/>
                  <a:gd name="connsiteY6" fmla="*/ 70424 h 590863"/>
                  <a:gd name="connsiteX7" fmla="*/ 175247 w 378463"/>
                  <a:gd name="connsiteY7" fmla="*/ 102174 h 590863"/>
                  <a:gd name="connsiteX8" fmla="*/ 194297 w 378463"/>
                  <a:gd name="connsiteY8" fmla="*/ 260924 h 590863"/>
                  <a:gd name="connsiteX9" fmla="*/ 213347 w 378463"/>
                  <a:gd name="connsiteY9" fmla="*/ 108524 h 590863"/>
                  <a:gd name="connsiteX10" fmla="*/ 181597 w 378463"/>
                  <a:gd name="connsiteY10" fmla="*/ 574 h 590863"/>
                  <a:gd name="connsiteX11" fmla="*/ 257797 w 378463"/>
                  <a:gd name="connsiteY11" fmla="*/ 76774 h 590863"/>
                  <a:gd name="connsiteX12" fmla="*/ 226047 w 378463"/>
                  <a:gd name="connsiteY12" fmla="*/ 299024 h 590863"/>
                  <a:gd name="connsiteX13" fmla="*/ 283197 w 378463"/>
                  <a:gd name="connsiteY13" fmla="*/ 191074 h 590863"/>
                  <a:gd name="connsiteX14" fmla="*/ 283197 w 378463"/>
                  <a:gd name="connsiteY14" fmla="*/ 114874 h 590863"/>
                  <a:gd name="connsiteX15" fmla="*/ 302247 w 378463"/>
                  <a:gd name="connsiteY15" fmla="*/ 279974 h 590863"/>
                  <a:gd name="connsiteX16" fmla="*/ 245097 w 378463"/>
                  <a:gd name="connsiteY16" fmla="*/ 368874 h 590863"/>
                  <a:gd name="connsiteX17" fmla="*/ 206997 w 378463"/>
                  <a:gd name="connsiteY17" fmla="*/ 457774 h 590863"/>
                  <a:gd name="connsiteX18" fmla="*/ 302247 w 378463"/>
                  <a:gd name="connsiteY18" fmla="*/ 368874 h 590863"/>
                  <a:gd name="connsiteX19" fmla="*/ 378447 w 378463"/>
                  <a:gd name="connsiteY19" fmla="*/ 305374 h 590863"/>
                  <a:gd name="connsiteX20" fmla="*/ 295897 w 378463"/>
                  <a:gd name="connsiteY20" fmla="*/ 438724 h 590863"/>
                  <a:gd name="connsiteX21" fmla="*/ 204549 w 378463"/>
                  <a:gd name="connsiteY21" fmla="*/ 572074 h 590863"/>
                  <a:gd name="connsiteX22" fmla="*/ 149847 w 378463"/>
                  <a:gd name="connsiteY22" fmla="*/ 578424 h 590863"/>
                  <a:gd name="connsiteX23" fmla="*/ 142680 w 378463"/>
                  <a:gd name="connsiteY23" fmla="*/ 463942 h 590863"/>
                  <a:gd name="connsiteX24" fmla="*/ 54597 w 378463"/>
                  <a:gd name="connsiteY24" fmla="*/ 349824 h 590863"/>
                  <a:gd name="connsiteX25" fmla="*/ 3797 w 378463"/>
                  <a:gd name="connsiteY25" fmla="*/ 229174 h 590863"/>
                  <a:gd name="connsiteX26" fmla="*/ 16497 w 378463"/>
                  <a:gd name="connsiteY26" fmla="*/ 203774 h 590863"/>
                  <a:gd name="connsiteX27" fmla="*/ 130797 w 378463"/>
                  <a:gd name="connsiteY27" fmla="*/ 330774 h 590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</a:cxnLst>
                <a:rect l="l" t="t" r="r" b="b"/>
                <a:pathLst>
                  <a:path w="378463" h="590863">
                    <a:moveTo>
                      <a:pt x="130797" y="330774"/>
                    </a:moveTo>
                    <a:cubicBezTo>
                      <a:pt x="139264" y="342416"/>
                      <a:pt x="71530" y="302199"/>
                      <a:pt x="67297" y="273624"/>
                    </a:cubicBezTo>
                    <a:cubicBezTo>
                      <a:pt x="63064" y="245049"/>
                      <a:pt x="96930" y="167791"/>
                      <a:pt x="105397" y="159324"/>
                    </a:cubicBezTo>
                    <a:cubicBezTo>
                      <a:pt x="113864" y="150857"/>
                      <a:pt x="109630" y="202716"/>
                      <a:pt x="118097" y="222824"/>
                    </a:cubicBezTo>
                    <a:cubicBezTo>
                      <a:pt x="126564" y="242932"/>
                      <a:pt x="153022" y="290557"/>
                      <a:pt x="156197" y="279974"/>
                    </a:cubicBezTo>
                    <a:cubicBezTo>
                      <a:pt x="159372" y="269391"/>
                      <a:pt x="135030" y="194249"/>
                      <a:pt x="137147" y="159324"/>
                    </a:cubicBezTo>
                    <a:cubicBezTo>
                      <a:pt x="139264" y="124399"/>
                      <a:pt x="162547" y="79949"/>
                      <a:pt x="168897" y="70424"/>
                    </a:cubicBezTo>
                    <a:cubicBezTo>
                      <a:pt x="175247" y="60899"/>
                      <a:pt x="171014" y="70424"/>
                      <a:pt x="175247" y="102174"/>
                    </a:cubicBezTo>
                    <a:cubicBezTo>
                      <a:pt x="179480" y="133924"/>
                      <a:pt x="187947" y="259866"/>
                      <a:pt x="194297" y="260924"/>
                    </a:cubicBezTo>
                    <a:cubicBezTo>
                      <a:pt x="200647" y="261982"/>
                      <a:pt x="215464" y="151916"/>
                      <a:pt x="213347" y="108524"/>
                    </a:cubicBezTo>
                    <a:cubicBezTo>
                      <a:pt x="211230" y="65132"/>
                      <a:pt x="174189" y="5866"/>
                      <a:pt x="181597" y="574"/>
                    </a:cubicBezTo>
                    <a:cubicBezTo>
                      <a:pt x="189005" y="-4718"/>
                      <a:pt x="250389" y="27032"/>
                      <a:pt x="257797" y="76774"/>
                    </a:cubicBezTo>
                    <a:cubicBezTo>
                      <a:pt x="265205" y="126516"/>
                      <a:pt x="221814" y="279974"/>
                      <a:pt x="226047" y="299024"/>
                    </a:cubicBezTo>
                    <a:cubicBezTo>
                      <a:pt x="230280" y="318074"/>
                      <a:pt x="273672" y="221766"/>
                      <a:pt x="283197" y="191074"/>
                    </a:cubicBezTo>
                    <a:cubicBezTo>
                      <a:pt x="292722" y="160382"/>
                      <a:pt x="280022" y="100057"/>
                      <a:pt x="283197" y="114874"/>
                    </a:cubicBezTo>
                    <a:cubicBezTo>
                      <a:pt x="286372" y="129691"/>
                      <a:pt x="308597" y="237641"/>
                      <a:pt x="302247" y="279974"/>
                    </a:cubicBezTo>
                    <a:cubicBezTo>
                      <a:pt x="295897" y="322307"/>
                      <a:pt x="260972" y="339241"/>
                      <a:pt x="245097" y="368874"/>
                    </a:cubicBezTo>
                    <a:cubicBezTo>
                      <a:pt x="229222" y="398507"/>
                      <a:pt x="197472" y="457774"/>
                      <a:pt x="206997" y="457774"/>
                    </a:cubicBezTo>
                    <a:cubicBezTo>
                      <a:pt x="216522" y="457774"/>
                      <a:pt x="273672" y="394274"/>
                      <a:pt x="302247" y="368874"/>
                    </a:cubicBezTo>
                    <a:cubicBezTo>
                      <a:pt x="330822" y="343474"/>
                      <a:pt x="379505" y="293732"/>
                      <a:pt x="378447" y="305374"/>
                    </a:cubicBezTo>
                    <a:cubicBezTo>
                      <a:pt x="377389" y="317016"/>
                      <a:pt x="324880" y="394274"/>
                      <a:pt x="295897" y="438724"/>
                    </a:cubicBezTo>
                    <a:cubicBezTo>
                      <a:pt x="266914" y="483174"/>
                      <a:pt x="228891" y="548791"/>
                      <a:pt x="204549" y="572074"/>
                    </a:cubicBezTo>
                    <a:cubicBezTo>
                      <a:pt x="180207" y="595357"/>
                      <a:pt x="160158" y="596446"/>
                      <a:pt x="149847" y="578424"/>
                    </a:cubicBezTo>
                    <a:cubicBezTo>
                      <a:pt x="139536" y="560402"/>
                      <a:pt x="158555" y="502042"/>
                      <a:pt x="142680" y="463942"/>
                    </a:cubicBezTo>
                    <a:cubicBezTo>
                      <a:pt x="126805" y="425842"/>
                      <a:pt x="77744" y="388952"/>
                      <a:pt x="54597" y="349824"/>
                    </a:cubicBezTo>
                    <a:cubicBezTo>
                      <a:pt x="31450" y="310696"/>
                      <a:pt x="10147" y="253516"/>
                      <a:pt x="3797" y="229174"/>
                    </a:cubicBezTo>
                    <a:cubicBezTo>
                      <a:pt x="-2553" y="204832"/>
                      <a:pt x="-2553" y="185782"/>
                      <a:pt x="16497" y="203774"/>
                    </a:cubicBezTo>
                    <a:cubicBezTo>
                      <a:pt x="35547" y="221766"/>
                      <a:pt x="122330" y="319132"/>
                      <a:pt x="130797" y="330774"/>
                    </a:cubicBezTo>
                    <a:close/>
                  </a:path>
                </a:pathLst>
              </a:custGeom>
              <a:solidFill>
                <a:srgbClr val="92D050"/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defTabSz="1280160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100"/>
              </a:p>
            </p:txBody>
          </p:sp>
          <p:grpSp>
            <p:nvGrpSpPr>
              <p:cNvPr id="138" name="Group 351"/>
              <p:cNvGrpSpPr>
                <a:grpSpLocks noChangeAspect="1"/>
              </p:cNvGrpSpPr>
              <p:nvPr/>
            </p:nvGrpSpPr>
            <p:grpSpPr bwMode="auto">
              <a:xfrm rot="-3608549">
                <a:off x="3764256" y="4615735"/>
                <a:ext cx="56520" cy="79773"/>
                <a:chOff x="5422842" y="6253085"/>
                <a:chExt cx="307202" cy="526063"/>
              </a:xfrm>
            </p:grpSpPr>
            <p:sp>
              <p:nvSpPr>
                <p:cNvPr id="202" name="Freeform 201"/>
                <p:cNvSpPr/>
                <p:nvPr/>
              </p:nvSpPr>
              <p:spPr bwMode="auto">
                <a:xfrm rot="2429880">
                  <a:off x="5436009" y="6216203"/>
                  <a:ext cx="353759" cy="491856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solidFill>
                  <a:srgbClr val="CCFF66"/>
                </a:solidFill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203" name="Freeform 202"/>
                <p:cNvSpPr/>
                <p:nvPr/>
              </p:nvSpPr>
              <p:spPr bwMode="auto">
                <a:xfrm rot="2429880">
                  <a:off x="5445563" y="6393104"/>
                  <a:ext cx="258846" cy="251162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solidFill>
                  <a:srgbClr val="CCFF66"/>
                </a:solidFill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39" name="Group 357"/>
              <p:cNvGrpSpPr>
                <a:grpSpLocks noChangeAspect="1"/>
              </p:cNvGrpSpPr>
              <p:nvPr/>
            </p:nvGrpSpPr>
            <p:grpSpPr bwMode="auto">
              <a:xfrm rot="-1260000">
                <a:off x="3791811" y="4554012"/>
                <a:ext cx="76924" cy="48445"/>
                <a:chOff x="5257442" y="6389464"/>
                <a:chExt cx="637995" cy="319420"/>
              </a:xfrm>
            </p:grpSpPr>
            <p:sp>
              <p:nvSpPr>
                <p:cNvPr id="200" name="Freeform 199"/>
                <p:cNvSpPr/>
                <p:nvPr/>
              </p:nvSpPr>
              <p:spPr bwMode="auto">
                <a:xfrm rot="3060000">
                  <a:off x="5405825" y="6119768"/>
                  <a:ext cx="209334" cy="684416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solidFill>
                  <a:srgbClr val="CCFF66"/>
                </a:solidFill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201" name="Freeform 200"/>
                <p:cNvSpPr/>
                <p:nvPr/>
              </p:nvSpPr>
              <p:spPr bwMode="auto">
                <a:xfrm rot="2429880">
                  <a:off x="5389298" y="6404592"/>
                  <a:ext cx="263237" cy="1884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solidFill>
                  <a:srgbClr val="CCFF66"/>
                </a:solidFill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40" name="Group 360"/>
              <p:cNvGrpSpPr>
                <a:grpSpLocks noChangeAspect="1"/>
              </p:cNvGrpSpPr>
              <p:nvPr/>
            </p:nvGrpSpPr>
            <p:grpSpPr bwMode="auto">
              <a:xfrm rot="-3540000">
                <a:off x="3773673" y="4483850"/>
                <a:ext cx="37680" cy="78349"/>
                <a:chOff x="5422842" y="6253085"/>
                <a:chExt cx="307202" cy="526063"/>
              </a:xfrm>
            </p:grpSpPr>
            <p:sp>
              <p:nvSpPr>
                <p:cNvPr id="198" name="Freeform 197"/>
                <p:cNvSpPr/>
                <p:nvPr/>
              </p:nvSpPr>
              <p:spPr bwMode="auto">
                <a:xfrm rot="2429880">
                  <a:off x="5570831" y="6134151"/>
                  <a:ext cx="323564" cy="500792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solidFill>
                  <a:srgbClr val="CCFF66"/>
                </a:solidFill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99" name="Freeform 198"/>
                <p:cNvSpPr/>
                <p:nvPr/>
              </p:nvSpPr>
              <p:spPr bwMode="auto">
                <a:xfrm rot="2429880">
                  <a:off x="5541247" y="6278798"/>
                  <a:ext cx="271795" cy="266377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solidFill>
                  <a:srgbClr val="CCFF66"/>
                </a:solidFill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41" name="Group 38"/>
              <p:cNvGrpSpPr>
                <a:grpSpLocks noChangeAspect="1"/>
              </p:cNvGrpSpPr>
              <p:nvPr/>
            </p:nvGrpSpPr>
            <p:grpSpPr bwMode="auto">
              <a:xfrm rot="18240000">
                <a:off x="3706702" y="5235180"/>
                <a:ext cx="126610" cy="146760"/>
                <a:chOff x="3899502" y="4414757"/>
                <a:chExt cx="362859" cy="599923"/>
              </a:xfrm>
              <a:solidFill>
                <a:srgbClr val="CCFF66"/>
              </a:solidFill>
            </p:grpSpPr>
            <p:sp>
              <p:nvSpPr>
                <p:cNvPr id="194" name="Freeform 193"/>
                <p:cNvSpPr/>
                <p:nvPr/>
              </p:nvSpPr>
              <p:spPr>
                <a:xfrm>
                  <a:off x="3899504" y="4414757"/>
                  <a:ext cx="362857" cy="599923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95" name="Freeform 194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96" name="Freeform 195"/>
                <p:cNvSpPr/>
                <p:nvPr/>
              </p:nvSpPr>
              <p:spPr>
                <a:xfrm>
                  <a:off x="3899502" y="4414757"/>
                  <a:ext cx="362857" cy="599923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97" name="Freeform 196"/>
                <p:cNvSpPr/>
                <p:nvPr/>
              </p:nvSpPr>
              <p:spPr>
                <a:xfrm>
                  <a:off x="3959979" y="4630057"/>
                  <a:ext cx="292704" cy="304801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42" name="Group 41"/>
              <p:cNvGrpSpPr>
                <a:grpSpLocks noChangeAspect="1"/>
              </p:cNvGrpSpPr>
              <p:nvPr/>
            </p:nvGrpSpPr>
            <p:grpSpPr bwMode="auto">
              <a:xfrm rot="1680000">
                <a:off x="3808314" y="4999920"/>
                <a:ext cx="99405" cy="158734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92" name="Freeform 191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93" name="Freeform 192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cxnSp>
            <p:nvCxnSpPr>
              <p:cNvPr id="143" name="Straight Connector 142"/>
              <p:cNvCxnSpPr/>
              <p:nvPr/>
            </p:nvCxnSpPr>
            <p:spPr bwMode="auto">
              <a:xfrm rot="20771895">
                <a:off x="3651483" y="4911625"/>
                <a:ext cx="0" cy="0"/>
              </a:xfrm>
              <a:prstGeom prst="line">
                <a:avLst/>
              </a:prstGeom>
              <a:ln w="63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44" name="Group 25"/>
              <p:cNvGrpSpPr/>
              <p:nvPr/>
            </p:nvGrpSpPr>
            <p:grpSpPr bwMode="auto">
              <a:xfrm rot="18462427">
                <a:off x="3653470" y="5678160"/>
                <a:ext cx="174956" cy="208394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90" name="Freeform 189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91" name="Freeform 190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45" name="Group 22"/>
              <p:cNvGrpSpPr/>
              <p:nvPr/>
            </p:nvGrpSpPr>
            <p:grpSpPr bwMode="auto">
              <a:xfrm rot="18280728">
                <a:off x="3634739" y="6024677"/>
                <a:ext cx="171961" cy="269796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88" name="Freeform 187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89" name="Freeform 188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46" name="Group 21"/>
              <p:cNvGrpSpPr/>
              <p:nvPr/>
            </p:nvGrpSpPr>
            <p:grpSpPr bwMode="auto">
              <a:xfrm rot="2429880">
                <a:off x="3826902" y="5826040"/>
                <a:ext cx="150714" cy="264556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86" name="Freeform 185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87" name="Freeform 186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47" name="Group 28"/>
              <p:cNvGrpSpPr>
                <a:grpSpLocks noChangeAspect="1"/>
              </p:cNvGrpSpPr>
              <p:nvPr/>
            </p:nvGrpSpPr>
            <p:grpSpPr bwMode="auto">
              <a:xfrm rot="2764909">
                <a:off x="3805294" y="5462924"/>
                <a:ext cx="139650" cy="204673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84" name="Freeform 183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85" name="Freeform 184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48" name="Group 360"/>
              <p:cNvGrpSpPr>
                <a:grpSpLocks noChangeAspect="1"/>
              </p:cNvGrpSpPr>
              <p:nvPr/>
            </p:nvGrpSpPr>
            <p:grpSpPr bwMode="auto">
              <a:xfrm rot="-600000">
                <a:off x="3807482" y="4408676"/>
                <a:ext cx="37038" cy="78052"/>
                <a:chOff x="5422842" y="6253085"/>
                <a:chExt cx="307202" cy="526063"/>
              </a:xfrm>
            </p:grpSpPr>
            <p:sp>
              <p:nvSpPr>
                <p:cNvPr id="182" name="Freeform 181"/>
                <p:cNvSpPr/>
                <p:nvPr/>
              </p:nvSpPr>
              <p:spPr bwMode="auto">
                <a:xfrm rot="2429880">
                  <a:off x="5375885" y="6209622"/>
                  <a:ext cx="276416" cy="513561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solidFill>
                  <a:srgbClr val="CCFF66"/>
                </a:solidFill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83" name="Freeform 182"/>
                <p:cNvSpPr/>
                <p:nvPr/>
              </p:nvSpPr>
              <p:spPr bwMode="auto">
                <a:xfrm rot="2429880">
                  <a:off x="5356769" y="6361265"/>
                  <a:ext cx="184275" cy="25678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solidFill>
                  <a:srgbClr val="CCFF66"/>
                </a:solidFill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49" name="Group 354"/>
              <p:cNvGrpSpPr>
                <a:grpSpLocks noChangeAspect="1"/>
              </p:cNvGrpSpPr>
              <p:nvPr/>
            </p:nvGrpSpPr>
            <p:grpSpPr bwMode="auto">
              <a:xfrm rot="-840000">
                <a:off x="3806057" y="4711460"/>
                <a:ext cx="65528" cy="138608"/>
                <a:chOff x="5422842" y="6253085"/>
                <a:chExt cx="307202" cy="526063"/>
              </a:xfrm>
            </p:grpSpPr>
            <p:sp>
              <p:nvSpPr>
                <p:cNvPr id="180" name="Freeform 179"/>
                <p:cNvSpPr/>
                <p:nvPr/>
              </p:nvSpPr>
              <p:spPr bwMode="auto">
                <a:xfrm rot="2429880">
                  <a:off x="5382383" y="6231141"/>
                  <a:ext cx="290148" cy="512116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solidFill>
                  <a:srgbClr val="CCFF66"/>
                </a:solidFill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81" name="Freeform 180"/>
                <p:cNvSpPr/>
                <p:nvPr/>
              </p:nvSpPr>
              <p:spPr bwMode="auto">
                <a:xfrm rot="2429880">
                  <a:off x="5372358" y="6387639"/>
                  <a:ext cx="238072" cy="259067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solidFill>
                  <a:srgbClr val="CCFF66"/>
                </a:solidFill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50" name="Group 41"/>
              <p:cNvGrpSpPr>
                <a:grpSpLocks noChangeAspect="1"/>
              </p:cNvGrpSpPr>
              <p:nvPr/>
            </p:nvGrpSpPr>
            <p:grpSpPr bwMode="auto">
              <a:xfrm rot="18660000">
                <a:off x="3708380" y="4844170"/>
                <a:ext cx="85036" cy="133429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78" name="Freeform 177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79" name="Freeform 178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51" name="Group 22"/>
              <p:cNvGrpSpPr/>
              <p:nvPr/>
            </p:nvGrpSpPr>
            <p:grpSpPr bwMode="auto">
              <a:xfrm rot="18280728">
                <a:off x="3591133" y="7171863"/>
                <a:ext cx="202317" cy="306416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76" name="Freeform 175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77" name="Freeform 176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52" name="Group 22"/>
              <p:cNvGrpSpPr/>
              <p:nvPr/>
            </p:nvGrpSpPr>
            <p:grpSpPr bwMode="auto">
              <a:xfrm rot="1999418">
                <a:off x="3811363" y="6500918"/>
                <a:ext cx="199211" cy="311195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74" name="Freeform 173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75" name="Freeform 174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53" name="Group 22"/>
              <p:cNvGrpSpPr/>
              <p:nvPr/>
            </p:nvGrpSpPr>
            <p:grpSpPr bwMode="auto">
              <a:xfrm rot="1999418">
                <a:off x="3820889" y="6940549"/>
                <a:ext cx="199211" cy="311195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72" name="Freeform 171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73" name="Freeform 172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54" name="Group 22"/>
              <p:cNvGrpSpPr/>
              <p:nvPr/>
            </p:nvGrpSpPr>
            <p:grpSpPr bwMode="auto">
              <a:xfrm rot="1999418">
                <a:off x="3810163" y="7370524"/>
                <a:ext cx="199211" cy="311195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70" name="Freeform 169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71" name="Freeform 170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55" name="Group 22"/>
              <p:cNvGrpSpPr/>
              <p:nvPr/>
            </p:nvGrpSpPr>
            <p:grpSpPr bwMode="auto">
              <a:xfrm rot="1999418">
                <a:off x="3847827" y="7784722"/>
                <a:ext cx="199211" cy="311195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68" name="Freeform 167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69" name="Freeform 168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56" name="Group 22"/>
              <p:cNvGrpSpPr/>
              <p:nvPr/>
            </p:nvGrpSpPr>
            <p:grpSpPr bwMode="auto">
              <a:xfrm rot="2300291">
                <a:off x="3831060" y="6152116"/>
                <a:ext cx="169320" cy="274004"/>
                <a:chOff x="3899504" y="4414762"/>
                <a:chExt cx="330200" cy="561219"/>
              </a:xfrm>
              <a:solidFill>
                <a:srgbClr val="CCFF66"/>
              </a:solidFill>
            </p:grpSpPr>
            <p:sp>
              <p:nvSpPr>
                <p:cNvPr id="166" name="Freeform 165"/>
                <p:cNvSpPr/>
                <p:nvPr/>
              </p:nvSpPr>
              <p:spPr>
                <a:xfrm>
                  <a:off x="3899504" y="4414762"/>
                  <a:ext cx="330200" cy="561219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67" name="Freeform 166"/>
                <p:cNvSpPr/>
                <p:nvPr/>
              </p:nvSpPr>
              <p:spPr>
                <a:xfrm>
                  <a:off x="3959982" y="4640764"/>
                  <a:ext cx="233829" cy="294094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57" name="Group 22"/>
              <p:cNvGrpSpPr/>
              <p:nvPr/>
            </p:nvGrpSpPr>
            <p:grpSpPr bwMode="auto">
              <a:xfrm rot="18280728">
                <a:off x="3613522" y="6370723"/>
                <a:ext cx="188968" cy="288403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64" name="Freeform 163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65" name="Freeform 164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58" name="Group 22"/>
              <p:cNvGrpSpPr/>
              <p:nvPr/>
            </p:nvGrpSpPr>
            <p:grpSpPr bwMode="auto">
              <a:xfrm rot="18280728">
                <a:off x="3608246" y="7631502"/>
                <a:ext cx="202317" cy="306416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62" name="Freeform 161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63" name="Freeform 162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159" name="Group 22"/>
              <p:cNvGrpSpPr/>
              <p:nvPr/>
            </p:nvGrpSpPr>
            <p:grpSpPr bwMode="auto">
              <a:xfrm rot="18280728">
                <a:off x="3595352" y="6802440"/>
                <a:ext cx="202317" cy="306416"/>
                <a:chOff x="3899505" y="4414762"/>
                <a:chExt cx="362857" cy="599924"/>
              </a:xfrm>
              <a:solidFill>
                <a:srgbClr val="CCFF66"/>
              </a:solidFill>
            </p:grpSpPr>
            <p:sp>
              <p:nvSpPr>
                <p:cNvPr id="160" name="Freeform 159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61" name="Freeform 160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</p:grpSp>
        <p:sp>
          <p:nvSpPr>
            <p:cNvPr id="27" name="Left Brace 26"/>
            <p:cNvSpPr/>
            <p:nvPr/>
          </p:nvSpPr>
          <p:spPr bwMode="auto">
            <a:xfrm>
              <a:off x="4254380" y="4964613"/>
              <a:ext cx="287243" cy="929435"/>
            </a:xfrm>
            <a:prstGeom prst="leftBrace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cxnSp>
          <p:nvCxnSpPr>
            <p:cNvPr id="28" name="Straight Connector 27"/>
            <p:cNvCxnSpPr/>
            <p:nvPr/>
          </p:nvCxnSpPr>
          <p:spPr bwMode="auto">
            <a:xfrm>
              <a:off x="3044639" y="5418821"/>
              <a:ext cx="1066280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Left Brace 28"/>
            <p:cNvSpPr/>
            <p:nvPr/>
          </p:nvSpPr>
          <p:spPr bwMode="auto">
            <a:xfrm>
              <a:off x="2043239" y="4048990"/>
              <a:ext cx="294185" cy="828916"/>
            </a:xfrm>
            <a:prstGeom prst="leftBrace">
              <a:avLst/>
            </a:prstGeom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sp>
          <p:nvSpPr>
            <p:cNvPr id="30" name="Left Brace 29"/>
            <p:cNvSpPr/>
            <p:nvPr/>
          </p:nvSpPr>
          <p:spPr bwMode="auto">
            <a:xfrm>
              <a:off x="2043239" y="3118853"/>
              <a:ext cx="284341" cy="846399"/>
            </a:xfrm>
            <a:prstGeom prst="leftBrace">
              <a:avLst>
                <a:gd name="adj1" fmla="val 8333"/>
                <a:gd name="adj2" fmla="val 42633"/>
              </a:avLst>
            </a:prstGeom>
            <a:ln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sp>
          <p:nvSpPr>
            <p:cNvPr id="31" name="Left Brace 30"/>
            <p:cNvSpPr/>
            <p:nvPr/>
          </p:nvSpPr>
          <p:spPr bwMode="auto">
            <a:xfrm>
              <a:off x="2043239" y="2630827"/>
              <a:ext cx="295948" cy="458890"/>
            </a:xfrm>
            <a:prstGeom prst="leftBrace">
              <a:avLst>
                <a:gd name="adj1" fmla="val 8333"/>
                <a:gd name="adj2" fmla="val 44223"/>
              </a:avLst>
            </a:prstGeom>
            <a:ln>
              <a:solidFill>
                <a:schemeClr val="accent1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sp>
          <p:nvSpPr>
            <p:cNvPr id="32" name="Left Brace 31"/>
            <p:cNvSpPr/>
            <p:nvPr/>
          </p:nvSpPr>
          <p:spPr bwMode="auto">
            <a:xfrm>
              <a:off x="2043239" y="2525938"/>
              <a:ext cx="294185" cy="43704"/>
            </a:xfrm>
            <a:prstGeom prst="leftBrace">
              <a:avLst>
                <a:gd name="adj1" fmla="val 8333"/>
                <a:gd name="adj2" fmla="val 39946"/>
              </a:avLst>
            </a:prstGeom>
            <a:ln>
              <a:solidFill>
                <a:srgbClr val="D2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defTabSz="1280160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100"/>
            </a:p>
          </p:txBody>
        </p:sp>
        <p:sp>
          <p:nvSpPr>
            <p:cNvPr id="33" name="TextBox 668"/>
            <p:cNvSpPr txBox="1">
              <a:spLocks noChangeArrowheads="1"/>
            </p:cNvSpPr>
            <p:nvPr/>
          </p:nvSpPr>
          <p:spPr bwMode="auto">
            <a:xfrm>
              <a:off x="1603474" y="2351073"/>
              <a:ext cx="340961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279525" eaLnBrk="0" fontAlgn="base" hangingPunct="0">
                <a:spcBef>
                  <a:spcPct val="0"/>
                </a:spcBef>
                <a:spcAft>
                  <a:spcPct val="0"/>
                </a:spcAft>
                <a:defRPr sz="25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nb-NO" altLang="en-US" sz="1100" dirty="0"/>
                <a:t>0.</a:t>
              </a:r>
              <a:endParaRPr lang="en-US" altLang="en-US" sz="1100" dirty="0"/>
            </a:p>
          </p:txBody>
        </p:sp>
        <p:grpSp>
          <p:nvGrpSpPr>
            <p:cNvPr id="34" name="Group 3"/>
            <p:cNvGrpSpPr>
              <a:grpSpLocks/>
            </p:cNvGrpSpPr>
            <p:nvPr/>
          </p:nvGrpSpPr>
          <p:grpSpPr bwMode="auto">
            <a:xfrm>
              <a:off x="4684086" y="741363"/>
              <a:ext cx="605047" cy="5638015"/>
              <a:chOff x="6014748" y="2317750"/>
              <a:chExt cx="661857" cy="6143625"/>
            </a:xfrm>
          </p:grpSpPr>
          <p:sp>
            <p:nvSpPr>
              <p:cNvPr id="40" name="Freeform 39"/>
              <p:cNvSpPr/>
              <p:nvPr/>
            </p:nvSpPr>
            <p:spPr bwMode="auto">
              <a:xfrm>
                <a:off x="6295316" y="2487606"/>
                <a:ext cx="169802" cy="5973533"/>
              </a:xfrm>
              <a:custGeom>
                <a:avLst/>
                <a:gdLst>
                  <a:gd name="connsiteX0" fmla="*/ 226094 w 537484"/>
                  <a:gd name="connsiteY0" fmla="*/ 386839 h 8967583"/>
                  <a:gd name="connsiteX1" fmla="*/ 400265 w 537484"/>
                  <a:gd name="connsiteY1" fmla="*/ 5815182 h 8967583"/>
                  <a:gd name="connsiteX2" fmla="*/ 443808 w 537484"/>
                  <a:gd name="connsiteY2" fmla="*/ 8166496 h 8967583"/>
                  <a:gd name="connsiteX3" fmla="*/ 458322 w 537484"/>
                  <a:gd name="connsiteY3" fmla="*/ 8587411 h 8967583"/>
                  <a:gd name="connsiteX4" fmla="*/ 458322 w 537484"/>
                  <a:gd name="connsiteY4" fmla="*/ 8921239 h 8967583"/>
                  <a:gd name="connsiteX5" fmla="*/ 516379 w 537484"/>
                  <a:gd name="connsiteY5" fmla="*/ 8935753 h 8967583"/>
                  <a:gd name="connsiteX6" fmla="*/ 51922 w 537484"/>
                  <a:gd name="connsiteY6" fmla="*/ 8935753 h 8967583"/>
                  <a:gd name="connsiteX7" fmla="*/ 8379 w 537484"/>
                  <a:gd name="connsiteY7" fmla="*/ 8921239 h 8967583"/>
                  <a:gd name="connsiteX8" fmla="*/ 8379 w 537484"/>
                  <a:gd name="connsiteY8" fmla="*/ 8601925 h 8967583"/>
                  <a:gd name="connsiteX9" fmla="*/ 95465 w 537484"/>
                  <a:gd name="connsiteY9" fmla="*/ 5292668 h 8967583"/>
                  <a:gd name="connsiteX10" fmla="*/ 197065 w 537484"/>
                  <a:gd name="connsiteY10" fmla="*/ 1039982 h 8967583"/>
                  <a:gd name="connsiteX11" fmla="*/ 168036 w 537484"/>
                  <a:gd name="connsiteY11" fmla="*/ 459411 h 8967583"/>
                  <a:gd name="connsiteX12" fmla="*/ 255122 w 537484"/>
                  <a:gd name="connsiteY12" fmla="*/ 444896 h 8967583"/>
                  <a:gd name="connsiteX13" fmla="*/ 226094 w 537484"/>
                  <a:gd name="connsiteY13" fmla="*/ 386839 h 8967583"/>
                  <a:gd name="connsiteX0" fmla="*/ 568994 w 571319"/>
                  <a:gd name="connsiteY0" fmla="*/ 405698 h 8895955"/>
                  <a:gd name="connsiteX1" fmla="*/ 400265 w 571319"/>
                  <a:gd name="connsiteY1" fmla="*/ 5743554 h 8895955"/>
                  <a:gd name="connsiteX2" fmla="*/ 443808 w 571319"/>
                  <a:gd name="connsiteY2" fmla="*/ 8094868 h 8895955"/>
                  <a:gd name="connsiteX3" fmla="*/ 458322 w 571319"/>
                  <a:gd name="connsiteY3" fmla="*/ 8515783 h 8895955"/>
                  <a:gd name="connsiteX4" fmla="*/ 458322 w 571319"/>
                  <a:gd name="connsiteY4" fmla="*/ 8849611 h 8895955"/>
                  <a:gd name="connsiteX5" fmla="*/ 516379 w 571319"/>
                  <a:gd name="connsiteY5" fmla="*/ 8864125 h 8895955"/>
                  <a:gd name="connsiteX6" fmla="*/ 51922 w 571319"/>
                  <a:gd name="connsiteY6" fmla="*/ 8864125 h 8895955"/>
                  <a:gd name="connsiteX7" fmla="*/ 8379 w 571319"/>
                  <a:gd name="connsiteY7" fmla="*/ 8849611 h 8895955"/>
                  <a:gd name="connsiteX8" fmla="*/ 8379 w 571319"/>
                  <a:gd name="connsiteY8" fmla="*/ 8530297 h 8895955"/>
                  <a:gd name="connsiteX9" fmla="*/ 95465 w 571319"/>
                  <a:gd name="connsiteY9" fmla="*/ 5221040 h 8895955"/>
                  <a:gd name="connsiteX10" fmla="*/ 197065 w 571319"/>
                  <a:gd name="connsiteY10" fmla="*/ 968354 h 8895955"/>
                  <a:gd name="connsiteX11" fmla="*/ 168036 w 571319"/>
                  <a:gd name="connsiteY11" fmla="*/ 387783 h 8895955"/>
                  <a:gd name="connsiteX12" fmla="*/ 255122 w 571319"/>
                  <a:gd name="connsiteY12" fmla="*/ 373268 h 8895955"/>
                  <a:gd name="connsiteX13" fmla="*/ 568994 w 571319"/>
                  <a:gd name="connsiteY13" fmla="*/ 405698 h 8895955"/>
                  <a:gd name="connsiteX0" fmla="*/ 568994 w 571887"/>
                  <a:gd name="connsiteY0" fmla="*/ 472076 h 8962333"/>
                  <a:gd name="connsiteX1" fmla="*/ 400265 w 571887"/>
                  <a:gd name="connsiteY1" fmla="*/ 5809932 h 8962333"/>
                  <a:gd name="connsiteX2" fmla="*/ 443808 w 571887"/>
                  <a:gd name="connsiteY2" fmla="*/ 8161246 h 8962333"/>
                  <a:gd name="connsiteX3" fmla="*/ 458322 w 571887"/>
                  <a:gd name="connsiteY3" fmla="*/ 8582161 h 8962333"/>
                  <a:gd name="connsiteX4" fmla="*/ 458322 w 571887"/>
                  <a:gd name="connsiteY4" fmla="*/ 8915989 h 8962333"/>
                  <a:gd name="connsiteX5" fmla="*/ 516379 w 571887"/>
                  <a:gd name="connsiteY5" fmla="*/ 8930503 h 8962333"/>
                  <a:gd name="connsiteX6" fmla="*/ 51922 w 571887"/>
                  <a:gd name="connsiteY6" fmla="*/ 8930503 h 8962333"/>
                  <a:gd name="connsiteX7" fmla="*/ 8379 w 571887"/>
                  <a:gd name="connsiteY7" fmla="*/ 8915989 h 8962333"/>
                  <a:gd name="connsiteX8" fmla="*/ 8379 w 571887"/>
                  <a:gd name="connsiteY8" fmla="*/ 8596675 h 8962333"/>
                  <a:gd name="connsiteX9" fmla="*/ 95465 w 571887"/>
                  <a:gd name="connsiteY9" fmla="*/ 5287418 h 8962333"/>
                  <a:gd name="connsiteX10" fmla="*/ 197065 w 571887"/>
                  <a:gd name="connsiteY10" fmla="*/ 1034732 h 8962333"/>
                  <a:gd name="connsiteX11" fmla="*/ 168036 w 571887"/>
                  <a:gd name="connsiteY11" fmla="*/ 454161 h 8962333"/>
                  <a:gd name="connsiteX12" fmla="*/ 236072 w 571887"/>
                  <a:gd name="connsiteY12" fmla="*/ 263433 h 8962333"/>
                  <a:gd name="connsiteX13" fmla="*/ 568994 w 571887"/>
                  <a:gd name="connsiteY13" fmla="*/ 472076 h 8962333"/>
                  <a:gd name="connsiteX0" fmla="*/ 568994 w 571887"/>
                  <a:gd name="connsiteY0" fmla="*/ 472076 h 8962333"/>
                  <a:gd name="connsiteX1" fmla="*/ 400265 w 571887"/>
                  <a:gd name="connsiteY1" fmla="*/ 5809932 h 8962333"/>
                  <a:gd name="connsiteX2" fmla="*/ 443808 w 571887"/>
                  <a:gd name="connsiteY2" fmla="*/ 8161246 h 8962333"/>
                  <a:gd name="connsiteX3" fmla="*/ 458322 w 571887"/>
                  <a:gd name="connsiteY3" fmla="*/ 8582161 h 8962333"/>
                  <a:gd name="connsiteX4" fmla="*/ 458322 w 571887"/>
                  <a:gd name="connsiteY4" fmla="*/ 8915989 h 8962333"/>
                  <a:gd name="connsiteX5" fmla="*/ 516379 w 571887"/>
                  <a:gd name="connsiteY5" fmla="*/ 8930503 h 8962333"/>
                  <a:gd name="connsiteX6" fmla="*/ 51922 w 571887"/>
                  <a:gd name="connsiteY6" fmla="*/ 8930503 h 8962333"/>
                  <a:gd name="connsiteX7" fmla="*/ 8379 w 571887"/>
                  <a:gd name="connsiteY7" fmla="*/ 8915989 h 8962333"/>
                  <a:gd name="connsiteX8" fmla="*/ 8379 w 571887"/>
                  <a:gd name="connsiteY8" fmla="*/ 8596675 h 8962333"/>
                  <a:gd name="connsiteX9" fmla="*/ 95465 w 571887"/>
                  <a:gd name="connsiteY9" fmla="*/ 5287418 h 8962333"/>
                  <a:gd name="connsiteX10" fmla="*/ 197065 w 571887"/>
                  <a:gd name="connsiteY10" fmla="*/ 1034732 h 8962333"/>
                  <a:gd name="connsiteX11" fmla="*/ 206136 w 571887"/>
                  <a:gd name="connsiteY11" fmla="*/ 454161 h 8962333"/>
                  <a:gd name="connsiteX12" fmla="*/ 236072 w 571887"/>
                  <a:gd name="connsiteY12" fmla="*/ 263433 h 8962333"/>
                  <a:gd name="connsiteX13" fmla="*/ 568994 w 571887"/>
                  <a:gd name="connsiteY13" fmla="*/ 472076 h 8962333"/>
                  <a:gd name="connsiteX0" fmla="*/ 568994 w 572188"/>
                  <a:gd name="connsiteY0" fmla="*/ 436477 h 8926734"/>
                  <a:gd name="connsiteX1" fmla="*/ 400265 w 572188"/>
                  <a:gd name="connsiteY1" fmla="*/ 5774333 h 8926734"/>
                  <a:gd name="connsiteX2" fmla="*/ 443808 w 572188"/>
                  <a:gd name="connsiteY2" fmla="*/ 8125647 h 8926734"/>
                  <a:gd name="connsiteX3" fmla="*/ 458322 w 572188"/>
                  <a:gd name="connsiteY3" fmla="*/ 8546562 h 8926734"/>
                  <a:gd name="connsiteX4" fmla="*/ 458322 w 572188"/>
                  <a:gd name="connsiteY4" fmla="*/ 8880390 h 8926734"/>
                  <a:gd name="connsiteX5" fmla="*/ 516379 w 572188"/>
                  <a:gd name="connsiteY5" fmla="*/ 8894904 h 8926734"/>
                  <a:gd name="connsiteX6" fmla="*/ 51922 w 572188"/>
                  <a:gd name="connsiteY6" fmla="*/ 8894904 h 8926734"/>
                  <a:gd name="connsiteX7" fmla="*/ 8379 w 572188"/>
                  <a:gd name="connsiteY7" fmla="*/ 8880390 h 8926734"/>
                  <a:gd name="connsiteX8" fmla="*/ 8379 w 572188"/>
                  <a:gd name="connsiteY8" fmla="*/ 8561076 h 8926734"/>
                  <a:gd name="connsiteX9" fmla="*/ 95465 w 572188"/>
                  <a:gd name="connsiteY9" fmla="*/ 5251819 h 8926734"/>
                  <a:gd name="connsiteX10" fmla="*/ 197065 w 572188"/>
                  <a:gd name="connsiteY10" fmla="*/ 999133 h 8926734"/>
                  <a:gd name="connsiteX11" fmla="*/ 206136 w 572188"/>
                  <a:gd name="connsiteY11" fmla="*/ 418562 h 8926734"/>
                  <a:gd name="connsiteX12" fmla="*/ 226547 w 572188"/>
                  <a:gd name="connsiteY12" fmla="*/ 318321 h 8926734"/>
                  <a:gd name="connsiteX13" fmla="*/ 568994 w 572188"/>
                  <a:gd name="connsiteY13" fmla="*/ 436477 h 8926734"/>
                  <a:gd name="connsiteX0" fmla="*/ 568994 w 570582"/>
                  <a:gd name="connsiteY0" fmla="*/ 363376 h 8853633"/>
                  <a:gd name="connsiteX1" fmla="*/ 400265 w 570582"/>
                  <a:gd name="connsiteY1" fmla="*/ 5701232 h 8853633"/>
                  <a:gd name="connsiteX2" fmla="*/ 443808 w 570582"/>
                  <a:gd name="connsiteY2" fmla="*/ 8052546 h 8853633"/>
                  <a:gd name="connsiteX3" fmla="*/ 458322 w 570582"/>
                  <a:gd name="connsiteY3" fmla="*/ 8473461 h 8853633"/>
                  <a:gd name="connsiteX4" fmla="*/ 458322 w 570582"/>
                  <a:gd name="connsiteY4" fmla="*/ 8807289 h 8853633"/>
                  <a:gd name="connsiteX5" fmla="*/ 516379 w 570582"/>
                  <a:gd name="connsiteY5" fmla="*/ 8821803 h 8853633"/>
                  <a:gd name="connsiteX6" fmla="*/ 51922 w 570582"/>
                  <a:gd name="connsiteY6" fmla="*/ 8821803 h 8853633"/>
                  <a:gd name="connsiteX7" fmla="*/ 8379 w 570582"/>
                  <a:gd name="connsiteY7" fmla="*/ 8807289 h 8853633"/>
                  <a:gd name="connsiteX8" fmla="*/ 8379 w 570582"/>
                  <a:gd name="connsiteY8" fmla="*/ 8487975 h 8853633"/>
                  <a:gd name="connsiteX9" fmla="*/ 95465 w 570582"/>
                  <a:gd name="connsiteY9" fmla="*/ 5178718 h 8853633"/>
                  <a:gd name="connsiteX10" fmla="*/ 197065 w 570582"/>
                  <a:gd name="connsiteY10" fmla="*/ 926032 h 8853633"/>
                  <a:gd name="connsiteX11" fmla="*/ 206136 w 570582"/>
                  <a:gd name="connsiteY11" fmla="*/ 345461 h 8853633"/>
                  <a:gd name="connsiteX12" fmla="*/ 226547 w 570582"/>
                  <a:gd name="connsiteY12" fmla="*/ 245220 h 8853633"/>
                  <a:gd name="connsiteX13" fmla="*/ 282789 w 570582"/>
                  <a:gd name="connsiteY13" fmla="*/ 451369 h 8853633"/>
                  <a:gd name="connsiteX14" fmla="*/ 568994 w 570582"/>
                  <a:gd name="connsiteY14" fmla="*/ 363376 h 8853633"/>
                  <a:gd name="connsiteX0" fmla="*/ 288007 w 537484"/>
                  <a:gd name="connsiteY0" fmla="*/ 1071799 h 8614318"/>
                  <a:gd name="connsiteX1" fmla="*/ 400265 w 537484"/>
                  <a:gd name="connsiteY1" fmla="*/ 5461917 h 8614318"/>
                  <a:gd name="connsiteX2" fmla="*/ 443808 w 537484"/>
                  <a:gd name="connsiteY2" fmla="*/ 7813231 h 8614318"/>
                  <a:gd name="connsiteX3" fmla="*/ 458322 w 537484"/>
                  <a:gd name="connsiteY3" fmla="*/ 8234146 h 8614318"/>
                  <a:gd name="connsiteX4" fmla="*/ 458322 w 537484"/>
                  <a:gd name="connsiteY4" fmla="*/ 8567974 h 8614318"/>
                  <a:gd name="connsiteX5" fmla="*/ 516379 w 537484"/>
                  <a:gd name="connsiteY5" fmla="*/ 8582488 h 8614318"/>
                  <a:gd name="connsiteX6" fmla="*/ 51922 w 537484"/>
                  <a:gd name="connsiteY6" fmla="*/ 8582488 h 8614318"/>
                  <a:gd name="connsiteX7" fmla="*/ 8379 w 537484"/>
                  <a:gd name="connsiteY7" fmla="*/ 8567974 h 8614318"/>
                  <a:gd name="connsiteX8" fmla="*/ 8379 w 537484"/>
                  <a:gd name="connsiteY8" fmla="*/ 8248660 h 8614318"/>
                  <a:gd name="connsiteX9" fmla="*/ 95465 w 537484"/>
                  <a:gd name="connsiteY9" fmla="*/ 4939403 h 8614318"/>
                  <a:gd name="connsiteX10" fmla="*/ 197065 w 537484"/>
                  <a:gd name="connsiteY10" fmla="*/ 686717 h 8614318"/>
                  <a:gd name="connsiteX11" fmla="*/ 206136 w 537484"/>
                  <a:gd name="connsiteY11" fmla="*/ 106146 h 8614318"/>
                  <a:gd name="connsiteX12" fmla="*/ 226547 w 537484"/>
                  <a:gd name="connsiteY12" fmla="*/ 5905 h 8614318"/>
                  <a:gd name="connsiteX13" fmla="*/ 282789 w 537484"/>
                  <a:gd name="connsiteY13" fmla="*/ 212054 h 8614318"/>
                  <a:gd name="connsiteX14" fmla="*/ 288007 w 537484"/>
                  <a:gd name="connsiteY14" fmla="*/ 1071799 h 8614318"/>
                  <a:gd name="connsiteX0" fmla="*/ 288007 w 537484"/>
                  <a:gd name="connsiteY0" fmla="*/ 1098859 h 8641378"/>
                  <a:gd name="connsiteX1" fmla="*/ 400265 w 537484"/>
                  <a:gd name="connsiteY1" fmla="*/ 5488977 h 8641378"/>
                  <a:gd name="connsiteX2" fmla="*/ 443808 w 537484"/>
                  <a:gd name="connsiteY2" fmla="*/ 7840291 h 8641378"/>
                  <a:gd name="connsiteX3" fmla="*/ 458322 w 537484"/>
                  <a:gd name="connsiteY3" fmla="*/ 8261206 h 8641378"/>
                  <a:gd name="connsiteX4" fmla="*/ 458322 w 537484"/>
                  <a:gd name="connsiteY4" fmla="*/ 8595034 h 8641378"/>
                  <a:gd name="connsiteX5" fmla="*/ 516379 w 537484"/>
                  <a:gd name="connsiteY5" fmla="*/ 8609548 h 8641378"/>
                  <a:gd name="connsiteX6" fmla="*/ 51922 w 537484"/>
                  <a:gd name="connsiteY6" fmla="*/ 8609548 h 8641378"/>
                  <a:gd name="connsiteX7" fmla="*/ 8379 w 537484"/>
                  <a:gd name="connsiteY7" fmla="*/ 8595034 h 8641378"/>
                  <a:gd name="connsiteX8" fmla="*/ 8379 w 537484"/>
                  <a:gd name="connsiteY8" fmla="*/ 8275720 h 8641378"/>
                  <a:gd name="connsiteX9" fmla="*/ 95465 w 537484"/>
                  <a:gd name="connsiteY9" fmla="*/ 4966463 h 8641378"/>
                  <a:gd name="connsiteX10" fmla="*/ 197065 w 537484"/>
                  <a:gd name="connsiteY10" fmla="*/ 713777 h 8641378"/>
                  <a:gd name="connsiteX11" fmla="*/ 206136 w 537484"/>
                  <a:gd name="connsiteY11" fmla="*/ 133206 h 8641378"/>
                  <a:gd name="connsiteX12" fmla="*/ 226547 w 537484"/>
                  <a:gd name="connsiteY12" fmla="*/ 32965 h 8641378"/>
                  <a:gd name="connsiteX13" fmla="*/ 297077 w 537484"/>
                  <a:gd name="connsiteY13" fmla="*/ 620114 h 8641378"/>
                  <a:gd name="connsiteX14" fmla="*/ 288007 w 537484"/>
                  <a:gd name="connsiteY14" fmla="*/ 1098859 h 8641378"/>
                  <a:gd name="connsiteX0" fmla="*/ 288007 w 537484"/>
                  <a:gd name="connsiteY0" fmla="*/ 1098859 h 8641378"/>
                  <a:gd name="connsiteX1" fmla="*/ 400265 w 537484"/>
                  <a:gd name="connsiteY1" fmla="*/ 5488977 h 8641378"/>
                  <a:gd name="connsiteX2" fmla="*/ 443808 w 537484"/>
                  <a:gd name="connsiteY2" fmla="*/ 7840291 h 8641378"/>
                  <a:gd name="connsiteX3" fmla="*/ 458322 w 537484"/>
                  <a:gd name="connsiteY3" fmla="*/ 8261206 h 8641378"/>
                  <a:gd name="connsiteX4" fmla="*/ 458322 w 537484"/>
                  <a:gd name="connsiteY4" fmla="*/ 8595034 h 8641378"/>
                  <a:gd name="connsiteX5" fmla="*/ 516379 w 537484"/>
                  <a:gd name="connsiteY5" fmla="*/ 8609548 h 8641378"/>
                  <a:gd name="connsiteX6" fmla="*/ 51922 w 537484"/>
                  <a:gd name="connsiteY6" fmla="*/ 8609548 h 8641378"/>
                  <a:gd name="connsiteX7" fmla="*/ 8379 w 537484"/>
                  <a:gd name="connsiteY7" fmla="*/ 8595034 h 8641378"/>
                  <a:gd name="connsiteX8" fmla="*/ 8379 w 537484"/>
                  <a:gd name="connsiteY8" fmla="*/ 8275720 h 8641378"/>
                  <a:gd name="connsiteX9" fmla="*/ 95465 w 537484"/>
                  <a:gd name="connsiteY9" fmla="*/ 4966463 h 8641378"/>
                  <a:gd name="connsiteX10" fmla="*/ 197065 w 537484"/>
                  <a:gd name="connsiteY10" fmla="*/ 713777 h 8641378"/>
                  <a:gd name="connsiteX11" fmla="*/ 206136 w 537484"/>
                  <a:gd name="connsiteY11" fmla="*/ 133206 h 8641378"/>
                  <a:gd name="connsiteX12" fmla="*/ 226547 w 537484"/>
                  <a:gd name="connsiteY12" fmla="*/ 32965 h 8641378"/>
                  <a:gd name="connsiteX13" fmla="*/ 297077 w 537484"/>
                  <a:gd name="connsiteY13" fmla="*/ 620114 h 8641378"/>
                  <a:gd name="connsiteX14" fmla="*/ 288007 w 537484"/>
                  <a:gd name="connsiteY14" fmla="*/ 1098859 h 8641378"/>
                  <a:gd name="connsiteX0" fmla="*/ 288007 w 537484"/>
                  <a:gd name="connsiteY0" fmla="*/ 1099206 h 8641725"/>
                  <a:gd name="connsiteX1" fmla="*/ 400265 w 537484"/>
                  <a:gd name="connsiteY1" fmla="*/ 5489324 h 8641725"/>
                  <a:gd name="connsiteX2" fmla="*/ 443808 w 537484"/>
                  <a:gd name="connsiteY2" fmla="*/ 7840638 h 8641725"/>
                  <a:gd name="connsiteX3" fmla="*/ 458322 w 537484"/>
                  <a:gd name="connsiteY3" fmla="*/ 8261553 h 8641725"/>
                  <a:gd name="connsiteX4" fmla="*/ 458322 w 537484"/>
                  <a:gd name="connsiteY4" fmla="*/ 8595381 h 8641725"/>
                  <a:gd name="connsiteX5" fmla="*/ 516379 w 537484"/>
                  <a:gd name="connsiteY5" fmla="*/ 8609895 h 8641725"/>
                  <a:gd name="connsiteX6" fmla="*/ 51922 w 537484"/>
                  <a:gd name="connsiteY6" fmla="*/ 8609895 h 8641725"/>
                  <a:gd name="connsiteX7" fmla="*/ 8379 w 537484"/>
                  <a:gd name="connsiteY7" fmla="*/ 8595381 h 8641725"/>
                  <a:gd name="connsiteX8" fmla="*/ 8379 w 537484"/>
                  <a:gd name="connsiteY8" fmla="*/ 8276067 h 8641725"/>
                  <a:gd name="connsiteX9" fmla="*/ 95465 w 537484"/>
                  <a:gd name="connsiteY9" fmla="*/ 4966810 h 8641725"/>
                  <a:gd name="connsiteX10" fmla="*/ 197065 w 537484"/>
                  <a:gd name="connsiteY10" fmla="*/ 714124 h 8641725"/>
                  <a:gd name="connsiteX11" fmla="*/ 206136 w 537484"/>
                  <a:gd name="connsiteY11" fmla="*/ 133553 h 8641725"/>
                  <a:gd name="connsiteX12" fmla="*/ 226547 w 537484"/>
                  <a:gd name="connsiteY12" fmla="*/ 33312 h 8641725"/>
                  <a:gd name="connsiteX13" fmla="*/ 282789 w 537484"/>
                  <a:gd name="connsiteY13" fmla="*/ 625224 h 8641725"/>
                  <a:gd name="connsiteX14" fmla="*/ 288007 w 537484"/>
                  <a:gd name="connsiteY14" fmla="*/ 1099206 h 8641725"/>
                  <a:gd name="connsiteX0" fmla="*/ 288007 w 537484"/>
                  <a:gd name="connsiteY0" fmla="*/ 1099206 h 8641725"/>
                  <a:gd name="connsiteX1" fmla="*/ 400265 w 537484"/>
                  <a:gd name="connsiteY1" fmla="*/ 5489324 h 8641725"/>
                  <a:gd name="connsiteX2" fmla="*/ 443808 w 537484"/>
                  <a:gd name="connsiteY2" fmla="*/ 7840638 h 8641725"/>
                  <a:gd name="connsiteX3" fmla="*/ 458322 w 537484"/>
                  <a:gd name="connsiteY3" fmla="*/ 8261553 h 8641725"/>
                  <a:gd name="connsiteX4" fmla="*/ 458322 w 537484"/>
                  <a:gd name="connsiteY4" fmla="*/ 8595381 h 8641725"/>
                  <a:gd name="connsiteX5" fmla="*/ 516379 w 537484"/>
                  <a:gd name="connsiteY5" fmla="*/ 8609895 h 8641725"/>
                  <a:gd name="connsiteX6" fmla="*/ 51922 w 537484"/>
                  <a:gd name="connsiteY6" fmla="*/ 8609895 h 8641725"/>
                  <a:gd name="connsiteX7" fmla="*/ 8379 w 537484"/>
                  <a:gd name="connsiteY7" fmla="*/ 8595381 h 8641725"/>
                  <a:gd name="connsiteX8" fmla="*/ 8379 w 537484"/>
                  <a:gd name="connsiteY8" fmla="*/ 8276067 h 8641725"/>
                  <a:gd name="connsiteX9" fmla="*/ 95465 w 537484"/>
                  <a:gd name="connsiteY9" fmla="*/ 4966810 h 8641725"/>
                  <a:gd name="connsiteX10" fmla="*/ 197065 w 537484"/>
                  <a:gd name="connsiteY10" fmla="*/ 714124 h 8641725"/>
                  <a:gd name="connsiteX11" fmla="*/ 206136 w 537484"/>
                  <a:gd name="connsiteY11" fmla="*/ 133553 h 8641725"/>
                  <a:gd name="connsiteX12" fmla="*/ 226547 w 537484"/>
                  <a:gd name="connsiteY12" fmla="*/ 33312 h 8641725"/>
                  <a:gd name="connsiteX13" fmla="*/ 282789 w 537484"/>
                  <a:gd name="connsiteY13" fmla="*/ 625224 h 8641725"/>
                  <a:gd name="connsiteX14" fmla="*/ 288007 w 537484"/>
                  <a:gd name="connsiteY14" fmla="*/ 1099206 h 8641725"/>
                  <a:gd name="connsiteX0" fmla="*/ 288007 w 537484"/>
                  <a:gd name="connsiteY0" fmla="*/ 1097820 h 8640339"/>
                  <a:gd name="connsiteX1" fmla="*/ 400265 w 537484"/>
                  <a:gd name="connsiteY1" fmla="*/ 5487938 h 8640339"/>
                  <a:gd name="connsiteX2" fmla="*/ 443808 w 537484"/>
                  <a:gd name="connsiteY2" fmla="*/ 7839252 h 8640339"/>
                  <a:gd name="connsiteX3" fmla="*/ 458322 w 537484"/>
                  <a:gd name="connsiteY3" fmla="*/ 8260167 h 8640339"/>
                  <a:gd name="connsiteX4" fmla="*/ 458322 w 537484"/>
                  <a:gd name="connsiteY4" fmla="*/ 8593995 h 8640339"/>
                  <a:gd name="connsiteX5" fmla="*/ 516379 w 537484"/>
                  <a:gd name="connsiteY5" fmla="*/ 8608509 h 8640339"/>
                  <a:gd name="connsiteX6" fmla="*/ 51922 w 537484"/>
                  <a:gd name="connsiteY6" fmla="*/ 8608509 h 8640339"/>
                  <a:gd name="connsiteX7" fmla="*/ 8379 w 537484"/>
                  <a:gd name="connsiteY7" fmla="*/ 8593995 h 8640339"/>
                  <a:gd name="connsiteX8" fmla="*/ 8379 w 537484"/>
                  <a:gd name="connsiteY8" fmla="*/ 8274681 h 8640339"/>
                  <a:gd name="connsiteX9" fmla="*/ 95465 w 537484"/>
                  <a:gd name="connsiteY9" fmla="*/ 4965424 h 8640339"/>
                  <a:gd name="connsiteX10" fmla="*/ 197065 w 537484"/>
                  <a:gd name="connsiteY10" fmla="*/ 712738 h 8640339"/>
                  <a:gd name="connsiteX11" fmla="*/ 206136 w 537484"/>
                  <a:gd name="connsiteY11" fmla="*/ 132167 h 8640339"/>
                  <a:gd name="connsiteX12" fmla="*/ 226547 w 537484"/>
                  <a:gd name="connsiteY12" fmla="*/ 31926 h 8640339"/>
                  <a:gd name="connsiteX13" fmla="*/ 263739 w 537484"/>
                  <a:gd name="connsiteY13" fmla="*/ 604788 h 8640339"/>
                  <a:gd name="connsiteX14" fmla="*/ 288007 w 537484"/>
                  <a:gd name="connsiteY14" fmla="*/ 1097820 h 8640339"/>
                  <a:gd name="connsiteX0" fmla="*/ 288007 w 537484"/>
                  <a:gd name="connsiteY0" fmla="*/ 1097820 h 8640339"/>
                  <a:gd name="connsiteX1" fmla="*/ 400265 w 537484"/>
                  <a:gd name="connsiteY1" fmla="*/ 5487938 h 8640339"/>
                  <a:gd name="connsiteX2" fmla="*/ 443808 w 537484"/>
                  <a:gd name="connsiteY2" fmla="*/ 7839252 h 8640339"/>
                  <a:gd name="connsiteX3" fmla="*/ 458322 w 537484"/>
                  <a:gd name="connsiteY3" fmla="*/ 8260167 h 8640339"/>
                  <a:gd name="connsiteX4" fmla="*/ 458322 w 537484"/>
                  <a:gd name="connsiteY4" fmla="*/ 8593995 h 8640339"/>
                  <a:gd name="connsiteX5" fmla="*/ 516379 w 537484"/>
                  <a:gd name="connsiteY5" fmla="*/ 8608509 h 8640339"/>
                  <a:gd name="connsiteX6" fmla="*/ 51922 w 537484"/>
                  <a:gd name="connsiteY6" fmla="*/ 8608509 h 8640339"/>
                  <a:gd name="connsiteX7" fmla="*/ 8379 w 537484"/>
                  <a:gd name="connsiteY7" fmla="*/ 8593995 h 8640339"/>
                  <a:gd name="connsiteX8" fmla="*/ 8379 w 537484"/>
                  <a:gd name="connsiteY8" fmla="*/ 8274681 h 8640339"/>
                  <a:gd name="connsiteX9" fmla="*/ 95465 w 537484"/>
                  <a:gd name="connsiteY9" fmla="*/ 4965424 h 8640339"/>
                  <a:gd name="connsiteX10" fmla="*/ 197065 w 537484"/>
                  <a:gd name="connsiteY10" fmla="*/ 712738 h 8640339"/>
                  <a:gd name="connsiteX11" fmla="*/ 206136 w 537484"/>
                  <a:gd name="connsiteY11" fmla="*/ 132167 h 8640339"/>
                  <a:gd name="connsiteX12" fmla="*/ 226547 w 537484"/>
                  <a:gd name="connsiteY12" fmla="*/ 31926 h 8640339"/>
                  <a:gd name="connsiteX13" fmla="*/ 263739 w 537484"/>
                  <a:gd name="connsiteY13" fmla="*/ 604788 h 8640339"/>
                  <a:gd name="connsiteX14" fmla="*/ 288007 w 537484"/>
                  <a:gd name="connsiteY14" fmla="*/ 1097820 h 8640339"/>
                  <a:gd name="connsiteX0" fmla="*/ 288007 w 537484"/>
                  <a:gd name="connsiteY0" fmla="*/ 1097820 h 8640339"/>
                  <a:gd name="connsiteX1" fmla="*/ 400265 w 537484"/>
                  <a:gd name="connsiteY1" fmla="*/ 5487938 h 8640339"/>
                  <a:gd name="connsiteX2" fmla="*/ 443808 w 537484"/>
                  <a:gd name="connsiteY2" fmla="*/ 7839252 h 8640339"/>
                  <a:gd name="connsiteX3" fmla="*/ 458322 w 537484"/>
                  <a:gd name="connsiteY3" fmla="*/ 8260167 h 8640339"/>
                  <a:gd name="connsiteX4" fmla="*/ 458322 w 537484"/>
                  <a:gd name="connsiteY4" fmla="*/ 8593995 h 8640339"/>
                  <a:gd name="connsiteX5" fmla="*/ 516379 w 537484"/>
                  <a:gd name="connsiteY5" fmla="*/ 8608509 h 8640339"/>
                  <a:gd name="connsiteX6" fmla="*/ 51922 w 537484"/>
                  <a:gd name="connsiteY6" fmla="*/ 8608509 h 8640339"/>
                  <a:gd name="connsiteX7" fmla="*/ 8379 w 537484"/>
                  <a:gd name="connsiteY7" fmla="*/ 8593995 h 8640339"/>
                  <a:gd name="connsiteX8" fmla="*/ 8379 w 537484"/>
                  <a:gd name="connsiteY8" fmla="*/ 8274681 h 8640339"/>
                  <a:gd name="connsiteX9" fmla="*/ 95465 w 537484"/>
                  <a:gd name="connsiteY9" fmla="*/ 4965424 h 8640339"/>
                  <a:gd name="connsiteX10" fmla="*/ 197065 w 537484"/>
                  <a:gd name="connsiteY10" fmla="*/ 712738 h 8640339"/>
                  <a:gd name="connsiteX11" fmla="*/ 206136 w 537484"/>
                  <a:gd name="connsiteY11" fmla="*/ 132167 h 8640339"/>
                  <a:gd name="connsiteX12" fmla="*/ 226547 w 537484"/>
                  <a:gd name="connsiteY12" fmla="*/ 31926 h 8640339"/>
                  <a:gd name="connsiteX13" fmla="*/ 263739 w 537484"/>
                  <a:gd name="connsiteY13" fmla="*/ 604788 h 8640339"/>
                  <a:gd name="connsiteX14" fmla="*/ 288007 w 537484"/>
                  <a:gd name="connsiteY14" fmla="*/ 1097820 h 8640339"/>
                  <a:gd name="connsiteX0" fmla="*/ 288007 w 537484"/>
                  <a:gd name="connsiteY0" fmla="*/ 1097820 h 8640339"/>
                  <a:gd name="connsiteX1" fmla="*/ 400265 w 537484"/>
                  <a:gd name="connsiteY1" fmla="*/ 5487938 h 8640339"/>
                  <a:gd name="connsiteX2" fmla="*/ 443808 w 537484"/>
                  <a:gd name="connsiteY2" fmla="*/ 7839252 h 8640339"/>
                  <a:gd name="connsiteX3" fmla="*/ 458322 w 537484"/>
                  <a:gd name="connsiteY3" fmla="*/ 8260167 h 8640339"/>
                  <a:gd name="connsiteX4" fmla="*/ 458322 w 537484"/>
                  <a:gd name="connsiteY4" fmla="*/ 8593995 h 8640339"/>
                  <a:gd name="connsiteX5" fmla="*/ 516379 w 537484"/>
                  <a:gd name="connsiteY5" fmla="*/ 8608509 h 8640339"/>
                  <a:gd name="connsiteX6" fmla="*/ 51922 w 537484"/>
                  <a:gd name="connsiteY6" fmla="*/ 8608509 h 8640339"/>
                  <a:gd name="connsiteX7" fmla="*/ 8379 w 537484"/>
                  <a:gd name="connsiteY7" fmla="*/ 8593995 h 8640339"/>
                  <a:gd name="connsiteX8" fmla="*/ 8379 w 537484"/>
                  <a:gd name="connsiteY8" fmla="*/ 8274681 h 8640339"/>
                  <a:gd name="connsiteX9" fmla="*/ 95465 w 537484"/>
                  <a:gd name="connsiteY9" fmla="*/ 4965424 h 8640339"/>
                  <a:gd name="connsiteX10" fmla="*/ 197065 w 537484"/>
                  <a:gd name="connsiteY10" fmla="*/ 712738 h 8640339"/>
                  <a:gd name="connsiteX11" fmla="*/ 206136 w 537484"/>
                  <a:gd name="connsiteY11" fmla="*/ 132167 h 8640339"/>
                  <a:gd name="connsiteX12" fmla="*/ 226547 w 537484"/>
                  <a:gd name="connsiteY12" fmla="*/ 31926 h 8640339"/>
                  <a:gd name="connsiteX13" fmla="*/ 244689 w 537484"/>
                  <a:gd name="connsiteY13" fmla="*/ 604788 h 8640339"/>
                  <a:gd name="connsiteX14" fmla="*/ 288007 w 537484"/>
                  <a:gd name="connsiteY14" fmla="*/ 1097820 h 8640339"/>
                  <a:gd name="connsiteX0" fmla="*/ 268957 w 537484"/>
                  <a:gd name="connsiteY0" fmla="*/ 1121632 h 8640339"/>
                  <a:gd name="connsiteX1" fmla="*/ 400265 w 537484"/>
                  <a:gd name="connsiteY1" fmla="*/ 5487938 h 8640339"/>
                  <a:gd name="connsiteX2" fmla="*/ 443808 w 537484"/>
                  <a:gd name="connsiteY2" fmla="*/ 7839252 h 8640339"/>
                  <a:gd name="connsiteX3" fmla="*/ 458322 w 537484"/>
                  <a:gd name="connsiteY3" fmla="*/ 8260167 h 8640339"/>
                  <a:gd name="connsiteX4" fmla="*/ 458322 w 537484"/>
                  <a:gd name="connsiteY4" fmla="*/ 8593995 h 8640339"/>
                  <a:gd name="connsiteX5" fmla="*/ 516379 w 537484"/>
                  <a:gd name="connsiteY5" fmla="*/ 8608509 h 8640339"/>
                  <a:gd name="connsiteX6" fmla="*/ 51922 w 537484"/>
                  <a:gd name="connsiteY6" fmla="*/ 8608509 h 8640339"/>
                  <a:gd name="connsiteX7" fmla="*/ 8379 w 537484"/>
                  <a:gd name="connsiteY7" fmla="*/ 8593995 h 8640339"/>
                  <a:gd name="connsiteX8" fmla="*/ 8379 w 537484"/>
                  <a:gd name="connsiteY8" fmla="*/ 8274681 h 8640339"/>
                  <a:gd name="connsiteX9" fmla="*/ 95465 w 537484"/>
                  <a:gd name="connsiteY9" fmla="*/ 4965424 h 8640339"/>
                  <a:gd name="connsiteX10" fmla="*/ 197065 w 537484"/>
                  <a:gd name="connsiteY10" fmla="*/ 712738 h 8640339"/>
                  <a:gd name="connsiteX11" fmla="*/ 206136 w 537484"/>
                  <a:gd name="connsiteY11" fmla="*/ 132167 h 8640339"/>
                  <a:gd name="connsiteX12" fmla="*/ 226547 w 537484"/>
                  <a:gd name="connsiteY12" fmla="*/ 31926 h 8640339"/>
                  <a:gd name="connsiteX13" fmla="*/ 244689 w 537484"/>
                  <a:gd name="connsiteY13" fmla="*/ 604788 h 8640339"/>
                  <a:gd name="connsiteX14" fmla="*/ 268957 w 537484"/>
                  <a:gd name="connsiteY14" fmla="*/ 1121632 h 8640339"/>
                  <a:gd name="connsiteX0" fmla="*/ 268957 w 467285"/>
                  <a:gd name="connsiteY0" fmla="*/ 1121632 h 8640339"/>
                  <a:gd name="connsiteX1" fmla="*/ 400265 w 467285"/>
                  <a:gd name="connsiteY1" fmla="*/ 5487938 h 8640339"/>
                  <a:gd name="connsiteX2" fmla="*/ 443808 w 467285"/>
                  <a:gd name="connsiteY2" fmla="*/ 7839252 h 8640339"/>
                  <a:gd name="connsiteX3" fmla="*/ 458322 w 467285"/>
                  <a:gd name="connsiteY3" fmla="*/ 8260167 h 8640339"/>
                  <a:gd name="connsiteX4" fmla="*/ 458322 w 467285"/>
                  <a:gd name="connsiteY4" fmla="*/ 8593995 h 8640339"/>
                  <a:gd name="connsiteX5" fmla="*/ 344929 w 467285"/>
                  <a:gd name="connsiteY5" fmla="*/ 8618034 h 8640339"/>
                  <a:gd name="connsiteX6" fmla="*/ 51922 w 467285"/>
                  <a:gd name="connsiteY6" fmla="*/ 8608509 h 8640339"/>
                  <a:gd name="connsiteX7" fmla="*/ 8379 w 467285"/>
                  <a:gd name="connsiteY7" fmla="*/ 8593995 h 8640339"/>
                  <a:gd name="connsiteX8" fmla="*/ 8379 w 467285"/>
                  <a:gd name="connsiteY8" fmla="*/ 8274681 h 8640339"/>
                  <a:gd name="connsiteX9" fmla="*/ 95465 w 467285"/>
                  <a:gd name="connsiteY9" fmla="*/ 4965424 h 8640339"/>
                  <a:gd name="connsiteX10" fmla="*/ 197065 w 467285"/>
                  <a:gd name="connsiteY10" fmla="*/ 712738 h 8640339"/>
                  <a:gd name="connsiteX11" fmla="*/ 206136 w 467285"/>
                  <a:gd name="connsiteY11" fmla="*/ 132167 h 8640339"/>
                  <a:gd name="connsiteX12" fmla="*/ 226547 w 467285"/>
                  <a:gd name="connsiteY12" fmla="*/ 31926 h 8640339"/>
                  <a:gd name="connsiteX13" fmla="*/ 244689 w 467285"/>
                  <a:gd name="connsiteY13" fmla="*/ 604788 h 8640339"/>
                  <a:gd name="connsiteX14" fmla="*/ 268957 w 467285"/>
                  <a:gd name="connsiteY14" fmla="*/ 1121632 h 8640339"/>
                  <a:gd name="connsiteX0" fmla="*/ 270835 w 469163"/>
                  <a:gd name="connsiteY0" fmla="*/ 1121632 h 8639464"/>
                  <a:gd name="connsiteX1" fmla="*/ 402143 w 469163"/>
                  <a:gd name="connsiteY1" fmla="*/ 5487938 h 8639464"/>
                  <a:gd name="connsiteX2" fmla="*/ 445686 w 469163"/>
                  <a:gd name="connsiteY2" fmla="*/ 7839252 h 8639464"/>
                  <a:gd name="connsiteX3" fmla="*/ 460200 w 469163"/>
                  <a:gd name="connsiteY3" fmla="*/ 8260167 h 8639464"/>
                  <a:gd name="connsiteX4" fmla="*/ 460200 w 469163"/>
                  <a:gd name="connsiteY4" fmla="*/ 8593995 h 8639464"/>
                  <a:gd name="connsiteX5" fmla="*/ 346807 w 469163"/>
                  <a:gd name="connsiteY5" fmla="*/ 8618034 h 8639464"/>
                  <a:gd name="connsiteX6" fmla="*/ 87137 w 469163"/>
                  <a:gd name="connsiteY6" fmla="*/ 8622796 h 8639464"/>
                  <a:gd name="connsiteX7" fmla="*/ 10257 w 469163"/>
                  <a:gd name="connsiteY7" fmla="*/ 8593995 h 8639464"/>
                  <a:gd name="connsiteX8" fmla="*/ 10257 w 469163"/>
                  <a:gd name="connsiteY8" fmla="*/ 8274681 h 8639464"/>
                  <a:gd name="connsiteX9" fmla="*/ 97343 w 469163"/>
                  <a:gd name="connsiteY9" fmla="*/ 4965424 h 8639464"/>
                  <a:gd name="connsiteX10" fmla="*/ 198943 w 469163"/>
                  <a:gd name="connsiteY10" fmla="*/ 712738 h 8639464"/>
                  <a:gd name="connsiteX11" fmla="*/ 208014 w 469163"/>
                  <a:gd name="connsiteY11" fmla="*/ 132167 h 8639464"/>
                  <a:gd name="connsiteX12" fmla="*/ 228425 w 469163"/>
                  <a:gd name="connsiteY12" fmla="*/ 31926 h 8639464"/>
                  <a:gd name="connsiteX13" fmla="*/ 246567 w 469163"/>
                  <a:gd name="connsiteY13" fmla="*/ 604788 h 8639464"/>
                  <a:gd name="connsiteX14" fmla="*/ 270835 w 469163"/>
                  <a:gd name="connsiteY14" fmla="*/ 1121632 h 8639464"/>
                  <a:gd name="connsiteX0" fmla="*/ 280632 w 478960"/>
                  <a:gd name="connsiteY0" fmla="*/ 1121632 h 8629359"/>
                  <a:gd name="connsiteX1" fmla="*/ 411940 w 478960"/>
                  <a:gd name="connsiteY1" fmla="*/ 5487938 h 8629359"/>
                  <a:gd name="connsiteX2" fmla="*/ 455483 w 478960"/>
                  <a:gd name="connsiteY2" fmla="*/ 7839252 h 8629359"/>
                  <a:gd name="connsiteX3" fmla="*/ 469997 w 478960"/>
                  <a:gd name="connsiteY3" fmla="*/ 8260167 h 8629359"/>
                  <a:gd name="connsiteX4" fmla="*/ 469997 w 478960"/>
                  <a:gd name="connsiteY4" fmla="*/ 8593995 h 8629359"/>
                  <a:gd name="connsiteX5" fmla="*/ 356604 w 478960"/>
                  <a:gd name="connsiteY5" fmla="*/ 8618034 h 8629359"/>
                  <a:gd name="connsiteX6" fmla="*/ 96934 w 478960"/>
                  <a:gd name="connsiteY6" fmla="*/ 8622796 h 8629359"/>
                  <a:gd name="connsiteX7" fmla="*/ 5767 w 478960"/>
                  <a:gd name="connsiteY7" fmla="*/ 8527320 h 8629359"/>
                  <a:gd name="connsiteX8" fmla="*/ 20054 w 478960"/>
                  <a:gd name="connsiteY8" fmla="*/ 8274681 h 8629359"/>
                  <a:gd name="connsiteX9" fmla="*/ 107140 w 478960"/>
                  <a:gd name="connsiteY9" fmla="*/ 4965424 h 8629359"/>
                  <a:gd name="connsiteX10" fmla="*/ 208740 w 478960"/>
                  <a:gd name="connsiteY10" fmla="*/ 712738 h 8629359"/>
                  <a:gd name="connsiteX11" fmla="*/ 217811 w 478960"/>
                  <a:gd name="connsiteY11" fmla="*/ 132167 h 8629359"/>
                  <a:gd name="connsiteX12" fmla="*/ 238222 w 478960"/>
                  <a:gd name="connsiteY12" fmla="*/ 31926 h 8629359"/>
                  <a:gd name="connsiteX13" fmla="*/ 256364 w 478960"/>
                  <a:gd name="connsiteY13" fmla="*/ 604788 h 8629359"/>
                  <a:gd name="connsiteX14" fmla="*/ 280632 w 478960"/>
                  <a:gd name="connsiteY14" fmla="*/ 1121632 h 8629359"/>
                  <a:gd name="connsiteX0" fmla="*/ 274911 w 473239"/>
                  <a:gd name="connsiteY0" fmla="*/ 1121632 h 8629359"/>
                  <a:gd name="connsiteX1" fmla="*/ 406219 w 473239"/>
                  <a:gd name="connsiteY1" fmla="*/ 5487938 h 8629359"/>
                  <a:gd name="connsiteX2" fmla="*/ 449762 w 473239"/>
                  <a:gd name="connsiteY2" fmla="*/ 7839252 h 8629359"/>
                  <a:gd name="connsiteX3" fmla="*/ 464276 w 473239"/>
                  <a:gd name="connsiteY3" fmla="*/ 8260167 h 8629359"/>
                  <a:gd name="connsiteX4" fmla="*/ 464276 w 473239"/>
                  <a:gd name="connsiteY4" fmla="*/ 8593995 h 8629359"/>
                  <a:gd name="connsiteX5" fmla="*/ 350883 w 473239"/>
                  <a:gd name="connsiteY5" fmla="*/ 8618034 h 8629359"/>
                  <a:gd name="connsiteX6" fmla="*/ 91213 w 473239"/>
                  <a:gd name="connsiteY6" fmla="*/ 8622796 h 8629359"/>
                  <a:gd name="connsiteX7" fmla="*/ 46 w 473239"/>
                  <a:gd name="connsiteY7" fmla="*/ 8527320 h 8629359"/>
                  <a:gd name="connsiteX8" fmla="*/ 14333 w 473239"/>
                  <a:gd name="connsiteY8" fmla="*/ 8274681 h 8629359"/>
                  <a:gd name="connsiteX9" fmla="*/ 101419 w 473239"/>
                  <a:gd name="connsiteY9" fmla="*/ 4965424 h 8629359"/>
                  <a:gd name="connsiteX10" fmla="*/ 203019 w 473239"/>
                  <a:gd name="connsiteY10" fmla="*/ 712738 h 8629359"/>
                  <a:gd name="connsiteX11" fmla="*/ 212090 w 473239"/>
                  <a:gd name="connsiteY11" fmla="*/ 132167 h 8629359"/>
                  <a:gd name="connsiteX12" fmla="*/ 232501 w 473239"/>
                  <a:gd name="connsiteY12" fmla="*/ 31926 h 8629359"/>
                  <a:gd name="connsiteX13" fmla="*/ 250643 w 473239"/>
                  <a:gd name="connsiteY13" fmla="*/ 604788 h 8629359"/>
                  <a:gd name="connsiteX14" fmla="*/ 274911 w 473239"/>
                  <a:gd name="connsiteY14" fmla="*/ 1121632 h 8629359"/>
                  <a:gd name="connsiteX0" fmla="*/ 274911 w 480890"/>
                  <a:gd name="connsiteY0" fmla="*/ 1121632 h 8632030"/>
                  <a:gd name="connsiteX1" fmla="*/ 406219 w 480890"/>
                  <a:gd name="connsiteY1" fmla="*/ 5487938 h 8632030"/>
                  <a:gd name="connsiteX2" fmla="*/ 449762 w 480890"/>
                  <a:gd name="connsiteY2" fmla="*/ 7839252 h 8632030"/>
                  <a:gd name="connsiteX3" fmla="*/ 464276 w 480890"/>
                  <a:gd name="connsiteY3" fmla="*/ 8260167 h 8632030"/>
                  <a:gd name="connsiteX4" fmla="*/ 473801 w 480890"/>
                  <a:gd name="connsiteY4" fmla="*/ 8532082 h 8632030"/>
                  <a:gd name="connsiteX5" fmla="*/ 350883 w 480890"/>
                  <a:gd name="connsiteY5" fmla="*/ 8618034 h 8632030"/>
                  <a:gd name="connsiteX6" fmla="*/ 91213 w 480890"/>
                  <a:gd name="connsiteY6" fmla="*/ 8622796 h 8632030"/>
                  <a:gd name="connsiteX7" fmla="*/ 46 w 480890"/>
                  <a:gd name="connsiteY7" fmla="*/ 8527320 h 8632030"/>
                  <a:gd name="connsiteX8" fmla="*/ 14333 w 480890"/>
                  <a:gd name="connsiteY8" fmla="*/ 8274681 h 8632030"/>
                  <a:gd name="connsiteX9" fmla="*/ 101419 w 480890"/>
                  <a:gd name="connsiteY9" fmla="*/ 4965424 h 8632030"/>
                  <a:gd name="connsiteX10" fmla="*/ 203019 w 480890"/>
                  <a:gd name="connsiteY10" fmla="*/ 712738 h 8632030"/>
                  <a:gd name="connsiteX11" fmla="*/ 212090 w 480890"/>
                  <a:gd name="connsiteY11" fmla="*/ 132167 h 8632030"/>
                  <a:gd name="connsiteX12" fmla="*/ 232501 w 480890"/>
                  <a:gd name="connsiteY12" fmla="*/ 31926 h 8632030"/>
                  <a:gd name="connsiteX13" fmla="*/ 250643 w 480890"/>
                  <a:gd name="connsiteY13" fmla="*/ 604788 h 8632030"/>
                  <a:gd name="connsiteX14" fmla="*/ 274911 w 480890"/>
                  <a:gd name="connsiteY14" fmla="*/ 1121632 h 8632030"/>
                  <a:gd name="connsiteX0" fmla="*/ 274911 w 474066"/>
                  <a:gd name="connsiteY0" fmla="*/ 1121632 h 8632030"/>
                  <a:gd name="connsiteX1" fmla="*/ 406219 w 474066"/>
                  <a:gd name="connsiteY1" fmla="*/ 5487938 h 8632030"/>
                  <a:gd name="connsiteX2" fmla="*/ 449762 w 474066"/>
                  <a:gd name="connsiteY2" fmla="*/ 7839252 h 8632030"/>
                  <a:gd name="connsiteX3" fmla="*/ 464276 w 474066"/>
                  <a:gd name="connsiteY3" fmla="*/ 8260167 h 8632030"/>
                  <a:gd name="connsiteX4" fmla="*/ 473801 w 474066"/>
                  <a:gd name="connsiteY4" fmla="*/ 8532082 h 8632030"/>
                  <a:gd name="connsiteX5" fmla="*/ 350883 w 474066"/>
                  <a:gd name="connsiteY5" fmla="*/ 8618034 h 8632030"/>
                  <a:gd name="connsiteX6" fmla="*/ 91213 w 474066"/>
                  <a:gd name="connsiteY6" fmla="*/ 8622796 h 8632030"/>
                  <a:gd name="connsiteX7" fmla="*/ 46 w 474066"/>
                  <a:gd name="connsiteY7" fmla="*/ 8527320 h 8632030"/>
                  <a:gd name="connsiteX8" fmla="*/ 14333 w 474066"/>
                  <a:gd name="connsiteY8" fmla="*/ 8274681 h 8632030"/>
                  <a:gd name="connsiteX9" fmla="*/ 101419 w 474066"/>
                  <a:gd name="connsiteY9" fmla="*/ 4965424 h 8632030"/>
                  <a:gd name="connsiteX10" fmla="*/ 203019 w 474066"/>
                  <a:gd name="connsiteY10" fmla="*/ 712738 h 8632030"/>
                  <a:gd name="connsiteX11" fmla="*/ 212090 w 474066"/>
                  <a:gd name="connsiteY11" fmla="*/ 132167 h 8632030"/>
                  <a:gd name="connsiteX12" fmla="*/ 232501 w 474066"/>
                  <a:gd name="connsiteY12" fmla="*/ 31926 h 8632030"/>
                  <a:gd name="connsiteX13" fmla="*/ 250643 w 474066"/>
                  <a:gd name="connsiteY13" fmla="*/ 604788 h 8632030"/>
                  <a:gd name="connsiteX14" fmla="*/ 274911 w 474066"/>
                  <a:gd name="connsiteY14" fmla="*/ 1121632 h 8632030"/>
                  <a:gd name="connsiteX0" fmla="*/ 274911 w 478814"/>
                  <a:gd name="connsiteY0" fmla="*/ 1121632 h 8631000"/>
                  <a:gd name="connsiteX1" fmla="*/ 406219 w 478814"/>
                  <a:gd name="connsiteY1" fmla="*/ 5487938 h 8631000"/>
                  <a:gd name="connsiteX2" fmla="*/ 449762 w 478814"/>
                  <a:gd name="connsiteY2" fmla="*/ 7839252 h 8631000"/>
                  <a:gd name="connsiteX3" fmla="*/ 464276 w 478814"/>
                  <a:gd name="connsiteY3" fmla="*/ 8260167 h 8631000"/>
                  <a:gd name="connsiteX4" fmla="*/ 478563 w 478814"/>
                  <a:gd name="connsiteY4" fmla="*/ 8593995 h 8631000"/>
                  <a:gd name="connsiteX5" fmla="*/ 350883 w 478814"/>
                  <a:gd name="connsiteY5" fmla="*/ 8618034 h 8631000"/>
                  <a:gd name="connsiteX6" fmla="*/ 91213 w 478814"/>
                  <a:gd name="connsiteY6" fmla="*/ 8622796 h 8631000"/>
                  <a:gd name="connsiteX7" fmla="*/ 46 w 478814"/>
                  <a:gd name="connsiteY7" fmla="*/ 8527320 h 8631000"/>
                  <a:gd name="connsiteX8" fmla="*/ 14333 w 478814"/>
                  <a:gd name="connsiteY8" fmla="*/ 8274681 h 8631000"/>
                  <a:gd name="connsiteX9" fmla="*/ 101419 w 478814"/>
                  <a:gd name="connsiteY9" fmla="*/ 4965424 h 8631000"/>
                  <a:gd name="connsiteX10" fmla="*/ 203019 w 478814"/>
                  <a:gd name="connsiteY10" fmla="*/ 712738 h 8631000"/>
                  <a:gd name="connsiteX11" fmla="*/ 212090 w 478814"/>
                  <a:gd name="connsiteY11" fmla="*/ 132167 h 8631000"/>
                  <a:gd name="connsiteX12" fmla="*/ 232501 w 478814"/>
                  <a:gd name="connsiteY12" fmla="*/ 31926 h 8631000"/>
                  <a:gd name="connsiteX13" fmla="*/ 250643 w 478814"/>
                  <a:gd name="connsiteY13" fmla="*/ 604788 h 8631000"/>
                  <a:gd name="connsiteX14" fmla="*/ 274911 w 478814"/>
                  <a:gd name="connsiteY14" fmla="*/ 1121632 h 8631000"/>
                  <a:gd name="connsiteX0" fmla="*/ 274908 w 486316"/>
                  <a:gd name="connsiteY0" fmla="*/ 1121632 h 8631060"/>
                  <a:gd name="connsiteX1" fmla="*/ 406216 w 486316"/>
                  <a:gd name="connsiteY1" fmla="*/ 5487938 h 8631060"/>
                  <a:gd name="connsiteX2" fmla="*/ 449759 w 486316"/>
                  <a:gd name="connsiteY2" fmla="*/ 7839252 h 8631060"/>
                  <a:gd name="connsiteX3" fmla="*/ 464273 w 486316"/>
                  <a:gd name="connsiteY3" fmla="*/ 8260167 h 8631060"/>
                  <a:gd name="connsiteX4" fmla="*/ 478560 w 486316"/>
                  <a:gd name="connsiteY4" fmla="*/ 8593995 h 8631060"/>
                  <a:gd name="connsiteX5" fmla="*/ 331830 w 486316"/>
                  <a:gd name="connsiteY5" fmla="*/ 8622797 h 8631060"/>
                  <a:gd name="connsiteX6" fmla="*/ 91210 w 486316"/>
                  <a:gd name="connsiteY6" fmla="*/ 8622796 h 8631060"/>
                  <a:gd name="connsiteX7" fmla="*/ 43 w 486316"/>
                  <a:gd name="connsiteY7" fmla="*/ 8527320 h 8631060"/>
                  <a:gd name="connsiteX8" fmla="*/ 14330 w 486316"/>
                  <a:gd name="connsiteY8" fmla="*/ 8274681 h 8631060"/>
                  <a:gd name="connsiteX9" fmla="*/ 101416 w 486316"/>
                  <a:gd name="connsiteY9" fmla="*/ 4965424 h 8631060"/>
                  <a:gd name="connsiteX10" fmla="*/ 203016 w 486316"/>
                  <a:gd name="connsiteY10" fmla="*/ 712738 h 8631060"/>
                  <a:gd name="connsiteX11" fmla="*/ 212087 w 486316"/>
                  <a:gd name="connsiteY11" fmla="*/ 132167 h 8631060"/>
                  <a:gd name="connsiteX12" fmla="*/ 232498 w 486316"/>
                  <a:gd name="connsiteY12" fmla="*/ 31926 h 8631060"/>
                  <a:gd name="connsiteX13" fmla="*/ 250640 w 486316"/>
                  <a:gd name="connsiteY13" fmla="*/ 604788 h 8631060"/>
                  <a:gd name="connsiteX14" fmla="*/ 274908 w 486316"/>
                  <a:gd name="connsiteY14" fmla="*/ 1121632 h 8631060"/>
                  <a:gd name="connsiteX0" fmla="*/ 277822 w 489230"/>
                  <a:gd name="connsiteY0" fmla="*/ 1121632 h 8634642"/>
                  <a:gd name="connsiteX1" fmla="*/ 409130 w 489230"/>
                  <a:gd name="connsiteY1" fmla="*/ 5487938 h 8634642"/>
                  <a:gd name="connsiteX2" fmla="*/ 452673 w 489230"/>
                  <a:gd name="connsiteY2" fmla="*/ 7839252 h 8634642"/>
                  <a:gd name="connsiteX3" fmla="*/ 467187 w 489230"/>
                  <a:gd name="connsiteY3" fmla="*/ 8260167 h 8634642"/>
                  <a:gd name="connsiteX4" fmla="*/ 481474 w 489230"/>
                  <a:gd name="connsiteY4" fmla="*/ 8593995 h 8634642"/>
                  <a:gd name="connsiteX5" fmla="*/ 334744 w 489230"/>
                  <a:gd name="connsiteY5" fmla="*/ 8622797 h 8634642"/>
                  <a:gd name="connsiteX6" fmla="*/ 56024 w 489230"/>
                  <a:gd name="connsiteY6" fmla="*/ 8627559 h 8634642"/>
                  <a:gd name="connsiteX7" fmla="*/ 2957 w 489230"/>
                  <a:gd name="connsiteY7" fmla="*/ 8527320 h 8634642"/>
                  <a:gd name="connsiteX8" fmla="*/ 17244 w 489230"/>
                  <a:gd name="connsiteY8" fmla="*/ 8274681 h 8634642"/>
                  <a:gd name="connsiteX9" fmla="*/ 104330 w 489230"/>
                  <a:gd name="connsiteY9" fmla="*/ 4965424 h 8634642"/>
                  <a:gd name="connsiteX10" fmla="*/ 205930 w 489230"/>
                  <a:gd name="connsiteY10" fmla="*/ 712738 h 8634642"/>
                  <a:gd name="connsiteX11" fmla="*/ 215001 w 489230"/>
                  <a:gd name="connsiteY11" fmla="*/ 132167 h 8634642"/>
                  <a:gd name="connsiteX12" fmla="*/ 235412 w 489230"/>
                  <a:gd name="connsiteY12" fmla="*/ 31926 h 8634642"/>
                  <a:gd name="connsiteX13" fmla="*/ 253554 w 489230"/>
                  <a:gd name="connsiteY13" fmla="*/ 604788 h 8634642"/>
                  <a:gd name="connsiteX14" fmla="*/ 277822 w 489230"/>
                  <a:gd name="connsiteY14" fmla="*/ 1121632 h 8634642"/>
                  <a:gd name="connsiteX0" fmla="*/ 277822 w 489230"/>
                  <a:gd name="connsiteY0" fmla="*/ 1120835 h 8633845"/>
                  <a:gd name="connsiteX1" fmla="*/ 409130 w 489230"/>
                  <a:gd name="connsiteY1" fmla="*/ 5487141 h 8633845"/>
                  <a:gd name="connsiteX2" fmla="*/ 452673 w 489230"/>
                  <a:gd name="connsiteY2" fmla="*/ 7838455 h 8633845"/>
                  <a:gd name="connsiteX3" fmla="*/ 467187 w 489230"/>
                  <a:gd name="connsiteY3" fmla="*/ 8259370 h 8633845"/>
                  <a:gd name="connsiteX4" fmla="*/ 481474 w 489230"/>
                  <a:gd name="connsiteY4" fmla="*/ 8593198 h 8633845"/>
                  <a:gd name="connsiteX5" fmla="*/ 334744 w 489230"/>
                  <a:gd name="connsiteY5" fmla="*/ 8622000 h 8633845"/>
                  <a:gd name="connsiteX6" fmla="*/ 56024 w 489230"/>
                  <a:gd name="connsiteY6" fmla="*/ 8626762 h 8633845"/>
                  <a:gd name="connsiteX7" fmla="*/ 2957 w 489230"/>
                  <a:gd name="connsiteY7" fmla="*/ 8526523 h 8633845"/>
                  <a:gd name="connsiteX8" fmla="*/ 17244 w 489230"/>
                  <a:gd name="connsiteY8" fmla="*/ 8273884 h 8633845"/>
                  <a:gd name="connsiteX9" fmla="*/ 104330 w 489230"/>
                  <a:gd name="connsiteY9" fmla="*/ 4964627 h 8633845"/>
                  <a:gd name="connsiteX10" fmla="*/ 205930 w 489230"/>
                  <a:gd name="connsiteY10" fmla="*/ 711941 h 8633845"/>
                  <a:gd name="connsiteX11" fmla="*/ 215001 w 489230"/>
                  <a:gd name="connsiteY11" fmla="*/ 131370 h 8633845"/>
                  <a:gd name="connsiteX12" fmla="*/ 235412 w 489230"/>
                  <a:gd name="connsiteY12" fmla="*/ 31129 h 8633845"/>
                  <a:gd name="connsiteX13" fmla="*/ 300311 w 489230"/>
                  <a:gd name="connsiteY13" fmla="*/ 593038 h 8633845"/>
                  <a:gd name="connsiteX14" fmla="*/ 277822 w 489230"/>
                  <a:gd name="connsiteY14" fmla="*/ 1120835 h 8633845"/>
                  <a:gd name="connsiteX0" fmla="*/ 324577 w 489230"/>
                  <a:gd name="connsiteY0" fmla="*/ 1120835 h 8633845"/>
                  <a:gd name="connsiteX1" fmla="*/ 409130 w 489230"/>
                  <a:gd name="connsiteY1" fmla="*/ 5487141 h 8633845"/>
                  <a:gd name="connsiteX2" fmla="*/ 452673 w 489230"/>
                  <a:gd name="connsiteY2" fmla="*/ 7838455 h 8633845"/>
                  <a:gd name="connsiteX3" fmla="*/ 467187 w 489230"/>
                  <a:gd name="connsiteY3" fmla="*/ 8259370 h 8633845"/>
                  <a:gd name="connsiteX4" fmla="*/ 481474 w 489230"/>
                  <a:gd name="connsiteY4" fmla="*/ 8593198 h 8633845"/>
                  <a:gd name="connsiteX5" fmla="*/ 334744 w 489230"/>
                  <a:gd name="connsiteY5" fmla="*/ 8622000 h 8633845"/>
                  <a:gd name="connsiteX6" fmla="*/ 56024 w 489230"/>
                  <a:gd name="connsiteY6" fmla="*/ 8626762 h 8633845"/>
                  <a:gd name="connsiteX7" fmla="*/ 2957 w 489230"/>
                  <a:gd name="connsiteY7" fmla="*/ 8526523 h 8633845"/>
                  <a:gd name="connsiteX8" fmla="*/ 17244 w 489230"/>
                  <a:gd name="connsiteY8" fmla="*/ 8273884 h 8633845"/>
                  <a:gd name="connsiteX9" fmla="*/ 104330 w 489230"/>
                  <a:gd name="connsiteY9" fmla="*/ 4964627 h 8633845"/>
                  <a:gd name="connsiteX10" fmla="*/ 205930 w 489230"/>
                  <a:gd name="connsiteY10" fmla="*/ 711941 h 8633845"/>
                  <a:gd name="connsiteX11" fmla="*/ 215001 w 489230"/>
                  <a:gd name="connsiteY11" fmla="*/ 131370 h 8633845"/>
                  <a:gd name="connsiteX12" fmla="*/ 235412 w 489230"/>
                  <a:gd name="connsiteY12" fmla="*/ 31129 h 8633845"/>
                  <a:gd name="connsiteX13" fmla="*/ 300311 w 489230"/>
                  <a:gd name="connsiteY13" fmla="*/ 593038 h 8633845"/>
                  <a:gd name="connsiteX14" fmla="*/ 324577 w 489230"/>
                  <a:gd name="connsiteY14" fmla="*/ 1120835 h 8633845"/>
                  <a:gd name="connsiteX0" fmla="*/ 324577 w 489230"/>
                  <a:gd name="connsiteY0" fmla="*/ 1120835 h 8633845"/>
                  <a:gd name="connsiteX1" fmla="*/ 409130 w 489230"/>
                  <a:gd name="connsiteY1" fmla="*/ 5487141 h 8633845"/>
                  <a:gd name="connsiteX2" fmla="*/ 452673 w 489230"/>
                  <a:gd name="connsiteY2" fmla="*/ 7838455 h 8633845"/>
                  <a:gd name="connsiteX3" fmla="*/ 467187 w 489230"/>
                  <a:gd name="connsiteY3" fmla="*/ 8259370 h 8633845"/>
                  <a:gd name="connsiteX4" fmla="*/ 481474 w 489230"/>
                  <a:gd name="connsiteY4" fmla="*/ 8593198 h 8633845"/>
                  <a:gd name="connsiteX5" fmla="*/ 334744 w 489230"/>
                  <a:gd name="connsiteY5" fmla="*/ 8622000 h 8633845"/>
                  <a:gd name="connsiteX6" fmla="*/ 56024 w 489230"/>
                  <a:gd name="connsiteY6" fmla="*/ 8626762 h 8633845"/>
                  <a:gd name="connsiteX7" fmla="*/ 2957 w 489230"/>
                  <a:gd name="connsiteY7" fmla="*/ 8526523 h 8633845"/>
                  <a:gd name="connsiteX8" fmla="*/ 17244 w 489230"/>
                  <a:gd name="connsiteY8" fmla="*/ 8273884 h 8633845"/>
                  <a:gd name="connsiteX9" fmla="*/ 104330 w 489230"/>
                  <a:gd name="connsiteY9" fmla="*/ 4964627 h 8633845"/>
                  <a:gd name="connsiteX10" fmla="*/ 143589 w 489230"/>
                  <a:gd name="connsiteY10" fmla="*/ 700989 h 8633845"/>
                  <a:gd name="connsiteX11" fmla="*/ 215001 w 489230"/>
                  <a:gd name="connsiteY11" fmla="*/ 131370 h 8633845"/>
                  <a:gd name="connsiteX12" fmla="*/ 235412 w 489230"/>
                  <a:gd name="connsiteY12" fmla="*/ 31129 h 8633845"/>
                  <a:gd name="connsiteX13" fmla="*/ 300311 w 489230"/>
                  <a:gd name="connsiteY13" fmla="*/ 593038 h 8633845"/>
                  <a:gd name="connsiteX14" fmla="*/ 324577 w 489230"/>
                  <a:gd name="connsiteY14" fmla="*/ 1120835 h 8633845"/>
                  <a:gd name="connsiteX0" fmla="*/ 324577 w 489230"/>
                  <a:gd name="connsiteY0" fmla="*/ 1113691 h 8626701"/>
                  <a:gd name="connsiteX1" fmla="*/ 409130 w 489230"/>
                  <a:gd name="connsiteY1" fmla="*/ 5479997 h 8626701"/>
                  <a:gd name="connsiteX2" fmla="*/ 452673 w 489230"/>
                  <a:gd name="connsiteY2" fmla="*/ 7831311 h 8626701"/>
                  <a:gd name="connsiteX3" fmla="*/ 467187 w 489230"/>
                  <a:gd name="connsiteY3" fmla="*/ 8252226 h 8626701"/>
                  <a:gd name="connsiteX4" fmla="*/ 481474 w 489230"/>
                  <a:gd name="connsiteY4" fmla="*/ 8586054 h 8626701"/>
                  <a:gd name="connsiteX5" fmla="*/ 334744 w 489230"/>
                  <a:gd name="connsiteY5" fmla="*/ 8614856 h 8626701"/>
                  <a:gd name="connsiteX6" fmla="*/ 56024 w 489230"/>
                  <a:gd name="connsiteY6" fmla="*/ 8619618 h 8626701"/>
                  <a:gd name="connsiteX7" fmla="*/ 2957 w 489230"/>
                  <a:gd name="connsiteY7" fmla="*/ 8519379 h 8626701"/>
                  <a:gd name="connsiteX8" fmla="*/ 17244 w 489230"/>
                  <a:gd name="connsiteY8" fmla="*/ 8266740 h 8626701"/>
                  <a:gd name="connsiteX9" fmla="*/ 104330 w 489230"/>
                  <a:gd name="connsiteY9" fmla="*/ 4957483 h 8626701"/>
                  <a:gd name="connsiteX10" fmla="*/ 143589 w 489230"/>
                  <a:gd name="connsiteY10" fmla="*/ 693845 h 8626701"/>
                  <a:gd name="connsiteX11" fmla="*/ 215001 w 489230"/>
                  <a:gd name="connsiteY11" fmla="*/ 124226 h 8626701"/>
                  <a:gd name="connsiteX12" fmla="*/ 235412 w 489230"/>
                  <a:gd name="connsiteY12" fmla="*/ 23985 h 8626701"/>
                  <a:gd name="connsiteX13" fmla="*/ 269140 w 489230"/>
                  <a:gd name="connsiteY13" fmla="*/ 487327 h 8626701"/>
                  <a:gd name="connsiteX14" fmla="*/ 324577 w 489230"/>
                  <a:gd name="connsiteY14" fmla="*/ 1113691 h 8626701"/>
                  <a:gd name="connsiteX0" fmla="*/ 324577 w 489230"/>
                  <a:gd name="connsiteY0" fmla="*/ 1108180 h 8621190"/>
                  <a:gd name="connsiteX1" fmla="*/ 409130 w 489230"/>
                  <a:gd name="connsiteY1" fmla="*/ 5474486 h 8621190"/>
                  <a:gd name="connsiteX2" fmla="*/ 452673 w 489230"/>
                  <a:gd name="connsiteY2" fmla="*/ 7825800 h 8621190"/>
                  <a:gd name="connsiteX3" fmla="*/ 467187 w 489230"/>
                  <a:gd name="connsiteY3" fmla="*/ 8246715 h 8621190"/>
                  <a:gd name="connsiteX4" fmla="*/ 481474 w 489230"/>
                  <a:gd name="connsiteY4" fmla="*/ 8580543 h 8621190"/>
                  <a:gd name="connsiteX5" fmla="*/ 334744 w 489230"/>
                  <a:gd name="connsiteY5" fmla="*/ 8609345 h 8621190"/>
                  <a:gd name="connsiteX6" fmla="*/ 56024 w 489230"/>
                  <a:gd name="connsiteY6" fmla="*/ 8614107 h 8621190"/>
                  <a:gd name="connsiteX7" fmla="*/ 2957 w 489230"/>
                  <a:gd name="connsiteY7" fmla="*/ 8513868 h 8621190"/>
                  <a:gd name="connsiteX8" fmla="*/ 17244 w 489230"/>
                  <a:gd name="connsiteY8" fmla="*/ 8261229 h 8621190"/>
                  <a:gd name="connsiteX9" fmla="*/ 104330 w 489230"/>
                  <a:gd name="connsiteY9" fmla="*/ 4951972 h 8621190"/>
                  <a:gd name="connsiteX10" fmla="*/ 143589 w 489230"/>
                  <a:gd name="connsiteY10" fmla="*/ 688334 h 8621190"/>
                  <a:gd name="connsiteX11" fmla="*/ 215001 w 489230"/>
                  <a:gd name="connsiteY11" fmla="*/ 118715 h 8621190"/>
                  <a:gd name="connsiteX12" fmla="*/ 235412 w 489230"/>
                  <a:gd name="connsiteY12" fmla="*/ 18474 h 8621190"/>
                  <a:gd name="connsiteX13" fmla="*/ 269140 w 489230"/>
                  <a:gd name="connsiteY13" fmla="*/ 405152 h 8621190"/>
                  <a:gd name="connsiteX14" fmla="*/ 324577 w 489230"/>
                  <a:gd name="connsiteY14" fmla="*/ 1108180 h 8621190"/>
                  <a:gd name="connsiteX0" fmla="*/ 324577 w 489230"/>
                  <a:gd name="connsiteY0" fmla="*/ 1108180 h 8621190"/>
                  <a:gd name="connsiteX1" fmla="*/ 409130 w 489230"/>
                  <a:gd name="connsiteY1" fmla="*/ 5474486 h 8621190"/>
                  <a:gd name="connsiteX2" fmla="*/ 452673 w 489230"/>
                  <a:gd name="connsiteY2" fmla="*/ 7825800 h 8621190"/>
                  <a:gd name="connsiteX3" fmla="*/ 467187 w 489230"/>
                  <a:gd name="connsiteY3" fmla="*/ 8246715 h 8621190"/>
                  <a:gd name="connsiteX4" fmla="*/ 481474 w 489230"/>
                  <a:gd name="connsiteY4" fmla="*/ 8580543 h 8621190"/>
                  <a:gd name="connsiteX5" fmla="*/ 334744 w 489230"/>
                  <a:gd name="connsiteY5" fmla="*/ 8609345 h 8621190"/>
                  <a:gd name="connsiteX6" fmla="*/ 56024 w 489230"/>
                  <a:gd name="connsiteY6" fmla="*/ 8614107 h 8621190"/>
                  <a:gd name="connsiteX7" fmla="*/ 2957 w 489230"/>
                  <a:gd name="connsiteY7" fmla="*/ 8513868 h 8621190"/>
                  <a:gd name="connsiteX8" fmla="*/ 17244 w 489230"/>
                  <a:gd name="connsiteY8" fmla="*/ 8261229 h 8621190"/>
                  <a:gd name="connsiteX9" fmla="*/ 104330 w 489230"/>
                  <a:gd name="connsiteY9" fmla="*/ 4951972 h 8621190"/>
                  <a:gd name="connsiteX10" fmla="*/ 143589 w 489230"/>
                  <a:gd name="connsiteY10" fmla="*/ 688334 h 8621190"/>
                  <a:gd name="connsiteX11" fmla="*/ 215001 w 489230"/>
                  <a:gd name="connsiteY11" fmla="*/ 118715 h 8621190"/>
                  <a:gd name="connsiteX12" fmla="*/ 235412 w 489230"/>
                  <a:gd name="connsiteY12" fmla="*/ 18474 h 8621190"/>
                  <a:gd name="connsiteX13" fmla="*/ 269140 w 489230"/>
                  <a:gd name="connsiteY13" fmla="*/ 405152 h 8621190"/>
                  <a:gd name="connsiteX14" fmla="*/ 324577 w 489230"/>
                  <a:gd name="connsiteY14" fmla="*/ 1108180 h 8621190"/>
                  <a:gd name="connsiteX0" fmla="*/ 324577 w 489230"/>
                  <a:gd name="connsiteY0" fmla="*/ 1102741 h 8615751"/>
                  <a:gd name="connsiteX1" fmla="*/ 409130 w 489230"/>
                  <a:gd name="connsiteY1" fmla="*/ 5469047 h 8615751"/>
                  <a:gd name="connsiteX2" fmla="*/ 452673 w 489230"/>
                  <a:gd name="connsiteY2" fmla="*/ 7820361 h 8615751"/>
                  <a:gd name="connsiteX3" fmla="*/ 467187 w 489230"/>
                  <a:gd name="connsiteY3" fmla="*/ 8241276 h 8615751"/>
                  <a:gd name="connsiteX4" fmla="*/ 481474 w 489230"/>
                  <a:gd name="connsiteY4" fmla="*/ 8575104 h 8615751"/>
                  <a:gd name="connsiteX5" fmla="*/ 334744 w 489230"/>
                  <a:gd name="connsiteY5" fmla="*/ 8603906 h 8615751"/>
                  <a:gd name="connsiteX6" fmla="*/ 56024 w 489230"/>
                  <a:gd name="connsiteY6" fmla="*/ 8608668 h 8615751"/>
                  <a:gd name="connsiteX7" fmla="*/ 2957 w 489230"/>
                  <a:gd name="connsiteY7" fmla="*/ 8508429 h 8615751"/>
                  <a:gd name="connsiteX8" fmla="*/ 17244 w 489230"/>
                  <a:gd name="connsiteY8" fmla="*/ 8255790 h 8615751"/>
                  <a:gd name="connsiteX9" fmla="*/ 104330 w 489230"/>
                  <a:gd name="connsiteY9" fmla="*/ 4946533 h 8615751"/>
                  <a:gd name="connsiteX10" fmla="*/ 143589 w 489230"/>
                  <a:gd name="connsiteY10" fmla="*/ 682895 h 8615751"/>
                  <a:gd name="connsiteX11" fmla="*/ 215001 w 489230"/>
                  <a:gd name="connsiteY11" fmla="*/ 113276 h 8615751"/>
                  <a:gd name="connsiteX12" fmla="*/ 235412 w 489230"/>
                  <a:gd name="connsiteY12" fmla="*/ 13035 h 8615751"/>
                  <a:gd name="connsiteX13" fmla="*/ 284726 w 489230"/>
                  <a:gd name="connsiteY13" fmla="*/ 323050 h 8615751"/>
                  <a:gd name="connsiteX14" fmla="*/ 324577 w 489230"/>
                  <a:gd name="connsiteY14" fmla="*/ 1102741 h 861575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489230" h="8615751">
                    <a:moveTo>
                      <a:pt x="324577" y="1102741"/>
                    </a:moveTo>
                    <a:cubicBezTo>
                      <a:pt x="345311" y="1960407"/>
                      <a:pt x="387781" y="4349444"/>
                      <a:pt x="409130" y="5469047"/>
                    </a:cubicBezTo>
                    <a:cubicBezTo>
                      <a:pt x="430479" y="6588650"/>
                      <a:pt x="442997" y="7358323"/>
                      <a:pt x="452673" y="7820361"/>
                    </a:cubicBezTo>
                    <a:cubicBezTo>
                      <a:pt x="462349" y="8282399"/>
                      <a:pt x="462387" y="8115486"/>
                      <a:pt x="467187" y="8241276"/>
                    </a:cubicBezTo>
                    <a:cubicBezTo>
                      <a:pt x="471987" y="8367066"/>
                      <a:pt x="503548" y="8514666"/>
                      <a:pt x="481474" y="8575104"/>
                    </a:cubicBezTo>
                    <a:cubicBezTo>
                      <a:pt x="459400" y="8635542"/>
                      <a:pt x="405652" y="8598312"/>
                      <a:pt x="334744" y="8603906"/>
                    </a:cubicBezTo>
                    <a:cubicBezTo>
                      <a:pt x="263836" y="8609500"/>
                      <a:pt x="111322" y="8624581"/>
                      <a:pt x="56024" y="8608668"/>
                    </a:cubicBezTo>
                    <a:cubicBezTo>
                      <a:pt x="726" y="8592755"/>
                      <a:pt x="9420" y="8567242"/>
                      <a:pt x="2957" y="8508429"/>
                    </a:cubicBezTo>
                    <a:cubicBezTo>
                      <a:pt x="-3506" y="8449616"/>
                      <a:pt x="348" y="8849439"/>
                      <a:pt x="17244" y="8255790"/>
                    </a:cubicBezTo>
                    <a:cubicBezTo>
                      <a:pt x="34140" y="7662141"/>
                      <a:pt x="83273" y="6208682"/>
                      <a:pt x="104330" y="4946533"/>
                    </a:cubicBezTo>
                    <a:cubicBezTo>
                      <a:pt x="125387" y="3684384"/>
                      <a:pt x="125144" y="1488438"/>
                      <a:pt x="143589" y="682895"/>
                    </a:cubicBezTo>
                    <a:cubicBezTo>
                      <a:pt x="162034" y="-122648"/>
                      <a:pt x="205325" y="212457"/>
                      <a:pt x="215001" y="113276"/>
                    </a:cubicBezTo>
                    <a:cubicBezTo>
                      <a:pt x="224677" y="14095"/>
                      <a:pt x="223791" y="-21927"/>
                      <a:pt x="235412" y="13035"/>
                    </a:cubicBezTo>
                    <a:cubicBezTo>
                      <a:pt x="247033" y="47997"/>
                      <a:pt x="289564" y="117619"/>
                      <a:pt x="284726" y="323050"/>
                    </a:cubicBezTo>
                    <a:cubicBezTo>
                      <a:pt x="278590" y="572752"/>
                      <a:pt x="303843" y="245075"/>
                      <a:pt x="324577" y="1102741"/>
                    </a:cubicBezTo>
                    <a:close/>
                  </a:path>
                </a:pathLst>
              </a:custGeom>
              <a:solidFill>
                <a:schemeClr val="accent4">
                  <a:lumMod val="75000"/>
                </a:schemeClr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defTabSz="1280160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100"/>
              </a:p>
            </p:txBody>
          </p:sp>
          <p:grpSp>
            <p:nvGrpSpPr>
              <p:cNvPr id="41" name="Group 41"/>
              <p:cNvGrpSpPr>
                <a:grpSpLocks noChangeAspect="1"/>
              </p:cNvGrpSpPr>
              <p:nvPr/>
            </p:nvGrpSpPr>
            <p:grpSpPr bwMode="auto">
              <a:xfrm rot="1680000">
                <a:off x="6386872" y="2638143"/>
                <a:ext cx="172990" cy="306035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135" name="Freeform 134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36" name="Freeform 135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42" name="Group 44"/>
              <p:cNvGrpSpPr>
                <a:grpSpLocks noChangeAspect="1"/>
              </p:cNvGrpSpPr>
              <p:nvPr/>
            </p:nvGrpSpPr>
            <p:grpSpPr bwMode="auto">
              <a:xfrm rot="21420000">
                <a:off x="6277435" y="2317750"/>
                <a:ext cx="199620" cy="353131"/>
                <a:chOff x="3899131" y="4414880"/>
                <a:chExt cx="362857" cy="599924"/>
              </a:xfrm>
              <a:solidFill>
                <a:srgbClr val="EBBA79"/>
              </a:solidFill>
            </p:grpSpPr>
            <p:sp>
              <p:nvSpPr>
                <p:cNvPr id="133" name="Freeform 132"/>
                <p:cNvSpPr/>
                <p:nvPr/>
              </p:nvSpPr>
              <p:spPr>
                <a:xfrm>
                  <a:off x="3899131" y="4414880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34" name="Freeform 133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43" name="Group 41"/>
              <p:cNvGrpSpPr>
                <a:grpSpLocks noChangeAspect="1"/>
              </p:cNvGrpSpPr>
              <p:nvPr/>
            </p:nvGrpSpPr>
            <p:grpSpPr bwMode="auto">
              <a:xfrm rot="1680000">
                <a:off x="6382042" y="2978542"/>
                <a:ext cx="172990" cy="306035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131" name="Freeform 130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32" name="Freeform 131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44" name="Group 41"/>
              <p:cNvGrpSpPr>
                <a:grpSpLocks noChangeAspect="1"/>
              </p:cNvGrpSpPr>
              <p:nvPr/>
            </p:nvGrpSpPr>
            <p:grpSpPr bwMode="auto">
              <a:xfrm rot="1680000">
                <a:off x="6409489" y="3247463"/>
                <a:ext cx="189983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129" name="Freeform 128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30" name="Freeform 129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45" name="Group 38"/>
              <p:cNvGrpSpPr>
                <a:grpSpLocks noChangeAspect="1"/>
              </p:cNvGrpSpPr>
              <p:nvPr/>
            </p:nvGrpSpPr>
            <p:grpSpPr bwMode="auto">
              <a:xfrm rot="18240000">
                <a:off x="6134772" y="2833263"/>
                <a:ext cx="155861" cy="3348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27" name="Freeform 126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28" name="Freeform 127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46" name="Group 38"/>
              <p:cNvGrpSpPr>
                <a:grpSpLocks noChangeAspect="1"/>
              </p:cNvGrpSpPr>
              <p:nvPr/>
            </p:nvGrpSpPr>
            <p:grpSpPr bwMode="auto">
              <a:xfrm rot="18240000">
                <a:off x="6154139" y="2608678"/>
                <a:ext cx="166890" cy="358499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25" name="Freeform 124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26" name="Freeform 125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47" name="Group 38"/>
              <p:cNvGrpSpPr>
                <a:grpSpLocks noChangeAspect="1"/>
              </p:cNvGrpSpPr>
              <p:nvPr/>
            </p:nvGrpSpPr>
            <p:grpSpPr bwMode="auto">
              <a:xfrm rot="18240000">
                <a:off x="6200224" y="2458041"/>
                <a:ext cx="142882" cy="30692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23" name="Freeform 122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24" name="Freeform 123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48" name="Group 41"/>
              <p:cNvGrpSpPr>
                <a:grpSpLocks/>
              </p:cNvGrpSpPr>
              <p:nvPr/>
            </p:nvGrpSpPr>
            <p:grpSpPr bwMode="auto">
              <a:xfrm rot="1680000">
                <a:off x="6401382" y="3598576"/>
                <a:ext cx="189983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121" name="Freeform 120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22" name="Freeform 121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49" name="Group 38"/>
              <p:cNvGrpSpPr>
                <a:grpSpLocks/>
              </p:cNvGrpSpPr>
              <p:nvPr/>
            </p:nvGrpSpPr>
            <p:grpSpPr bwMode="auto">
              <a:xfrm rot="18240000">
                <a:off x="6120718" y="7664928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19" name="Freeform 118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20" name="Freeform 119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50" name="Group 38"/>
              <p:cNvGrpSpPr>
                <a:grpSpLocks/>
              </p:cNvGrpSpPr>
              <p:nvPr/>
            </p:nvGrpSpPr>
            <p:grpSpPr bwMode="auto">
              <a:xfrm rot="18240000">
                <a:off x="6117557" y="7234874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17" name="Freeform 116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18" name="Freeform 117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51" name="Group 38"/>
              <p:cNvGrpSpPr>
                <a:grpSpLocks/>
              </p:cNvGrpSpPr>
              <p:nvPr/>
            </p:nvGrpSpPr>
            <p:grpSpPr bwMode="auto">
              <a:xfrm rot="18240000">
                <a:off x="6103059" y="6825113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15" name="Freeform 114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16" name="Freeform 115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52" name="Group 38"/>
              <p:cNvGrpSpPr>
                <a:grpSpLocks/>
              </p:cNvGrpSpPr>
              <p:nvPr/>
            </p:nvGrpSpPr>
            <p:grpSpPr bwMode="auto">
              <a:xfrm rot="18240000">
                <a:off x="6110735" y="6385729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13" name="Freeform 112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14" name="Freeform 113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53" name="Group 38"/>
              <p:cNvGrpSpPr>
                <a:grpSpLocks/>
              </p:cNvGrpSpPr>
              <p:nvPr/>
            </p:nvGrpSpPr>
            <p:grpSpPr bwMode="auto">
              <a:xfrm rot="18240000">
                <a:off x="6117557" y="5986489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11" name="Freeform 110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12" name="Freeform 111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54" name="Group 38"/>
              <p:cNvGrpSpPr>
                <a:grpSpLocks/>
              </p:cNvGrpSpPr>
              <p:nvPr/>
            </p:nvGrpSpPr>
            <p:grpSpPr bwMode="auto">
              <a:xfrm rot="18240000">
                <a:off x="6113192" y="5587250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09" name="Freeform 108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10" name="Freeform 109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55" name="Group 38"/>
              <p:cNvGrpSpPr>
                <a:grpSpLocks/>
              </p:cNvGrpSpPr>
              <p:nvPr/>
            </p:nvGrpSpPr>
            <p:grpSpPr bwMode="auto">
              <a:xfrm rot="18240000">
                <a:off x="6120717" y="5258452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07" name="Freeform 106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08" name="Freeform 107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56" name="Group 38"/>
              <p:cNvGrpSpPr>
                <a:grpSpLocks/>
              </p:cNvGrpSpPr>
              <p:nvPr/>
            </p:nvGrpSpPr>
            <p:grpSpPr bwMode="auto">
              <a:xfrm rot="18240000">
                <a:off x="6117468" y="4909456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05" name="Freeform 104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06" name="Freeform 105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57" name="Group 38"/>
              <p:cNvGrpSpPr>
                <a:grpSpLocks/>
              </p:cNvGrpSpPr>
              <p:nvPr/>
            </p:nvGrpSpPr>
            <p:grpSpPr bwMode="auto">
              <a:xfrm rot="18240000">
                <a:off x="6115604" y="4520147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03" name="Freeform 102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04" name="Freeform 103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58" name="Group 38"/>
              <p:cNvGrpSpPr>
                <a:grpSpLocks/>
              </p:cNvGrpSpPr>
              <p:nvPr/>
            </p:nvGrpSpPr>
            <p:grpSpPr bwMode="auto">
              <a:xfrm rot="18240000">
                <a:off x="6090243" y="4141371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101" name="Freeform 100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02" name="Freeform 101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59" name="Group 38"/>
              <p:cNvGrpSpPr>
                <a:grpSpLocks/>
              </p:cNvGrpSpPr>
              <p:nvPr/>
            </p:nvGrpSpPr>
            <p:grpSpPr bwMode="auto">
              <a:xfrm rot="18240000">
                <a:off x="6108287" y="3803249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99" name="Freeform 98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100" name="Freeform 99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60" name="Group 38"/>
              <p:cNvGrpSpPr>
                <a:grpSpLocks/>
              </p:cNvGrpSpPr>
              <p:nvPr/>
            </p:nvGrpSpPr>
            <p:grpSpPr bwMode="auto">
              <a:xfrm rot="18240000">
                <a:off x="6128313" y="3423775"/>
                <a:ext cx="208613" cy="3596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97" name="Freeform 96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98" name="Freeform 97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61" name="Group 38"/>
              <p:cNvGrpSpPr>
                <a:grpSpLocks/>
              </p:cNvGrpSpPr>
              <p:nvPr/>
            </p:nvGrpSpPr>
            <p:grpSpPr bwMode="auto">
              <a:xfrm rot="18240000">
                <a:off x="6119378" y="3118708"/>
                <a:ext cx="208613" cy="347204"/>
                <a:chOff x="3899505" y="4414762"/>
                <a:chExt cx="362857" cy="599924"/>
              </a:xfrm>
              <a:solidFill>
                <a:srgbClr val="EBBA79"/>
              </a:solidFill>
            </p:grpSpPr>
            <p:sp>
              <p:nvSpPr>
                <p:cNvPr id="95" name="Freeform 94"/>
                <p:cNvSpPr/>
                <p:nvPr/>
              </p:nvSpPr>
              <p:spPr>
                <a:xfrm>
                  <a:off x="3899505" y="4414762"/>
                  <a:ext cx="362857" cy="599924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96" name="Freeform 95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62" name="Group 41"/>
              <p:cNvGrpSpPr>
                <a:grpSpLocks/>
              </p:cNvGrpSpPr>
              <p:nvPr/>
            </p:nvGrpSpPr>
            <p:grpSpPr bwMode="auto">
              <a:xfrm rot="1680000">
                <a:off x="6438725" y="7885024"/>
                <a:ext cx="223202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93" name="Freeform 92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94" name="Freeform 93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63" name="Group 41"/>
              <p:cNvGrpSpPr>
                <a:grpSpLocks/>
              </p:cNvGrpSpPr>
              <p:nvPr/>
            </p:nvGrpSpPr>
            <p:grpSpPr bwMode="auto">
              <a:xfrm rot="1680000">
                <a:off x="6434950" y="7496234"/>
                <a:ext cx="223202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91" name="Freeform 90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92" name="Freeform 91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64" name="Group 41"/>
              <p:cNvGrpSpPr>
                <a:grpSpLocks/>
              </p:cNvGrpSpPr>
              <p:nvPr/>
            </p:nvGrpSpPr>
            <p:grpSpPr bwMode="auto">
              <a:xfrm rot="1680000">
                <a:off x="6453403" y="7035328"/>
                <a:ext cx="223202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89" name="Freeform 88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90" name="Freeform 89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65" name="Group 41"/>
              <p:cNvGrpSpPr>
                <a:grpSpLocks/>
              </p:cNvGrpSpPr>
              <p:nvPr/>
            </p:nvGrpSpPr>
            <p:grpSpPr bwMode="auto">
              <a:xfrm rot="1680000">
                <a:off x="6406498" y="6544922"/>
                <a:ext cx="223202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87" name="Freeform 86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88" name="Freeform 87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66" name="Group 41"/>
              <p:cNvGrpSpPr>
                <a:grpSpLocks/>
              </p:cNvGrpSpPr>
              <p:nvPr/>
            </p:nvGrpSpPr>
            <p:grpSpPr bwMode="auto">
              <a:xfrm rot="1680000">
                <a:off x="6446690" y="6185620"/>
                <a:ext cx="223202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85" name="Freeform 84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86" name="Freeform 85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67" name="Group 41"/>
              <p:cNvGrpSpPr>
                <a:grpSpLocks/>
              </p:cNvGrpSpPr>
              <p:nvPr/>
            </p:nvGrpSpPr>
            <p:grpSpPr bwMode="auto">
              <a:xfrm rot="1680000">
                <a:off x="6420456" y="5837991"/>
                <a:ext cx="223202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83" name="Freeform 82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84" name="Freeform 83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68" name="Group 41"/>
              <p:cNvGrpSpPr>
                <a:grpSpLocks/>
              </p:cNvGrpSpPr>
              <p:nvPr/>
            </p:nvGrpSpPr>
            <p:grpSpPr bwMode="auto">
              <a:xfrm rot="1680000">
                <a:off x="6427788" y="5438837"/>
                <a:ext cx="223202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81" name="Freeform 80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82" name="Freeform 81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69" name="Group 41"/>
              <p:cNvGrpSpPr>
                <a:grpSpLocks/>
              </p:cNvGrpSpPr>
              <p:nvPr/>
            </p:nvGrpSpPr>
            <p:grpSpPr bwMode="auto">
              <a:xfrm rot="1680000">
                <a:off x="6413008" y="5029077"/>
                <a:ext cx="223202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79" name="Freeform 78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80" name="Freeform 79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70" name="Group 41"/>
              <p:cNvGrpSpPr>
                <a:grpSpLocks/>
              </p:cNvGrpSpPr>
              <p:nvPr/>
            </p:nvGrpSpPr>
            <p:grpSpPr bwMode="auto">
              <a:xfrm rot="1680000">
                <a:off x="6420912" y="4650625"/>
                <a:ext cx="223202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77" name="Freeform 76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78" name="Freeform 77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71" name="Group 41"/>
              <p:cNvGrpSpPr>
                <a:grpSpLocks/>
              </p:cNvGrpSpPr>
              <p:nvPr/>
            </p:nvGrpSpPr>
            <p:grpSpPr bwMode="auto">
              <a:xfrm rot="1680000">
                <a:off x="6406497" y="4281866"/>
                <a:ext cx="223202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75" name="Freeform 74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76" name="Freeform 75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  <p:grpSp>
            <p:nvGrpSpPr>
              <p:cNvPr id="72" name="Group 41"/>
              <p:cNvGrpSpPr>
                <a:grpSpLocks/>
              </p:cNvGrpSpPr>
              <p:nvPr/>
            </p:nvGrpSpPr>
            <p:grpSpPr bwMode="auto">
              <a:xfrm rot="1680000">
                <a:off x="6412365" y="3943289"/>
                <a:ext cx="223202" cy="336100"/>
                <a:chOff x="3907849" y="4412122"/>
                <a:chExt cx="362857" cy="599925"/>
              </a:xfrm>
              <a:solidFill>
                <a:srgbClr val="EBBA79"/>
              </a:solidFill>
            </p:grpSpPr>
            <p:sp>
              <p:nvSpPr>
                <p:cNvPr id="73" name="Freeform 72"/>
                <p:cNvSpPr/>
                <p:nvPr/>
              </p:nvSpPr>
              <p:spPr>
                <a:xfrm>
                  <a:off x="3907849" y="4412122"/>
                  <a:ext cx="362857" cy="599925"/>
                </a:xfrm>
                <a:custGeom>
                  <a:avLst/>
                  <a:gdLst>
                    <a:gd name="connsiteX0" fmla="*/ 48381 w 362857"/>
                    <a:gd name="connsiteY0" fmla="*/ 505581 h 599924"/>
                    <a:gd name="connsiteX1" fmla="*/ 19352 w 362857"/>
                    <a:gd name="connsiteY1" fmla="*/ 258838 h 599924"/>
                    <a:gd name="connsiteX2" fmla="*/ 164495 w 362857"/>
                    <a:gd name="connsiteY2" fmla="*/ 84667 h 599924"/>
                    <a:gd name="connsiteX3" fmla="*/ 237066 w 362857"/>
                    <a:gd name="connsiteY3" fmla="*/ 12095 h 599924"/>
                    <a:gd name="connsiteX4" fmla="*/ 324152 w 362857"/>
                    <a:gd name="connsiteY4" fmla="*/ 157238 h 599924"/>
                    <a:gd name="connsiteX5" fmla="*/ 353181 w 362857"/>
                    <a:gd name="connsiteY5" fmla="*/ 331409 h 599924"/>
                    <a:gd name="connsiteX6" fmla="*/ 266095 w 362857"/>
                    <a:gd name="connsiteY6" fmla="*/ 563638 h 599924"/>
                    <a:gd name="connsiteX7" fmla="*/ 193524 w 362857"/>
                    <a:gd name="connsiteY7" fmla="*/ 549124 h 599924"/>
                    <a:gd name="connsiteX8" fmla="*/ 48381 w 362857"/>
                    <a:gd name="connsiteY8" fmla="*/ 505581 h 5999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362857" h="599924">
                      <a:moveTo>
                        <a:pt x="48381" y="505581"/>
                      </a:moveTo>
                      <a:cubicBezTo>
                        <a:pt x="24190" y="417285"/>
                        <a:pt x="0" y="328990"/>
                        <a:pt x="19352" y="258838"/>
                      </a:cubicBezTo>
                      <a:cubicBezTo>
                        <a:pt x="38704" y="188686"/>
                        <a:pt x="128209" y="125791"/>
                        <a:pt x="164495" y="84667"/>
                      </a:cubicBezTo>
                      <a:cubicBezTo>
                        <a:pt x="200781" y="43543"/>
                        <a:pt x="210457" y="0"/>
                        <a:pt x="237066" y="12095"/>
                      </a:cubicBezTo>
                      <a:cubicBezTo>
                        <a:pt x="263675" y="24190"/>
                        <a:pt x="304800" y="104019"/>
                        <a:pt x="324152" y="157238"/>
                      </a:cubicBezTo>
                      <a:cubicBezTo>
                        <a:pt x="343504" y="210457"/>
                        <a:pt x="362857" y="263676"/>
                        <a:pt x="353181" y="331409"/>
                      </a:cubicBezTo>
                      <a:cubicBezTo>
                        <a:pt x="343505" y="399142"/>
                        <a:pt x="292704" y="527352"/>
                        <a:pt x="266095" y="563638"/>
                      </a:cubicBezTo>
                      <a:cubicBezTo>
                        <a:pt x="239486" y="599924"/>
                        <a:pt x="193524" y="549124"/>
                        <a:pt x="193524" y="549124"/>
                      </a:cubicBezTo>
                      <a:lnTo>
                        <a:pt x="48381" y="505581"/>
                      </a:lnTo>
                      <a:close/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  <p:sp>
              <p:nvSpPr>
                <p:cNvPr id="74" name="Freeform 73"/>
                <p:cNvSpPr/>
                <p:nvPr/>
              </p:nvSpPr>
              <p:spPr>
                <a:xfrm>
                  <a:off x="3959981" y="4630057"/>
                  <a:ext cx="292705" cy="304800"/>
                </a:xfrm>
                <a:custGeom>
                  <a:avLst/>
                  <a:gdLst>
                    <a:gd name="connsiteX0" fmla="*/ 16933 w 292705"/>
                    <a:gd name="connsiteY0" fmla="*/ 304800 h 304800"/>
                    <a:gd name="connsiteX1" fmla="*/ 45962 w 292705"/>
                    <a:gd name="connsiteY1" fmla="*/ 130629 h 304800"/>
                    <a:gd name="connsiteX2" fmla="*/ 292705 w 292705"/>
                    <a:gd name="connsiteY2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92705" h="304800">
                      <a:moveTo>
                        <a:pt x="16933" y="304800"/>
                      </a:moveTo>
                      <a:cubicBezTo>
                        <a:pt x="8466" y="243114"/>
                        <a:pt x="0" y="181429"/>
                        <a:pt x="45962" y="130629"/>
                      </a:cubicBezTo>
                      <a:cubicBezTo>
                        <a:pt x="91924" y="79829"/>
                        <a:pt x="192314" y="39914"/>
                        <a:pt x="292705" y="0"/>
                      </a:cubicBezTo>
                    </a:path>
                  </a:pathLst>
                </a:custGeom>
                <a:grpFill/>
                <a:ln w="635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/>
                <a:p>
                  <a:pPr algn="ctr" defTabSz="1280160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1100"/>
                </a:p>
              </p:txBody>
            </p:sp>
          </p:grpSp>
        </p:grpSp>
        <p:sp>
          <p:nvSpPr>
            <p:cNvPr id="35" name="TextBox 2"/>
            <p:cNvSpPr txBox="1">
              <a:spLocks noChangeArrowheads="1"/>
            </p:cNvSpPr>
            <p:nvPr/>
          </p:nvSpPr>
          <p:spPr bwMode="auto">
            <a:xfrm>
              <a:off x="3942220" y="1659707"/>
              <a:ext cx="518738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nb-NO" altLang="en-US" sz="1100" dirty="0"/>
                <a:t>1-10</a:t>
              </a:r>
              <a:endParaRPr lang="en-GB" altLang="en-US" sz="1100" dirty="0"/>
            </a:p>
          </p:txBody>
        </p:sp>
        <p:sp>
          <p:nvSpPr>
            <p:cNvPr id="36" name="TextBox 259"/>
            <p:cNvSpPr txBox="1">
              <a:spLocks noChangeArrowheads="1"/>
            </p:cNvSpPr>
            <p:nvPr/>
          </p:nvSpPr>
          <p:spPr bwMode="auto">
            <a:xfrm>
              <a:off x="3896502" y="2710373"/>
              <a:ext cx="602949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nb-NO" altLang="en-US" sz="1100" dirty="0"/>
                <a:t>11-15</a:t>
              </a:r>
              <a:endParaRPr lang="en-GB" altLang="en-US" sz="1100" dirty="0"/>
            </a:p>
          </p:txBody>
        </p:sp>
        <p:sp>
          <p:nvSpPr>
            <p:cNvPr id="37" name="TextBox 260"/>
            <p:cNvSpPr txBox="1">
              <a:spLocks noChangeArrowheads="1"/>
            </p:cNvSpPr>
            <p:nvPr/>
          </p:nvSpPr>
          <p:spPr bwMode="auto">
            <a:xfrm>
              <a:off x="3846727" y="3612924"/>
              <a:ext cx="602949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nb-NO" altLang="en-US" sz="1100" dirty="0"/>
                <a:t>16-20</a:t>
              </a:r>
              <a:endParaRPr lang="en-GB" altLang="en-US" sz="1100" dirty="0"/>
            </a:p>
          </p:txBody>
        </p:sp>
        <p:sp>
          <p:nvSpPr>
            <p:cNvPr id="38" name="TextBox 261"/>
            <p:cNvSpPr txBox="1">
              <a:spLocks noChangeArrowheads="1"/>
            </p:cNvSpPr>
            <p:nvPr/>
          </p:nvSpPr>
          <p:spPr bwMode="auto">
            <a:xfrm>
              <a:off x="3865537" y="4490624"/>
              <a:ext cx="602949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nb-NO" altLang="en-US" sz="1100" dirty="0"/>
                <a:t>21-25</a:t>
              </a:r>
              <a:endParaRPr lang="en-GB" altLang="en-US" sz="1100" dirty="0"/>
            </a:p>
          </p:txBody>
        </p:sp>
        <p:sp>
          <p:nvSpPr>
            <p:cNvPr id="39" name="TextBox 262"/>
            <p:cNvSpPr txBox="1">
              <a:spLocks noChangeArrowheads="1"/>
            </p:cNvSpPr>
            <p:nvPr/>
          </p:nvSpPr>
          <p:spPr bwMode="auto">
            <a:xfrm>
              <a:off x="3833111" y="5522055"/>
              <a:ext cx="602949" cy="301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nb-NO" altLang="en-US" sz="1100" dirty="0"/>
                <a:t>25-30</a:t>
              </a:r>
              <a:endParaRPr lang="en-GB" altLang="en-US" sz="1100" dirty="0"/>
            </a:p>
          </p:txBody>
        </p:sp>
      </p:grpSp>
      <p:sp>
        <p:nvSpPr>
          <p:cNvPr id="204" name="TextBox 1"/>
          <p:cNvSpPr txBox="1">
            <a:spLocks noChangeArrowheads="1"/>
          </p:cNvSpPr>
          <p:nvPr/>
        </p:nvSpPr>
        <p:spPr bwMode="auto">
          <a:xfrm>
            <a:off x="1124602" y="6560649"/>
            <a:ext cx="4680000" cy="24776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just" eaLnBrk="1" hangingPunct="1"/>
            <a:r>
              <a: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. 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osition of axillary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uds (AXBs)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 and after a seven-week exposure to short photoperiod.</a:t>
            </a:r>
          </a:p>
          <a:p>
            <a:pPr algn="just" eaLnBrk="1" hangingPunct="1"/>
            <a:endParaRPr lang="en-US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xillary meristems of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~ 10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f primordia at the apex of long day plants (group 0), produced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 AXBs (1-10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nder short photoperiod.  In long photoperiod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,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~ 10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XBs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ent between the apex and the bud maturation point (BMP). </a:t>
            </a:r>
            <a:r>
              <a:rPr lang="en-US" altLang="en-US" sz="110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en-US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XBs of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1 are in an initial developmental stage, while those of group 2 are in a further stage of development. After short photoperiod exposure the AXBs of these groups occupied the new positions 11-15 and 16-20, respectively. Below the BMP in long photoperiod plants AXBs are para-dormant, and classified as mature (group 3) or ageing (group 4). After the short photoperiod exposure they occupied positions 21-25 and 25-30, respectively. Bud numbers are approximate.</a:t>
            </a:r>
          </a:p>
          <a:p>
            <a:endParaRPr lang="en-GB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483871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186</Words>
  <Application>Microsoft Office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an van der Schoot</dc:creator>
  <cp:lastModifiedBy>Christiaan van der Schoot</cp:lastModifiedBy>
  <cp:revision>4</cp:revision>
  <dcterms:created xsi:type="dcterms:W3CDTF">2015-07-10T16:00:39Z</dcterms:created>
  <dcterms:modified xsi:type="dcterms:W3CDTF">2015-07-28T17:19:47Z</dcterms:modified>
</cp:coreProperties>
</file>